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335" r:id="rId2"/>
    <p:sldId id="348" r:id="rId3"/>
    <p:sldId id="349" r:id="rId4"/>
    <p:sldId id="350" r:id="rId5"/>
    <p:sldId id="351" r:id="rId6"/>
  </p:sldIdLst>
  <p:sldSz cx="6858000" cy="9906000" type="A4"/>
  <p:notesSz cx="6797675" cy="992822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99CCFF"/>
    <a:srgbClr val="FFEDB9"/>
    <a:srgbClr val="663300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無樣式、表格格線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淺色樣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無樣式、無格線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613" autoAdjust="0"/>
    <p:restoredTop sz="96400" autoAdjust="0"/>
  </p:normalViewPr>
  <p:slideViewPr>
    <p:cSldViewPr snapToGrid="0">
      <p:cViewPr>
        <p:scale>
          <a:sx n="87" d="100"/>
          <a:sy n="87" d="100"/>
        </p:scale>
        <p:origin x="3270" y="-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13" Type="http://schemas.openxmlformats.org/officeDocument/2006/relationships/image" Target="../media/image25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12" Type="http://schemas.openxmlformats.org/officeDocument/2006/relationships/image" Target="../media/image24.emf"/><Relationship Id="rId2" Type="http://schemas.openxmlformats.org/officeDocument/2006/relationships/image" Target="../media/image14.emf"/><Relationship Id="rId16" Type="http://schemas.openxmlformats.org/officeDocument/2006/relationships/image" Target="../media/image28.emf"/><Relationship Id="rId1" Type="http://schemas.openxmlformats.org/officeDocument/2006/relationships/image" Target="../media/image13.emf"/><Relationship Id="rId6" Type="http://schemas.openxmlformats.org/officeDocument/2006/relationships/image" Target="../media/image18.emf"/><Relationship Id="rId11" Type="http://schemas.openxmlformats.org/officeDocument/2006/relationships/image" Target="../media/image23.emf"/><Relationship Id="rId5" Type="http://schemas.openxmlformats.org/officeDocument/2006/relationships/image" Target="../media/image17.emf"/><Relationship Id="rId15" Type="http://schemas.openxmlformats.org/officeDocument/2006/relationships/image" Target="../media/image27.emf"/><Relationship Id="rId10" Type="http://schemas.openxmlformats.org/officeDocument/2006/relationships/image" Target="../media/image22.emf"/><Relationship Id="rId4" Type="http://schemas.openxmlformats.org/officeDocument/2006/relationships/image" Target="../media/image16.emf"/><Relationship Id="rId9" Type="http://schemas.openxmlformats.org/officeDocument/2006/relationships/image" Target="../media/image21.emf"/><Relationship Id="rId14" Type="http://schemas.openxmlformats.org/officeDocument/2006/relationships/image" Target="../media/image26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36.emf"/><Relationship Id="rId13" Type="http://schemas.openxmlformats.org/officeDocument/2006/relationships/image" Target="../media/image41.emf"/><Relationship Id="rId3" Type="http://schemas.openxmlformats.org/officeDocument/2006/relationships/image" Target="../media/image31.emf"/><Relationship Id="rId7" Type="http://schemas.openxmlformats.org/officeDocument/2006/relationships/image" Target="../media/image35.emf"/><Relationship Id="rId12" Type="http://schemas.openxmlformats.org/officeDocument/2006/relationships/image" Target="../media/image40.emf"/><Relationship Id="rId2" Type="http://schemas.openxmlformats.org/officeDocument/2006/relationships/image" Target="../media/image30.emf"/><Relationship Id="rId16" Type="http://schemas.openxmlformats.org/officeDocument/2006/relationships/image" Target="../media/image44.emf"/><Relationship Id="rId1" Type="http://schemas.openxmlformats.org/officeDocument/2006/relationships/image" Target="../media/image29.emf"/><Relationship Id="rId6" Type="http://schemas.openxmlformats.org/officeDocument/2006/relationships/image" Target="../media/image34.emf"/><Relationship Id="rId11" Type="http://schemas.openxmlformats.org/officeDocument/2006/relationships/image" Target="../media/image39.emf"/><Relationship Id="rId5" Type="http://schemas.openxmlformats.org/officeDocument/2006/relationships/image" Target="../media/image33.emf"/><Relationship Id="rId15" Type="http://schemas.openxmlformats.org/officeDocument/2006/relationships/image" Target="../media/image43.emf"/><Relationship Id="rId10" Type="http://schemas.openxmlformats.org/officeDocument/2006/relationships/image" Target="../media/image38.emf"/><Relationship Id="rId4" Type="http://schemas.openxmlformats.org/officeDocument/2006/relationships/image" Target="../media/image32.emf"/><Relationship Id="rId9" Type="http://schemas.openxmlformats.org/officeDocument/2006/relationships/image" Target="../media/image37.emf"/><Relationship Id="rId14" Type="http://schemas.openxmlformats.org/officeDocument/2006/relationships/image" Target="../media/image42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47.emf"/><Relationship Id="rId2" Type="http://schemas.openxmlformats.org/officeDocument/2006/relationships/image" Target="../media/image46.emf"/><Relationship Id="rId1" Type="http://schemas.openxmlformats.org/officeDocument/2006/relationships/image" Target="../media/image45.emf"/><Relationship Id="rId5" Type="http://schemas.openxmlformats.org/officeDocument/2006/relationships/image" Target="../media/image49.emf"/><Relationship Id="rId4" Type="http://schemas.openxmlformats.org/officeDocument/2006/relationships/image" Target="../media/image4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CF69AA-6BA1-4E0F-B8DB-F4869F6A6146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3067D1-0D26-4FB9-AE8B-DACE9F1793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502558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76059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02819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952727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39284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48754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04856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17389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90648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018646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1898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40719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38640-A27A-45F5-88DF-0BB1A9179F58}" type="datetimeFigureOut">
              <a:rPr lang="zh-TW" altLang="en-US" smtClean="0"/>
              <a:t>2022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01C064-8578-4129-8F89-CA0C8754CE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59356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18.bin"/><Relationship Id="rId18" Type="http://schemas.openxmlformats.org/officeDocument/2006/relationships/image" Target="../media/image20.emf"/><Relationship Id="rId26" Type="http://schemas.openxmlformats.org/officeDocument/2006/relationships/image" Target="../media/image24.emf"/><Relationship Id="rId3" Type="http://schemas.openxmlformats.org/officeDocument/2006/relationships/oleObject" Target="../embeddings/oleObject13.bin"/><Relationship Id="rId21" Type="http://schemas.openxmlformats.org/officeDocument/2006/relationships/oleObject" Target="../embeddings/oleObject22.bin"/><Relationship Id="rId34" Type="http://schemas.openxmlformats.org/officeDocument/2006/relationships/image" Target="../media/image28.emf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17.emf"/><Relationship Id="rId17" Type="http://schemas.openxmlformats.org/officeDocument/2006/relationships/oleObject" Target="../embeddings/oleObject20.bin"/><Relationship Id="rId25" Type="http://schemas.openxmlformats.org/officeDocument/2006/relationships/oleObject" Target="../embeddings/oleObject24.bin"/><Relationship Id="rId33" Type="http://schemas.openxmlformats.org/officeDocument/2006/relationships/oleObject" Target="../embeddings/oleObject2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9.emf"/><Relationship Id="rId20" Type="http://schemas.openxmlformats.org/officeDocument/2006/relationships/image" Target="../media/image21.emf"/><Relationship Id="rId29" Type="http://schemas.openxmlformats.org/officeDocument/2006/relationships/oleObject" Target="../embeddings/oleObject26.bin"/><Relationship Id="rId1" Type="http://schemas.openxmlformats.org/officeDocument/2006/relationships/vmlDrawing" Target="../drawings/vmlDrawing2.vml"/><Relationship Id="rId6" Type="http://schemas.openxmlformats.org/officeDocument/2006/relationships/image" Target="../media/image14.emf"/><Relationship Id="rId11" Type="http://schemas.openxmlformats.org/officeDocument/2006/relationships/oleObject" Target="../embeddings/oleObject17.bin"/><Relationship Id="rId24" Type="http://schemas.openxmlformats.org/officeDocument/2006/relationships/image" Target="../media/image23.emf"/><Relationship Id="rId32" Type="http://schemas.openxmlformats.org/officeDocument/2006/relationships/image" Target="../media/image27.emf"/><Relationship Id="rId5" Type="http://schemas.openxmlformats.org/officeDocument/2006/relationships/oleObject" Target="../embeddings/oleObject14.bin"/><Relationship Id="rId15" Type="http://schemas.openxmlformats.org/officeDocument/2006/relationships/oleObject" Target="../embeddings/oleObject19.bin"/><Relationship Id="rId23" Type="http://schemas.openxmlformats.org/officeDocument/2006/relationships/oleObject" Target="../embeddings/oleObject23.bin"/><Relationship Id="rId28" Type="http://schemas.openxmlformats.org/officeDocument/2006/relationships/image" Target="../media/image25.emf"/><Relationship Id="rId10" Type="http://schemas.openxmlformats.org/officeDocument/2006/relationships/image" Target="../media/image16.emf"/><Relationship Id="rId19" Type="http://schemas.openxmlformats.org/officeDocument/2006/relationships/oleObject" Target="../embeddings/oleObject21.bin"/><Relationship Id="rId31" Type="http://schemas.openxmlformats.org/officeDocument/2006/relationships/oleObject" Target="../embeddings/oleObject27.bin"/><Relationship Id="rId4" Type="http://schemas.openxmlformats.org/officeDocument/2006/relationships/image" Target="../media/image13.e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18.emf"/><Relationship Id="rId22" Type="http://schemas.openxmlformats.org/officeDocument/2006/relationships/image" Target="../media/image22.emf"/><Relationship Id="rId27" Type="http://schemas.openxmlformats.org/officeDocument/2006/relationships/oleObject" Target="../embeddings/oleObject25.bin"/><Relationship Id="rId30" Type="http://schemas.openxmlformats.org/officeDocument/2006/relationships/image" Target="../media/image26.emf"/><Relationship Id="rId8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34.bin"/><Relationship Id="rId18" Type="http://schemas.openxmlformats.org/officeDocument/2006/relationships/image" Target="../media/image36.emf"/><Relationship Id="rId26" Type="http://schemas.openxmlformats.org/officeDocument/2006/relationships/image" Target="../media/image40.emf"/><Relationship Id="rId3" Type="http://schemas.openxmlformats.org/officeDocument/2006/relationships/oleObject" Target="../embeddings/oleObject29.bin"/><Relationship Id="rId21" Type="http://schemas.openxmlformats.org/officeDocument/2006/relationships/oleObject" Target="../embeddings/oleObject38.bin"/><Relationship Id="rId34" Type="http://schemas.openxmlformats.org/officeDocument/2006/relationships/image" Target="../media/image44.emf"/><Relationship Id="rId7" Type="http://schemas.openxmlformats.org/officeDocument/2006/relationships/oleObject" Target="../embeddings/oleObject31.bin"/><Relationship Id="rId12" Type="http://schemas.openxmlformats.org/officeDocument/2006/relationships/image" Target="../media/image33.emf"/><Relationship Id="rId17" Type="http://schemas.openxmlformats.org/officeDocument/2006/relationships/oleObject" Target="../embeddings/oleObject36.bin"/><Relationship Id="rId25" Type="http://schemas.openxmlformats.org/officeDocument/2006/relationships/oleObject" Target="../embeddings/oleObject40.bin"/><Relationship Id="rId33" Type="http://schemas.openxmlformats.org/officeDocument/2006/relationships/oleObject" Target="../embeddings/oleObject44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5.emf"/><Relationship Id="rId20" Type="http://schemas.openxmlformats.org/officeDocument/2006/relationships/image" Target="../media/image37.emf"/><Relationship Id="rId29" Type="http://schemas.openxmlformats.org/officeDocument/2006/relationships/oleObject" Target="../embeddings/oleObject42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30.emf"/><Relationship Id="rId11" Type="http://schemas.openxmlformats.org/officeDocument/2006/relationships/oleObject" Target="../embeddings/oleObject33.bin"/><Relationship Id="rId24" Type="http://schemas.openxmlformats.org/officeDocument/2006/relationships/image" Target="../media/image39.emf"/><Relationship Id="rId32" Type="http://schemas.openxmlformats.org/officeDocument/2006/relationships/image" Target="../media/image43.emf"/><Relationship Id="rId5" Type="http://schemas.openxmlformats.org/officeDocument/2006/relationships/oleObject" Target="../embeddings/oleObject30.bin"/><Relationship Id="rId15" Type="http://schemas.openxmlformats.org/officeDocument/2006/relationships/oleObject" Target="../embeddings/oleObject35.bin"/><Relationship Id="rId23" Type="http://schemas.openxmlformats.org/officeDocument/2006/relationships/oleObject" Target="../embeddings/oleObject39.bin"/><Relationship Id="rId28" Type="http://schemas.openxmlformats.org/officeDocument/2006/relationships/image" Target="../media/image41.emf"/><Relationship Id="rId10" Type="http://schemas.openxmlformats.org/officeDocument/2006/relationships/image" Target="../media/image32.emf"/><Relationship Id="rId19" Type="http://schemas.openxmlformats.org/officeDocument/2006/relationships/oleObject" Target="../embeddings/oleObject37.bin"/><Relationship Id="rId31" Type="http://schemas.openxmlformats.org/officeDocument/2006/relationships/oleObject" Target="../embeddings/oleObject43.bin"/><Relationship Id="rId4" Type="http://schemas.openxmlformats.org/officeDocument/2006/relationships/image" Target="../media/image29.emf"/><Relationship Id="rId9" Type="http://schemas.openxmlformats.org/officeDocument/2006/relationships/oleObject" Target="../embeddings/oleObject32.bin"/><Relationship Id="rId14" Type="http://schemas.openxmlformats.org/officeDocument/2006/relationships/image" Target="../media/image34.emf"/><Relationship Id="rId22" Type="http://schemas.openxmlformats.org/officeDocument/2006/relationships/image" Target="../media/image38.emf"/><Relationship Id="rId27" Type="http://schemas.openxmlformats.org/officeDocument/2006/relationships/oleObject" Target="../embeddings/oleObject41.bin"/><Relationship Id="rId30" Type="http://schemas.openxmlformats.org/officeDocument/2006/relationships/image" Target="../media/image42.emf"/><Relationship Id="rId8" Type="http://schemas.openxmlformats.org/officeDocument/2006/relationships/image" Target="../media/image31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emf"/><Relationship Id="rId3" Type="http://schemas.openxmlformats.org/officeDocument/2006/relationships/oleObject" Target="../embeddings/oleObject45.bin"/><Relationship Id="rId7" Type="http://schemas.openxmlformats.org/officeDocument/2006/relationships/oleObject" Target="../embeddings/oleObject47.bin"/><Relationship Id="rId12" Type="http://schemas.openxmlformats.org/officeDocument/2006/relationships/image" Target="../media/image4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46.emf"/><Relationship Id="rId11" Type="http://schemas.openxmlformats.org/officeDocument/2006/relationships/oleObject" Target="../embeddings/oleObject49.bin"/><Relationship Id="rId5" Type="http://schemas.openxmlformats.org/officeDocument/2006/relationships/oleObject" Target="../embeddings/oleObject46.bin"/><Relationship Id="rId10" Type="http://schemas.openxmlformats.org/officeDocument/2006/relationships/image" Target="../media/image48.emf"/><Relationship Id="rId4" Type="http://schemas.openxmlformats.org/officeDocument/2006/relationships/image" Target="../media/image45.emf"/><Relationship Id="rId9" Type="http://schemas.openxmlformats.org/officeDocument/2006/relationships/oleObject" Target="../embeddings/oleObject4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4"/>
          <p:cNvGrpSpPr>
            <a:grpSpLocks noChangeAspect="1"/>
          </p:cNvGrpSpPr>
          <p:nvPr/>
        </p:nvGrpSpPr>
        <p:grpSpPr bwMode="auto">
          <a:xfrm>
            <a:off x="957190" y="1322499"/>
            <a:ext cx="4981576" cy="6623051"/>
            <a:chOff x="181" y="458"/>
            <a:chExt cx="3138" cy="4172"/>
          </a:xfrm>
        </p:grpSpPr>
        <p:grpSp>
          <p:nvGrpSpPr>
            <p:cNvPr id="5" name="Group 205"/>
            <p:cNvGrpSpPr>
              <a:grpSpLocks/>
            </p:cNvGrpSpPr>
            <p:nvPr/>
          </p:nvGrpSpPr>
          <p:grpSpPr bwMode="auto">
            <a:xfrm>
              <a:off x="1662" y="1123"/>
              <a:ext cx="1657" cy="3365"/>
              <a:chOff x="1662" y="1123"/>
              <a:chExt cx="1657" cy="3365"/>
            </a:xfrm>
          </p:grpSpPr>
          <p:sp>
            <p:nvSpPr>
              <p:cNvPr id="195" name="Rectangle 6"/>
              <p:cNvSpPr>
                <a:spLocks noChangeArrowheads="1"/>
              </p:cNvSpPr>
              <p:nvPr/>
            </p:nvSpPr>
            <p:spPr bwMode="auto">
              <a:xfrm rot="16200000">
                <a:off x="1290" y="1495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7086/2015</a:t>
                </a:r>
              </a:p>
            </p:txBody>
          </p:sp>
          <p:sp>
            <p:nvSpPr>
              <p:cNvPr id="196" name="Line 7"/>
              <p:cNvSpPr>
                <a:spLocks noChangeShapeType="1"/>
              </p:cNvSpPr>
              <p:nvPr/>
            </p:nvSpPr>
            <p:spPr bwMode="auto">
              <a:xfrm>
                <a:off x="1723" y="1965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Rectangle 8"/>
              <p:cNvSpPr>
                <a:spLocks noChangeArrowheads="1"/>
              </p:cNvSpPr>
              <p:nvPr/>
            </p:nvSpPr>
            <p:spPr bwMode="auto">
              <a:xfrm rot="16500000">
                <a:off x="1408" y="1497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8308/2015</a:t>
                </a:r>
              </a:p>
            </p:txBody>
          </p:sp>
          <p:sp>
            <p:nvSpPr>
              <p:cNvPr id="198" name="Line 9"/>
              <p:cNvSpPr>
                <a:spLocks noChangeShapeType="1"/>
              </p:cNvSpPr>
              <p:nvPr/>
            </p:nvSpPr>
            <p:spPr bwMode="auto">
              <a:xfrm>
                <a:off x="1798" y="1971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Arc 10"/>
              <p:cNvSpPr>
                <a:spLocks/>
              </p:cNvSpPr>
              <p:nvPr/>
            </p:nvSpPr>
            <p:spPr bwMode="auto">
              <a:xfrm>
                <a:off x="1723" y="1965"/>
                <a:ext cx="37" cy="810"/>
              </a:xfrm>
              <a:custGeom>
                <a:avLst/>
                <a:gdLst>
                  <a:gd name="G0" fmla="+- 0 0 0"/>
                  <a:gd name="G1" fmla="+- 21600 0 0"/>
                  <a:gd name="G2" fmla="+- 21600 0 0"/>
                  <a:gd name="T0" fmla="*/ 0 w 984"/>
                  <a:gd name="T1" fmla="*/ 0 h 21600"/>
                  <a:gd name="T2" fmla="*/ 984 w 984"/>
                  <a:gd name="T3" fmla="*/ 22 h 21600"/>
                  <a:gd name="T4" fmla="*/ 0 w 984"/>
                  <a:gd name="T5" fmla="*/ 21600 h 216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84" h="21600" fill="none" extrusionOk="0">
                    <a:moveTo>
                      <a:pt x="-1" y="0"/>
                    </a:moveTo>
                    <a:cubicBezTo>
                      <a:pt x="328" y="0"/>
                      <a:pt x="656" y="7"/>
                      <a:pt x="983" y="22"/>
                    </a:cubicBezTo>
                  </a:path>
                  <a:path w="984" h="21600" stroke="0" extrusionOk="0">
                    <a:moveTo>
                      <a:pt x="-1" y="0"/>
                    </a:moveTo>
                    <a:cubicBezTo>
                      <a:pt x="328" y="0"/>
                      <a:pt x="656" y="7"/>
                      <a:pt x="983" y="22"/>
                    </a:cubicBezTo>
                    <a:lnTo>
                      <a:pt x="0" y="2160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Arc 11"/>
              <p:cNvSpPr>
                <a:spLocks/>
              </p:cNvSpPr>
              <p:nvPr/>
            </p:nvSpPr>
            <p:spPr bwMode="auto">
              <a:xfrm>
                <a:off x="1723" y="1966"/>
                <a:ext cx="75" cy="809"/>
              </a:xfrm>
              <a:custGeom>
                <a:avLst/>
                <a:gdLst>
                  <a:gd name="G0" fmla="+- 0 0 0"/>
                  <a:gd name="G1" fmla="+- 21578 0 0"/>
                  <a:gd name="G2" fmla="+- 21600 0 0"/>
                  <a:gd name="T0" fmla="*/ 984 w 2004"/>
                  <a:gd name="T1" fmla="*/ 0 h 21578"/>
                  <a:gd name="T2" fmla="*/ 2004 w 2004"/>
                  <a:gd name="T3" fmla="*/ 71 h 21578"/>
                  <a:gd name="T4" fmla="*/ 0 w 2004"/>
                  <a:gd name="T5" fmla="*/ 21578 h 215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04" h="21578" fill="none" extrusionOk="0">
                    <a:moveTo>
                      <a:pt x="983" y="0"/>
                    </a:moveTo>
                    <a:cubicBezTo>
                      <a:pt x="1324" y="15"/>
                      <a:pt x="1664" y="39"/>
                      <a:pt x="2003" y="71"/>
                    </a:cubicBezTo>
                  </a:path>
                  <a:path w="2004" h="21578" stroke="0" extrusionOk="0">
                    <a:moveTo>
                      <a:pt x="983" y="0"/>
                    </a:moveTo>
                    <a:cubicBezTo>
                      <a:pt x="1324" y="15"/>
                      <a:pt x="1664" y="39"/>
                      <a:pt x="2003" y="71"/>
                    </a:cubicBezTo>
                    <a:lnTo>
                      <a:pt x="0" y="21578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Line 13"/>
              <p:cNvSpPr>
                <a:spLocks noChangeShapeType="1"/>
              </p:cNvSpPr>
              <p:nvPr/>
            </p:nvSpPr>
            <p:spPr bwMode="auto">
              <a:xfrm flipV="1">
                <a:off x="1755" y="1965"/>
                <a:ext cx="5" cy="8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Rectangle 14"/>
              <p:cNvSpPr>
                <a:spLocks noChangeArrowheads="1"/>
              </p:cNvSpPr>
              <p:nvPr/>
            </p:nvSpPr>
            <p:spPr bwMode="auto">
              <a:xfrm rot="16800000">
                <a:off x="1527" y="1526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6516/2015</a:t>
                </a:r>
              </a:p>
            </p:txBody>
          </p:sp>
          <p:sp>
            <p:nvSpPr>
              <p:cNvPr id="204" name="Line 15"/>
              <p:cNvSpPr>
                <a:spLocks noChangeShapeType="1"/>
              </p:cNvSpPr>
              <p:nvPr/>
            </p:nvSpPr>
            <p:spPr bwMode="auto">
              <a:xfrm flipV="1">
                <a:off x="1857" y="1981"/>
                <a:ext cx="16" cy="8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Arc 16"/>
              <p:cNvSpPr>
                <a:spLocks/>
              </p:cNvSpPr>
              <p:nvPr/>
            </p:nvSpPr>
            <p:spPr bwMode="auto">
              <a:xfrm>
                <a:off x="1723" y="2047"/>
                <a:ext cx="86" cy="728"/>
              </a:xfrm>
              <a:custGeom>
                <a:avLst/>
                <a:gdLst>
                  <a:gd name="G0" fmla="+- 0 0 0"/>
                  <a:gd name="G1" fmla="+- 21579 0 0"/>
                  <a:gd name="G2" fmla="+- 21600 0 0"/>
                  <a:gd name="T0" fmla="*/ 946 w 2544"/>
                  <a:gd name="T1" fmla="*/ 0 h 21579"/>
                  <a:gd name="T2" fmla="*/ 2544 w 2544"/>
                  <a:gd name="T3" fmla="*/ 129 h 21579"/>
                  <a:gd name="T4" fmla="*/ 0 w 2544"/>
                  <a:gd name="T5" fmla="*/ 21579 h 215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44" h="21579" fill="none" extrusionOk="0">
                    <a:moveTo>
                      <a:pt x="946" y="-1"/>
                    </a:moveTo>
                    <a:cubicBezTo>
                      <a:pt x="1480" y="23"/>
                      <a:pt x="2013" y="66"/>
                      <a:pt x="2543" y="129"/>
                    </a:cubicBezTo>
                  </a:path>
                  <a:path w="2544" h="21579" stroke="0" extrusionOk="0">
                    <a:moveTo>
                      <a:pt x="946" y="-1"/>
                    </a:moveTo>
                    <a:cubicBezTo>
                      <a:pt x="1480" y="23"/>
                      <a:pt x="2013" y="66"/>
                      <a:pt x="2543" y="129"/>
                    </a:cubicBezTo>
                    <a:lnTo>
                      <a:pt x="0" y="21579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Arc 17"/>
              <p:cNvSpPr>
                <a:spLocks/>
              </p:cNvSpPr>
              <p:nvPr/>
            </p:nvSpPr>
            <p:spPr bwMode="auto">
              <a:xfrm>
                <a:off x="1723" y="2052"/>
                <a:ext cx="133" cy="723"/>
              </a:xfrm>
              <a:custGeom>
                <a:avLst/>
                <a:gdLst>
                  <a:gd name="G0" fmla="+- 0 0 0"/>
                  <a:gd name="G1" fmla="+- 21450 0 0"/>
                  <a:gd name="G2" fmla="+- 21600 0 0"/>
                  <a:gd name="T0" fmla="*/ 2544 w 3952"/>
                  <a:gd name="T1" fmla="*/ 0 h 21450"/>
                  <a:gd name="T2" fmla="*/ 3952 w 3952"/>
                  <a:gd name="T3" fmla="*/ 215 h 21450"/>
                  <a:gd name="T4" fmla="*/ 0 w 3952"/>
                  <a:gd name="T5" fmla="*/ 21450 h 214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52" h="21450" fill="none" extrusionOk="0">
                    <a:moveTo>
                      <a:pt x="2543" y="0"/>
                    </a:moveTo>
                    <a:cubicBezTo>
                      <a:pt x="3015" y="56"/>
                      <a:pt x="3485" y="127"/>
                      <a:pt x="3952" y="214"/>
                    </a:cubicBezTo>
                  </a:path>
                  <a:path w="3952" h="21450" stroke="0" extrusionOk="0">
                    <a:moveTo>
                      <a:pt x="2543" y="0"/>
                    </a:moveTo>
                    <a:cubicBezTo>
                      <a:pt x="3015" y="56"/>
                      <a:pt x="3485" y="127"/>
                      <a:pt x="3952" y="214"/>
                    </a:cubicBezTo>
                    <a:lnTo>
                      <a:pt x="0" y="2145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Rectangle 18"/>
              <p:cNvSpPr>
                <a:spLocks noChangeArrowheads="1"/>
              </p:cNvSpPr>
              <p:nvPr/>
            </p:nvSpPr>
            <p:spPr bwMode="auto">
              <a:xfrm rot="16560000">
                <a:off x="1734" y="2052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9</a:t>
                </a:r>
                <a:endParaRPr kumimoji="0" lang="zh-TW" altLang="zh-TW" sz="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8" name="Line 19"/>
              <p:cNvSpPr>
                <a:spLocks noChangeShapeType="1"/>
              </p:cNvSpPr>
              <p:nvPr/>
            </p:nvSpPr>
            <p:spPr bwMode="auto">
              <a:xfrm flipV="1">
                <a:off x="1792" y="2051"/>
                <a:ext cx="17" cy="16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Rectangle 20"/>
              <p:cNvSpPr>
                <a:spLocks noChangeArrowheads="1"/>
              </p:cNvSpPr>
              <p:nvPr/>
            </p:nvSpPr>
            <p:spPr bwMode="auto">
              <a:xfrm rot="17100000">
                <a:off x="1590" y="1701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D2/Taiwan/20769/2015</a:t>
                </a:r>
              </a:p>
            </p:txBody>
          </p:sp>
          <p:sp>
            <p:nvSpPr>
              <p:cNvPr id="210" name="Line 21"/>
              <p:cNvSpPr>
                <a:spLocks noChangeShapeType="1"/>
              </p:cNvSpPr>
              <p:nvPr/>
            </p:nvSpPr>
            <p:spPr bwMode="auto">
              <a:xfrm flipV="1">
                <a:off x="1878" y="2153"/>
                <a:ext cx="22" cy="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Arc 22"/>
              <p:cNvSpPr>
                <a:spLocks/>
              </p:cNvSpPr>
              <p:nvPr/>
            </p:nvSpPr>
            <p:spPr bwMode="auto">
              <a:xfrm>
                <a:off x="1723" y="2210"/>
                <a:ext cx="112" cy="564"/>
              </a:xfrm>
              <a:custGeom>
                <a:avLst/>
                <a:gdLst>
                  <a:gd name="G0" fmla="+- 0 0 0"/>
                  <a:gd name="G1" fmla="+- 21462 0 0"/>
                  <a:gd name="G2" fmla="+- 21600 0 0"/>
                  <a:gd name="T0" fmla="*/ 2440 w 4251"/>
                  <a:gd name="T1" fmla="*/ 0 h 21462"/>
                  <a:gd name="T2" fmla="*/ 4251 w 4251"/>
                  <a:gd name="T3" fmla="*/ 284 h 21462"/>
                  <a:gd name="T4" fmla="*/ 0 w 4251"/>
                  <a:gd name="T5" fmla="*/ 21462 h 214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51" h="21462" fill="none" extrusionOk="0">
                    <a:moveTo>
                      <a:pt x="2439" y="0"/>
                    </a:moveTo>
                    <a:cubicBezTo>
                      <a:pt x="3047" y="69"/>
                      <a:pt x="3651" y="164"/>
                      <a:pt x="4250" y="284"/>
                    </a:cubicBezTo>
                  </a:path>
                  <a:path w="4251" h="21462" stroke="0" extrusionOk="0">
                    <a:moveTo>
                      <a:pt x="2439" y="0"/>
                    </a:moveTo>
                    <a:cubicBezTo>
                      <a:pt x="3047" y="69"/>
                      <a:pt x="3651" y="164"/>
                      <a:pt x="4250" y="284"/>
                    </a:cubicBezTo>
                    <a:lnTo>
                      <a:pt x="0" y="21462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Arc 23"/>
              <p:cNvSpPr>
                <a:spLocks/>
              </p:cNvSpPr>
              <p:nvPr/>
            </p:nvSpPr>
            <p:spPr bwMode="auto">
              <a:xfrm>
                <a:off x="1723" y="2217"/>
                <a:ext cx="155" cy="557"/>
              </a:xfrm>
              <a:custGeom>
                <a:avLst/>
                <a:gdLst>
                  <a:gd name="G0" fmla="+- 0 0 0"/>
                  <a:gd name="G1" fmla="+- 21178 0 0"/>
                  <a:gd name="G2" fmla="+- 21600 0 0"/>
                  <a:gd name="T0" fmla="*/ 4251 w 5889"/>
                  <a:gd name="T1" fmla="*/ 0 h 21178"/>
                  <a:gd name="T2" fmla="*/ 5889 w 5889"/>
                  <a:gd name="T3" fmla="*/ 396 h 21178"/>
                  <a:gd name="T4" fmla="*/ 0 w 5889"/>
                  <a:gd name="T5" fmla="*/ 21178 h 211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889" h="21178" fill="none" extrusionOk="0">
                    <a:moveTo>
                      <a:pt x="4250" y="0"/>
                    </a:moveTo>
                    <a:cubicBezTo>
                      <a:pt x="4801" y="111"/>
                      <a:pt x="5348" y="243"/>
                      <a:pt x="5888" y="396"/>
                    </a:cubicBezTo>
                  </a:path>
                  <a:path w="5889" h="21178" stroke="0" extrusionOk="0">
                    <a:moveTo>
                      <a:pt x="4250" y="0"/>
                    </a:moveTo>
                    <a:cubicBezTo>
                      <a:pt x="4801" y="111"/>
                      <a:pt x="5348" y="243"/>
                      <a:pt x="5888" y="396"/>
                    </a:cubicBezTo>
                    <a:lnTo>
                      <a:pt x="0" y="21178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Line 25"/>
              <p:cNvSpPr>
                <a:spLocks noChangeShapeType="1"/>
              </p:cNvSpPr>
              <p:nvPr/>
            </p:nvSpPr>
            <p:spPr bwMode="auto">
              <a:xfrm flipV="1">
                <a:off x="1819" y="2217"/>
                <a:ext cx="16" cy="8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Rectangle 26"/>
              <p:cNvSpPr>
                <a:spLocks noChangeArrowheads="1"/>
              </p:cNvSpPr>
              <p:nvPr/>
            </p:nvSpPr>
            <p:spPr bwMode="auto">
              <a:xfrm rot="17460000">
                <a:off x="1693" y="1734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D2/Taiwan/24564/2015</a:t>
                </a:r>
              </a:p>
            </p:txBody>
          </p:sp>
          <p:sp>
            <p:nvSpPr>
              <p:cNvPr id="216" name="Line 27"/>
              <p:cNvSpPr>
                <a:spLocks noChangeShapeType="1"/>
              </p:cNvSpPr>
              <p:nvPr/>
            </p:nvSpPr>
            <p:spPr bwMode="auto">
              <a:xfrm flipV="1">
                <a:off x="1905" y="2169"/>
                <a:ext cx="54" cy="1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Arc 28"/>
              <p:cNvSpPr>
                <a:spLocks/>
              </p:cNvSpPr>
              <p:nvPr/>
            </p:nvSpPr>
            <p:spPr bwMode="auto">
              <a:xfrm>
                <a:off x="1723" y="2297"/>
                <a:ext cx="136" cy="478"/>
              </a:xfrm>
              <a:custGeom>
                <a:avLst/>
                <a:gdLst>
                  <a:gd name="G0" fmla="+- 0 0 0"/>
                  <a:gd name="G1" fmla="+- 21179 0 0"/>
                  <a:gd name="G2" fmla="+- 21600 0 0"/>
                  <a:gd name="T0" fmla="*/ 4245 w 6018"/>
                  <a:gd name="T1" fmla="*/ 0 h 21179"/>
                  <a:gd name="T2" fmla="*/ 6018 w 6018"/>
                  <a:gd name="T3" fmla="*/ 434 h 21179"/>
                  <a:gd name="T4" fmla="*/ 0 w 6018"/>
                  <a:gd name="T5" fmla="*/ 21179 h 211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18" h="21179" fill="none" extrusionOk="0">
                    <a:moveTo>
                      <a:pt x="4244" y="0"/>
                    </a:moveTo>
                    <a:cubicBezTo>
                      <a:pt x="4841" y="119"/>
                      <a:pt x="5433" y="264"/>
                      <a:pt x="6017" y="434"/>
                    </a:cubicBezTo>
                  </a:path>
                  <a:path w="6018" h="21179" stroke="0" extrusionOk="0">
                    <a:moveTo>
                      <a:pt x="4244" y="0"/>
                    </a:moveTo>
                    <a:cubicBezTo>
                      <a:pt x="4841" y="119"/>
                      <a:pt x="5433" y="264"/>
                      <a:pt x="6017" y="434"/>
                    </a:cubicBezTo>
                    <a:lnTo>
                      <a:pt x="0" y="21179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Arc 29"/>
              <p:cNvSpPr>
                <a:spLocks/>
              </p:cNvSpPr>
              <p:nvPr/>
            </p:nvSpPr>
            <p:spPr bwMode="auto">
              <a:xfrm>
                <a:off x="1723" y="2307"/>
                <a:ext cx="176" cy="468"/>
              </a:xfrm>
              <a:custGeom>
                <a:avLst/>
                <a:gdLst>
                  <a:gd name="G0" fmla="+- 0 0 0"/>
                  <a:gd name="G1" fmla="+- 20745 0 0"/>
                  <a:gd name="G2" fmla="+- 21600 0 0"/>
                  <a:gd name="T0" fmla="*/ 6018 w 7802"/>
                  <a:gd name="T1" fmla="*/ 0 h 20745"/>
                  <a:gd name="T2" fmla="*/ 7802 w 7802"/>
                  <a:gd name="T3" fmla="*/ 603 h 20745"/>
                  <a:gd name="T4" fmla="*/ 0 w 7802"/>
                  <a:gd name="T5" fmla="*/ 20745 h 207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802" h="20745" fill="none" extrusionOk="0">
                    <a:moveTo>
                      <a:pt x="6017" y="0"/>
                    </a:moveTo>
                    <a:cubicBezTo>
                      <a:pt x="6621" y="175"/>
                      <a:pt x="7216" y="376"/>
                      <a:pt x="7801" y="603"/>
                    </a:cubicBezTo>
                  </a:path>
                  <a:path w="7802" h="20745" stroke="0" extrusionOk="0">
                    <a:moveTo>
                      <a:pt x="6017" y="0"/>
                    </a:moveTo>
                    <a:cubicBezTo>
                      <a:pt x="6621" y="175"/>
                      <a:pt x="7216" y="376"/>
                      <a:pt x="7801" y="603"/>
                    </a:cubicBezTo>
                    <a:lnTo>
                      <a:pt x="0" y="20745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Line 31"/>
              <p:cNvSpPr>
                <a:spLocks noChangeShapeType="1"/>
              </p:cNvSpPr>
              <p:nvPr/>
            </p:nvSpPr>
            <p:spPr bwMode="auto">
              <a:xfrm>
                <a:off x="1862" y="2308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Rectangle 32"/>
              <p:cNvSpPr>
                <a:spLocks noChangeArrowheads="1"/>
              </p:cNvSpPr>
              <p:nvPr/>
            </p:nvSpPr>
            <p:spPr bwMode="auto">
              <a:xfrm rot="17760000">
                <a:off x="1749" y="1840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D2/Taiwan/21909/2015</a:t>
                </a:r>
              </a:p>
            </p:txBody>
          </p:sp>
          <p:sp>
            <p:nvSpPr>
              <p:cNvPr id="222" name="Line 33"/>
              <p:cNvSpPr>
                <a:spLocks noChangeShapeType="1"/>
              </p:cNvSpPr>
              <p:nvPr/>
            </p:nvSpPr>
            <p:spPr bwMode="auto">
              <a:xfrm flipV="1">
                <a:off x="1943" y="2265"/>
                <a:ext cx="32" cy="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Rectangle 34"/>
              <p:cNvSpPr>
                <a:spLocks noChangeArrowheads="1"/>
              </p:cNvSpPr>
              <p:nvPr/>
            </p:nvSpPr>
            <p:spPr bwMode="auto">
              <a:xfrm rot="18060000">
                <a:off x="1826" y="1892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8317/2015</a:t>
                </a:r>
              </a:p>
            </p:txBody>
          </p:sp>
          <p:sp>
            <p:nvSpPr>
              <p:cNvPr id="224" name="Line 35"/>
              <p:cNvSpPr>
                <a:spLocks noChangeShapeType="1"/>
              </p:cNvSpPr>
              <p:nvPr/>
            </p:nvSpPr>
            <p:spPr bwMode="auto">
              <a:xfrm flipV="1">
                <a:off x="1980" y="2292"/>
                <a:ext cx="43" cy="7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Rectangle 36"/>
              <p:cNvSpPr>
                <a:spLocks noChangeArrowheads="1"/>
              </p:cNvSpPr>
              <p:nvPr/>
            </p:nvSpPr>
            <p:spPr bwMode="auto">
              <a:xfrm rot="18420000">
                <a:off x="1956" y="1880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6752/2015</a:t>
                </a:r>
              </a:p>
            </p:txBody>
          </p:sp>
          <p:sp>
            <p:nvSpPr>
              <p:cNvPr id="226" name="Line 37"/>
              <p:cNvSpPr>
                <a:spLocks noChangeShapeType="1"/>
              </p:cNvSpPr>
              <p:nvPr/>
            </p:nvSpPr>
            <p:spPr bwMode="auto">
              <a:xfrm>
                <a:off x="2114" y="2255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Rectangle 38"/>
              <p:cNvSpPr>
                <a:spLocks noChangeArrowheads="1"/>
              </p:cNvSpPr>
              <p:nvPr/>
            </p:nvSpPr>
            <p:spPr bwMode="auto">
              <a:xfrm rot="18720000">
                <a:off x="2079" y="1888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8318/2015</a:t>
                </a:r>
              </a:p>
            </p:txBody>
          </p:sp>
          <p:sp>
            <p:nvSpPr>
              <p:cNvPr id="228" name="Line 39"/>
              <p:cNvSpPr>
                <a:spLocks noChangeShapeType="1"/>
              </p:cNvSpPr>
              <p:nvPr/>
            </p:nvSpPr>
            <p:spPr bwMode="auto">
              <a:xfrm flipV="1">
                <a:off x="2163" y="2239"/>
                <a:ext cx="53" cy="5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Arc 40"/>
              <p:cNvSpPr>
                <a:spLocks/>
              </p:cNvSpPr>
              <p:nvPr/>
            </p:nvSpPr>
            <p:spPr bwMode="auto">
              <a:xfrm>
                <a:off x="1723" y="2258"/>
                <a:ext cx="417" cy="517"/>
              </a:xfrm>
              <a:custGeom>
                <a:avLst/>
                <a:gdLst>
                  <a:gd name="G0" fmla="+- 0 0 0"/>
                  <a:gd name="G1" fmla="+- 17213 0 0"/>
                  <a:gd name="G2" fmla="+- 21600 0 0"/>
                  <a:gd name="T0" fmla="*/ 13049 w 13858"/>
                  <a:gd name="T1" fmla="*/ 0 h 17213"/>
                  <a:gd name="T2" fmla="*/ 13858 w 13858"/>
                  <a:gd name="T3" fmla="*/ 644 h 17213"/>
                  <a:gd name="T4" fmla="*/ 0 w 13858"/>
                  <a:gd name="T5" fmla="*/ 17213 h 17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858" h="17213" fill="none" extrusionOk="0">
                    <a:moveTo>
                      <a:pt x="13048" y="0"/>
                    </a:moveTo>
                    <a:cubicBezTo>
                      <a:pt x="13323" y="208"/>
                      <a:pt x="13593" y="423"/>
                      <a:pt x="13857" y="644"/>
                    </a:cubicBezTo>
                  </a:path>
                  <a:path w="13858" h="17213" stroke="0" extrusionOk="0">
                    <a:moveTo>
                      <a:pt x="13048" y="0"/>
                    </a:moveTo>
                    <a:cubicBezTo>
                      <a:pt x="13323" y="208"/>
                      <a:pt x="13593" y="423"/>
                      <a:pt x="13857" y="644"/>
                    </a:cubicBezTo>
                    <a:lnTo>
                      <a:pt x="0" y="17213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Arc 41"/>
              <p:cNvSpPr>
                <a:spLocks/>
              </p:cNvSpPr>
              <p:nvPr/>
            </p:nvSpPr>
            <p:spPr bwMode="auto">
              <a:xfrm>
                <a:off x="1723" y="2278"/>
                <a:ext cx="440" cy="497"/>
              </a:xfrm>
              <a:custGeom>
                <a:avLst/>
                <a:gdLst>
                  <a:gd name="G0" fmla="+- 0 0 0"/>
                  <a:gd name="G1" fmla="+- 16569 0 0"/>
                  <a:gd name="G2" fmla="+- 21600 0 0"/>
                  <a:gd name="T0" fmla="*/ 13858 w 14617"/>
                  <a:gd name="T1" fmla="*/ 0 h 16569"/>
                  <a:gd name="T2" fmla="*/ 14617 w 14617"/>
                  <a:gd name="T3" fmla="*/ 666 h 16569"/>
                  <a:gd name="T4" fmla="*/ 0 w 14617"/>
                  <a:gd name="T5" fmla="*/ 16569 h 165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617" h="16569" fill="none" extrusionOk="0">
                    <a:moveTo>
                      <a:pt x="13857" y="0"/>
                    </a:moveTo>
                    <a:cubicBezTo>
                      <a:pt x="14115" y="216"/>
                      <a:pt x="14369" y="438"/>
                      <a:pt x="14616" y="666"/>
                    </a:cubicBezTo>
                  </a:path>
                  <a:path w="14617" h="16569" stroke="0" extrusionOk="0">
                    <a:moveTo>
                      <a:pt x="13857" y="0"/>
                    </a:moveTo>
                    <a:cubicBezTo>
                      <a:pt x="14115" y="216"/>
                      <a:pt x="14369" y="438"/>
                      <a:pt x="14616" y="666"/>
                    </a:cubicBezTo>
                    <a:lnTo>
                      <a:pt x="0" y="16569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Rectangle 42"/>
              <p:cNvSpPr>
                <a:spLocks noChangeArrowheads="1"/>
              </p:cNvSpPr>
              <p:nvPr/>
            </p:nvSpPr>
            <p:spPr bwMode="auto">
              <a:xfrm rot="18540000">
                <a:off x="2098" y="2290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5</a:t>
                </a:r>
                <a:endParaRPr kumimoji="0" lang="zh-TW" altLang="zh-TW" sz="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2" name="Line 43"/>
              <p:cNvSpPr>
                <a:spLocks noChangeShapeType="1"/>
              </p:cNvSpPr>
              <p:nvPr/>
            </p:nvSpPr>
            <p:spPr bwMode="auto">
              <a:xfrm flipV="1">
                <a:off x="2034" y="2276"/>
                <a:ext cx="107" cy="1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Arc 44"/>
              <p:cNvSpPr>
                <a:spLocks/>
              </p:cNvSpPr>
              <p:nvPr/>
            </p:nvSpPr>
            <p:spPr bwMode="auto">
              <a:xfrm>
                <a:off x="1723" y="2362"/>
                <a:ext cx="284" cy="413"/>
              </a:xfrm>
              <a:custGeom>
                <a:avLst/>
                <a:gdLst>
                  <a:gd name="G0" fmla="+- 0 0 0"/>
                  <a:gd name="G1" fmla="+- 18287 0 0"/>
                  <a:gd name="G2" fmla="+- 21600 0 0"/>
                  <a:gd name="T0" fmla="*/ 11495 w 12550"/>
                  <a:gd name="T1" fmla="*/ 0 h 18287"/>
                  <a:gd name="T2" fmla="*/ 12550 w 12550"/>
                  <a:gd name="T3" fmla="*/ 707 h 18287"/>
                  <a:gd name="T4" fmla="*/ 0 w 12550"/>
                  <a:gd name="T5" fmla="*/ 18287 h 182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550" h="18287" fill="none" extrusionOk="0">
                    <a:moveTo>
                      <a:pt x="11495" y="-1"/>
                    </a:moveTo>
                    <a:cubicBezTo>
                      <a:pt x="11853" y="225"/>
                      <a:pt x="12205" y="460"/>
                      <a:pt x="12550" y="706"/>
                    </a:cubicBezTo>
                  </a:path>
                  <a:path w="12550" h="18287" stroke="0" extrusionOk="0">
                    <a:moveTo>
                      <a:pt x="11495" y="-1"/>
                    </a:moveTo>
                    <a:cubicBezTo>
                      <a:pt x="11853" y="225"/>
                      <a:pt x="12205" y="460"/>
                      <a:pt x="12550" y="706"/>
                    </a:cubicBezTo>
                    <a:lnTo>
                      <a:pt x="0" y="18287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Arc 45"/>
              <p:cNvSpPr>
                <a:spLocks/>
              </p:cNvSpPr>
              <p:nvPr/>
            </p:nvSpPr>
            <p:spPr bwMode="auto">
              <a:xfrm>
                <a:off x="1723" y="2378"/>
                <a:ext cx="311" cy="397"/>
              </a:xfrm>
              <a:custGeom>
                <a:avLst/>
                <a:gdLst>
                  <a:gd name="G0" fmla="+- 0 0 0"/>
                  <a:gd name="G1" fmla="+- 17580 0 0"/>
                  <a:gd name="G2" fmla="+- 21600 0 0"/>
                  <a:gd name="T0" fmla="*/ 12550 w 13750"/>
                  <a:gd name="T1" fmla="*/ 0 h 17580"/>
                  <a:gd name="T2" fmla="*/ 13750 w 13750"/>
                  <a:gd name="T3" fmla="*/ 922 h 17580"/>
                  <a:gd name="T4" fmla="*/ 0 w 13750"/>
                  <a:gd name="T5" fmla="*/ 17580 h 175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750" h="17580" fill="none" extrusionOk="0">
                    <a:moveTo>
                      <a:pt x="12550" y="-1"/>
                    </a:moveTo>
                    <a:cubicBezTo>
                      <a:pt x="12960" y="293"/>
                      <a:pt x="13360" y="600"/>
                      <a:pt x="13750" y="921"/>
                    </a:cubicBezTo>
                  </a:path>
                  <a:path w="13750" h="17580" stroke="0" extrusionOk="0">
                    <a:moveTo>
                      <a:pt x="12550" y="-1"/>
                    </a:moveTo>
                    <a:cubicBezTo>
                      <a:pt x="12960" y="293"/>
                      <a:pt x="13360" y="600"/>
                      <a:pt x="13750" y="921"/>
                    </a:cubicBezTo>
                    <a:lnTo>
                      <a:pt x="0" y="1758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Line 47"/>
              <p:cNvSpPr>
                <a:spLocks noChangeShapeType="1"/>
              </p:cNvSpPr>
              <p:nvPr/>
            </p:nvSpPr>
            <p:spPr bwMode="auto">
              <a:xfrm>
                <a:off x="2007" y="2378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Arc 48"/>
              <p:cNvSpPr>
                <a:spLocks/>
              </p:cNvSpPr>
              <p:nvPr/>
            </p:nvSpPr>
            <p:spPr bwMode="auto">
              <a:xfrm>
                <a:off x="1723" y="2340"/>
                <a:ext cx="251" cy="435"/>
              </a:xfrm>
              <a:custGeom>
                <a:avLst/>
                <a:gdLst>
                  <a:gd name="G0" fmla="+- 0 0 0"/>
                  <a:gd name="G1" fmla="+- 19283 0 0"/>
                  <a:gd name="G2" fmla="+- 21600 0 0"/>
                  <a:gd name="T0" fmla="*/ 9732 w 11116"/>
                  <a:gd name="T1" fmla="*/ 0 h 19283"/>
                  <a:gd name="T2" fmla="*/ 11116 w 11116"/>
                  <a:gd name="T3" fmla="*/ 763 h 19283"/>
                  <a:gd name="T4" fmla="*/ 0 w 11116"/>
                  <a:gd name="T5" fmla="*/ 19283 h 192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116" h="19283" fill="none" extrusionOk="0">
                    <a:moveTo>
                      <a:pt x="9732" y="-1"/>
                    </a:moveTo>
                    <a:cubicBezTo>
                      <a:pt x="10202" y="237"/>
                      <a:pt x="10664" y="491"/>
                      <a:pt x="11116" y="762"/>
                    </a:cubicBezTo>
                  </a:path>
                  <a:path w="11116" h="19283" stroke="0" extrusionOk="0">
                    <a:moveTo>
                      <a:pt x="9732" y="-1"/>
                    </a:moveTo>
                    <a:cubicBezTo>
                      <a:pt x="10202" y="237"/>
                      <a:pt x="10664" y="491"/>
                      <a:pt x="11116" y="762"/>
                    </a:cubicBezTo>
                    <a:lnTo>
                      <a:pt x="0" y="19283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Arc 49"/>
              <p:cNvSpPr>
                <a:spLocks/>
              </p:cNvSpPr>
              <p:nvPr/>
            </p:nvSpPr>
            <p:spPr bwMode="auto">
              <a:xfrm>
                <a:off x="1723" y="2357"/>
                <a:ext cx="284" cy="418"/>
              </a:xfrm>
              <a:custGeom>
                <a:avLst/>
                <a:gdLst>
                  <a:gd name="G0" fmla="+- 0 0 0"/>
                  <a:gd name="G1" fmla="+- 18520 0 0"/>
                  <a:gd name="G2" fmla="+- 21600 0 0"/>
                  <a:gd name="T0" fmla="*/ 11116 w 12550"/>
                  <a:gd name="T1" fmla="*/ 0 h 18520"/>
                  <a:gd name="T2" fmla="*/ 12550 w 12550"/>
                  <a:gd name="T3" fmla="*/ 940 h 18520"/>
                  <a:gd name="T4" fmla="*/ 0 w 12550"/>
                  <a:gd name="T5" fmla="*/ 18520 h 185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550" h="18520" fill="none" extrusionOk="0">
                    <a:moveTo>
                      <a:pt x="11116" y="-1"/>
                    </a:moveTo>
                    <a:cubicBezTo>
                      <a:pt x="11606" y="294"/>
                      <a:pt x="12084" y="607"/>
                      <a:pt x="12550" y="939"/>
                    </a:cubicBezTo>
                  </a:path>
                  <a:path w="12550" h="18520" stroke="0" extrusionOk="0">
                    <a:moveTo>
                      <a:pt x="11116" y="-1"/>
                    </a:moveTo>
                    <a:cubicBezTo>
                      <a:pt x="11606" y="294"/>
                      <a:pt x="12084" y="607"/>
                      <a:pt x="12550" y="939"/>
                    </a:cubicBezTo>
                    <a:lnTo>
                      <a:pt x="0" y="1852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Line 51"/>
              <p:cNvSpPr>
                <a:spLocks noChangeShapeType="1"/>
              </p:cNvSpPr>
              <p:nvPr/>
            </p:nvSpPr>
            <p:spPr bwMode="auto">
              <a:xfrm>
                <a:off x="1970" y="2356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Arc 52"/>
              <p:cNvSpPr>
                <a:spLocks/>
              </p:cNvSpPr>
              <p:nvPr/>
            </p:nvSpPr>
            <p:spPr bwMode="auto">
              <a:xfrm>
                <a:off x="1723" y="2307"/>
                <a:ext cx="198" cy="468"/>
              </a:xfrm>
              <a:custGeom>
                <a:avLst/>
                <a:gdLst>
                  <a:gd name="G0" fmla="+- 0 0 0"/>
                  <a:gd name="G1" fmla="+- 20745 0 0"/>
                  <a:gd name="G2" fmla="+- 21600 0 0"/>
                  <a:gd name="T0" fmla="*/ 6018 w 8766"/>
                  <a:gd name="T1" fmla="*/ 0 h 20745"/>
                  <a:gd name="T2" fmla="*/ 8766 w 8766"/>
                  <a:gd name="T3" fmla="*/ 1004 h 20745"/>
                  <a:gd name="T4" fmla="*/ 0 w 8766"/>
                  <a:gd name="T5" fmla="*/ 20745 h 207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66" h="20745" fill="none" extrusionOk="0">
                    <a:moveTo>
                      <a:pt x="6017" y="0"/>
                    </a:moveTo>
                    <a:cubicBezTo>
                      <a:pt x="6955" y="272"/>
                      <a:pt x="7873" y="607"/>
                      <a:pt x="8766" y="1003"/>
                    </a:cubicBezTo>
                  </a:path>
                  <a:path w="8766" h="20745" stroke="0" extrusionOk="0">
                    <a:moveTo>
                      <a:pt x="6017" y="0"/>
                    </a:moveTo>
                    <a:cubicBezTo>
                      <a:pt x="6955" y="272"/>
                      <a:pt x="7873" y="607"/>
                      <a:pt x="8766" y="1003"/>
                    </a:cubicBezTo>
                    <a:lnTo>
                      <a:pt x="0" y="20745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Arc 53"/>
              <p:cNvSpPr>
                <a:spLocks/>
              </p:cNvSpPr>
              <p:nvPr/>
            </p:nvSpPr>
            <p:spPr bwMode="auto">
              <a:xfrm>
                <a:off x="1723" y="2329"/>
                <a:ext cx="251" cy="446"/>
              </a:xfrm>
              <a:custGeom>
                <a:avLst/>
                <a:gdLst>
                  <a:gd name="G0" fmla="+- 0 0 0"/>
                  <a:gd name="G1" fmla="+- 19741 0 0"/>
                  <a:gd name="G2" fmla="+- 21600 0 0"/>
                  <a:gd name="T0" fmla="*/ 8766 w 11116"/>
                  <a:gd name="T1" fmla="*/ 0 h 19741"/>
                  <a:gd name="T2" fmla="*/ 11116 w 11116"/>
                  <a:gd name="T3" fmla="*/ 1221 h 19741"/>
                  <a:gd name="T4" fmla="*/ 0 w 11116"/>
                  <a:gd name="T5" fmla="*/ 19741 h 197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116" h="19741" fill="none" extrusionOk="0">
                    <a:moveTo>
                      <a:pt x="8766" y="-1"/>
                    </a:moveTo>
                    <a:cubicBezTo>
                      <a:pt x="9573" y="358"/>
                      <a:pt x="10358" y="766"/>
                      <a:pt x="11116" y="1220"/>
                    </a:cubicBezTo>
                  </a:path>
                  <a:path w="11116" h="19741" stroke="0" extrusionOk="0">
                    <a:moveTo>
                      <a:pt x="8766" y="-1"/>
                    </a:moveTo>
                    <a:cubicBezTo>
                      <a:pt x="9573" y="358"/>
                      <a:pt x="10358" y="766"/>
                      <a:pt x="11116" y="1220"/>
                    </a:cubicBezTo>
                    <a:lnTo>
                      <a:pt x="0" y="19741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Line 55"/>
              <p:cNvSpPr>
                <a:spLocks noChangeShapeType="1"/>
              </p:cNvSpPr>
              <p:nvPr/>
            </p:nvSpPr>
            <p:spPr bwMode="auto">
              <a:xfrm>
                <a:off x="1921" y="2330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Rectangle 56"/>
              <p:cNvSpPr>
                <a:spLocks noChangeArrowheads="1"/>
              </p:cNvSpPr>
              <p:nvPr/>
            </p:nvSpPr>
            <p:spPr bwMode="auto">
              <a:xfrm rot="19020000">
                <a:off x="2029" y="2065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8010/2015</a:t>
                </a:r>
              </a:p>
            </p:txBody>
          </p:sp>
          <p:sp>
            <p:nvSpPr>
              <p:cNvPr id="246" name="Line 57"/>
              <p:cNvSpPr>
                <a:spLocks noChangeShapeType="1"/>
              </p:cNvSpPr>
              <p:nvPr/>
            </p:nvSpPr>
            <p:spPr bwMode="auto">
              <a:xfrm flipV="1">
                <a:off x="2088" y="2394"/>
                <a:ext cx="59" cy="5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" name="Rectangle 58"/>
              <p:cNvSpPr>
                <a:spLocks noChangeArrowheads="1"/>
              </p:cNvSpPr>
              <p:nvPr/>
            </p:nvSpPr>
            <p:spPr bwMode="auto">
              <a:xfrm rot="19380000">
                <a:off x="2220" y="2045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D2/Taiwan/23492/2015</a:t>
                </a:r>
              </a:p>
            </p:txBody>
          </p:sp>
          <p:sp>
            <p:nvSpPr>
              <p:cNvPr id="248" name="Line 59"/>
              <p:cNvSpPr>
                <a:spLocks noChangeShapeType="1"/>
              </p:cNvSpPr>
              <p:nvPr/>
            </p:nvSpPr>
            <p:spPr bwMode="auto">
              <a:xfrm flipV="1">
                <a:off x="2114" y="2335"/>
                <a:ext cx="194" cy="14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Arc 60"/>
              <p:cNvSpPr>
                <a:spLocks/>
              </p:cNvSpPr>
              <p:nvPr/>
            </p:nvSpPr>
            <p:spPr bwMode="auto">
              <a:xfrm>
                <a:off x="1723" y="2446"/>
                <a:ext cx="376" cy="329"/>
              </a:xfrm>
              <a:custGeom>
                <a:avLst/>
                <a:gdLst>
                  <a:gd name="G0" fmla="+- 0 0 0"/>
                  <a:gd name="G1" fmla="+- 14562 0 0"/>
                  <a:gd name="G2" fmla="+- 21600 0 0"/>
                  <a:gd name="T0" fmla="*/ 15954 w 16612"/>
                  <a:gd name="T1" fmla="*/ 0 h 14562"/>
                  <a:gd name="T2" fmla="*/ 16612 w 16612"/>
                  <a:gd name="T3" fmla="*/ 757 h 14562"/>
                  <a:gd name="T4" fmla="*/ 0 w 16612"/>
                  <a:gd name="T5" fmla="*/ 14562 h 145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612" h="14562" fill="none" extrusionOk="0">
                    <a:moveTo>
                      <a:pt x="15953" y="0"/>
                    </a:moveTo>
                    <a:cubicBezTo>
                      <a:pt x="16179" y="247"/>
                      <a:pt x="16398" y="499"/>
                      <a:pt x="16612" y="756"/>
                    </a:cubicBezTo>
                  </a:path>
                  <a:path w="16612" h="14562" stroke="0" extrusionOk="0">
                    <a:moveTo>
                      <a:pt x="15953" y="0"/>
                    </a:moveTo>
                    <a:cubicBezTo>
                      <a:pt x="16179" y="247"/>
                      <a:pt x="16398" y="499"/>
                      <a:pt x="16612" y="756"/>
                    </a:cubicBezTo>
                    <a:lnTo>
                      <a:pt x="0" y="14562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Arc 61"/>
              <p:cNvSpPr>
                <a:spLocks/>
              </p:cNvSpPr>
              <p:nvPr/>
            </p:nvSpPr>
            <p:spPr bwMode="auto">
              <a:xfrm>
                <a:off x="1723" y="2463"/>
                <a:ext cx="390" cy="312"/>
              </a:xfrm>
              <a:custGeom>
                <a:avLst/>
                <a:gdLst>
                  <a:gd name="G0" fmla="+- 0 0 0"/>
                  <a:gd name="G1" fmla="+- 13805 0 0"/>
                  <a:gd name="G2" fmla="+- 21600 0 0"/>
                  <a:gd name="T0" fmla="*/ 16612 w 17256"/>
                  <a:gd name="T1" fmla="*/ 0 h 13805"/>
                  <a:gd name="T2" fmla="*/ 17256 w 17256"/>
                  <a:gd name="T3" fmla="*/ 814 h 13805"/>
                  <a:gd name="T4" fmla="*/ 0 w 17256"/>
                  <a:gd name="T5" fmla="*/ 13805 h 138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256" h="13805" fill="none" extrusionOk="0">
                    <a:moveTo>
                      <a:pt x="16612" y="-1"/>
                    </a:moveTo>
                    <a:cubicBezTo>
                      <a:pt x="16833" y="265"/>
                      <a:pt x="17048" y="537"/>
                      <a:pt x="17256" y="813"/>
                    </a:cubicBezTo>
                  </a:path>
                  <a:path w="17256" h="13805" stroke="0" extrusionOk="0">
                    <a:moveTo>
                      <a:pt x="16612" y="-1"/>
                    </a:moveTo>
                    <a:cubicBezTo>
                      <a:pt x="16833" y="265"/>
                      <a:pt x="17048" y="537"/>
                      <a:pt x="17256" y="813"/>
                    </a:cubicBezTo>
                    <a:lnTo>
                      <a:pt x="0" y="13805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Line 63"/>
              <p:cNvSpPr>
                <a:spLocks noChangeShapeType="1"/>
              </p:cNvSpPr>
              <p:nvPr/>
            </p:nvSpPr>
            <p:spPr bwMode="auto">
              <a:xfrm>
                <a:off x="2098" y="2464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Arc 64"/>
              <p:cNvSpPr>
                <a:spLocks/>
              </p:cNvSpPr>
              <p:nvPr/>
            </p:nvSpPr>
            <p:spPr bwMode="auto">
              <a:xfrm>
                <a:off x="1723" y="2329"/>
                <a:ext cx="293" cy="446"/>
              </a:xfrm>
              <a:custGeom>
                <a:avLst/>
                <a:gdLst>
                  <a:gd name="G0" fmla="+- 0 0 0"/>
                  <a:gd name="G1" fmla="+- 19741 0 0"/>
                  <a:gd name="G2" fmla="+- 21600 0 0"/>
                  <a:gd name="T0" fmla="*/ 8766 w 12971"/>
                  <a:gd name="T1" fmla="*/ 0 h 19741"/>
                  <a:gd name="T2" fmla="*/ 12971 w 12971"/>
                  <a:gd name="T3" fmla="*/ 2469 h 19741"/>
                  <a:gd name="T4" fmla="*/ 0 w 12971"/>
                  <a:gd name="T5" fmla="*/ 19741 h 197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971" h="19741" fill="none" extrusionOk="0">
                    <a:moveTo>
                      <a:pt x="8766" y="-1"/>
                    </a:moveTo>
                    <a:cubicBezTo>
                      <a:pt x="10256" y="661"/>
                      <a:pt x="11666" y="1489"/>
                      <a:pt x="12970" y="2469"/>
                    </a:cubicBezTo>
                  </a:path>
                  <a:path w="12971" h="19741" stroke="0" extrusionOk="0">
                    <a:moveTo>
                      <a:pt x="8766" y="-1"/>
                    </a:moveTo>
                    <a:cubicBezTo>
                      <a:pt x="10256" y="661"/>
                      <a:pt x="11666" y="1489"/>
                      <a:pt x="12970" y="2469"/>
                    </a:cubicBezTo>
                    <a:lnTo>
                      <a:pt x="0" y="19741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Arc 65"/>
              <p:cNvSpPr>
                <a:spLocks/>
              </p:cNvSpPr>
              <p:nvPr/>
            </p:nvSpPr>
            <p:spPr bwMode="auto">
              <a:xfrm>
                <a:off x="1723" y="2385"/>
                <a:ext cx="376" cy="390"/>
              </a:xfrm>
              <a:custGeom>
                <a:avLst/>
                <a:gdLst>
                  <a:gd name="G0" fmla="+- 0 0 0"/>
                  <a:gd name="G1" fmla="+- 17272 0 0"/>
                  <a:gd name="G2" fmla="+- 21600 0 0"/>
                  <a:gd name="T0" fmla="*/ 12971 w 16612"/>
                  <a:gd name="T1" fmla="*/ 0 h 17272"/>
                  <a:gd name="T2" fmla="*/ 16612 w 16612"/>
                  <a:gd name="T3" fmla="*/ 3467 h 17272"/>
                  <a:gd name="T4" fmla="*/ 0 w 16612"/>
                  <a:gd name="T5" fmla="*/ 17272 h 172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612" h="17272" fill="none" extrusionOk="0">
                    <a:moveTo>
                      <a:pt x="12970" y="0"/>
                    </a:moveTo>
                    <a:cubicBezTo>
                      <a:pt x="14315" y="1009"/>
                      <a:pt x="15537" y="2173"/>
                      <a:pt x="16612" y="3466"/>
                    </a:cubicBezTo>
                  </a:path>
                  <a:path w="16612" h="17272" stroke="0" extrusionOk="0">
                    <a:moveTo>
                      <a:pt x="12970" y="0"/>
                    </a:moveTo>
                    <a:cubicBezTo>
                      <a:pt x="14315" y="1009"/>
                      <a:pt x="15537" y="2173"/>
                      <a:pt x="16612" y="3466"/>
                    </a:cubicBezTo>
                    <a:lnTo>
                      <a:pt x="0" y="17272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Line 67"/>
              <p:cNvSpPr>
                <a:spLocks noChangeShapeType="1"/>
              </p:cNvSpPr>
              <p:nvPr/>
            </p:nvSpPr>
            <p:spPr bwMode="auto">
              <a:xfrm>
                <a:off x="2018" y="2383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Rectangle 68"/>
              <p:cNvSpPr>
                <a:spLocks noChangeArrowheads="1"/>
              </p:cNvSpPr>
              <p:nvPr/>
            </p:nvSpPr>
            <p:spPr bwMode="auto">
              <a:xfrm rot="19680000">
                <a:off x="2132" y="2214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D2/Taiwan/21337/2015</a:t>
                </a:r>
              </a:p>
            </p:txBody>
          </p:sp>
          <p:sp>
            <p:nvSpPr>
              <p:cNvPr id="258" name="Line 69"/>
              <p:cNvSpPr>
                <a:spLocks noChangeShapeType="1"/>
              </p:cNvSpPr>
              <p:nvPr/>
            </p:nvSpPr>
            <p:spPr bwMode="auto">
              <a:xfrm flipV="1">
                <a:off x="2136" y="2480"/>
                <a:ext cx="70" cy="4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Rectangle 70"/>
              <p:cNvSpPr>
                <a:spLocks noChangeArrowheads="1"/>
              </p:cNvSpPr>
              <p:nvPr/>
            </p:nvSpPr>
            <p:spPr bwMode="auto">
              <a:xfrm rot="19980000">
                <a:off x="2261" y="2253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8264/2015</a:t>
                </a:r>
              </a:p>
            </p:txBody>
          </p:sp>
          <p:sp>
            <p:nvSpPr>
              <p:cNvPr id="260" name="Line 71"/>
              <p:cNvSpPr>
                <a:spLocks noChangeShapeType="1"/>
              </p:cNvSpPr>
              <p:nvPr/>
            </p:nvSpPr>
            <p:spPr bwMode="auto">
              <a:xfrm>
                <a:off x="2308" y="2485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Rectangle 72"/>
              <p:cNvSpPr>
                <a:spLocks noChangeArrowheads="1"/>
              </p:cNvSpPr>
              <p:nvPr/>
            </p:nvSpPr>
            <p:spPr bwMode="auto">
              <a:xfrm rot="20340000">
                <a:off x="2370" y="2316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8286/2015</a:t>
                </a:r>
              </a:p>
            </p:txBody>
          </p:sp>
          <p:sp>
            <p:nvSpPr>
              <p:cNvPr id="262" name="Line 73"/>
              <p:cNvSpPr>
                <a:spLocks noChangeShapeType="1"/>
              </p:cNvSpPr>
              <p:nvPr/>
            </p:nvSpPr>
            <p:spPr bwMode="auto">
              <a:xfrm flipV="1">
                <a:off x="2329" y="2512"/>
                <a:ext cx="75" cy="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Arc 74"/>
              <p:cNvSpPr>
                <a:spLocks/>
              </p:cNvSpPr>
              <p:nvPr/>
            </p:nvSpPr>
            <p:spPr bwMode="auto">
              <a:xfrm>
                <a:off x="1723" y="2488"/>
                <a:ext cx="596" cy="287"/>
              </a:xfrm>
              <a:custGeom>
                <a:avLst/>
                <a:gdLst>
                  <a:gd name="G0" fmla="+- 0 0 0"/>
                  <a:gd name="G1" fmla="+- 9551 0 0"/>
                  <a:gd name="G2" fmla="+- 21600 0 0"/>
                  <a:gd name="T0" fmla="*/ 19374 w 19812"/>
                  <a:gd name="T1" fmla="*/ 0 h 9551"/>
                  <a:gd name="T2" fmla="*/ 19812 w 19812"/>
                  <a:gd name="T3" fmla="*/ 947 h 9551"/>
                  <a:gd name="T4" fmla="*/ 0 w 19812"/>
                  <a:gd name="T5" fmla="*/ 9551 h 95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812" h="9551" fill="none" extrusionOk="0">
                    <a:moveTo>
                      <a:pt x="19373" y="0"/>
                    </a:moveTo>
                    <a:cubicBezTo>
                      <a:pt x="19527" y="312"/>
                      <a:pt x="19673" y="627"/>
                      <a:pt x="19812" y="946"/>
                    </a:cubicBezTo>
                  </a:path>
                  <a:path w="19812" h="9551" stroke="0" extrusionOk="0">
                    <a:moveTo>
                      <a:pt x="19373" y="0"/>
                    </a:moveTo>
                    <a:cubicBezTo>
                      <a:pt x="19527" y="312"/>
                      <a:pt x="19673" y="627"/>
                      <a:pt x="19812" y="946"/>
                    </a:cubicBezTo>
                    <a:lnTo>
                      <a:pt x="0" y="9551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Arc 75"/>
              <p:cNvSpPr>
                <a:spLocks/>
              </p:cNvSpPr>
              <p:nvPr/>
            </p:nvSpPr>
            <p:spPr bwMode="auto">
              <a:xfrm>
                <a:off x="1723" y="2517"/>
                <a:ext cx="607" cy="258"/>
              </a:xfrm>
              <a:custGeom>
                <a:avLst/>
                <a:gdLst>
                  <a:gd name="G0" fmla="+- 0 0 0"/>
                  <a:gd name="G1" fmla="+- 8604 0 0"/>
                  <a:gd name="G2" fmla="+- 21600 0 0"/>
                  <a:gd name="T0" fmla="*/ 19812 w 20179"/>
                  <a:gd name="T1" fmla="*/ 0 h 8604"/>
                  <a:gd name="T2" fmla="*/ 20179 w 20179"/>
                  <a:gd name="T3" fmla="*/ 900 h 8604"/>
                  <a:gd name="T4" fmla="*/ 0 w 20179"/>
                  <a:gd name="T5" fmla="*/ 8604 h 86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179" h="8604" fill="none" extrusionOk="0">
                    <a:moveTo>
                      <a:pt x="19812" y="-1"/>
                    </a:moveTo>
                    <a:cubicBezTo>
                      <a:pt x="19941" y="297"/>
                      <a:pt x="20063" y="597"/>
                      <a:pt x="20179" y="899"/>
                    </a:cubicBezTo>
                  </a:path>
                  <a:path w="20179" h="8604" stroke="0" extrusionOk="0">
                    <a:moveTo>
                      <a:pt x="19812" y="-1"/>
                    </a:moveTo>
                    <a:cubicBezTo>
                      <a:pt x="19941" y="297"/>
                      <a:pt x="20063" y="597"/>
                      <a:pt x="20179" y="899"/>
                    </a:cubicBezTo>
                    <a:lnTo>
                      <a:pt x="0" y="8604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Rectangle 76"/>
              <p:cNvSpPr>
                <a:spLocks noChangeArrowheads="1"/>
              </p:cNvSpPr>
              <p:nvPr/>
            </p:nvSpPr>
            <p:spPr bwMode="auto">
              <a:xfrm rot="20160000">
                <a:off x="2255" y="2518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5</a:t>
                </a:r>
                <a:endParaRPr kumimoji="0" lang="zh-TW" altLang="zh-TW" sz="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6" name="Line 77"/>
              <p:cNvSpPr>
                <a:spLocks noChangeShapeType="1"/>
              </p:cNvSpPr>
              <p:nvPr/>
            </p:nvSpPr>
            <p:spPr bwMode="auto">
              <a:xfrm flipV="1">
                <a:off x="2168" y="2517"/>
                <a:ext cx="150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Arc 78"/>
              <p:cNvSpPr>
                <a:spLocks/>
              </p:cNvSpPr>
              <p:nvPr/>
            </p:nvSpPr>
            <p:spPr bwMode="auto">
              <a:xfrm>
                <a:off x="1723" y="2521"/>
                <a:ext cx="433" cy="254"/>
              </a:xfrm>
              <a:custGeom>
                <a:avLst/>
                <a:gdLst>
                  <a:gd name="G0" fmla="+- 0 0 0"/>
                  <a:gd name="G1" fmla="+- 11267 0 0"/>
                  <a:gd name="G2" fmla="+- 21600 0 0"/>
                  <a:gd name="T0" fmla="*/ 18428 w 19150"/>
                  <a:gd name="T1" fmla="*/ 0 h 11267"/>
                  <a:gd name="T2" fmla="*/ 19150 w 19150"/>
                  <a:gd name="T3" fmla="*/ 1275 h 11267"/>
                  <a:gd name="T4" fmla="*/ 0 w 19150"/>
                  <a:gd name="T5" fmla="*/ 11267 h 112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150" h="11267" fill="none" extrusionOk="0">
                    <a:moveTo>
                      <a:pt x="18428" y="-1"/>
                    </a:moveTo>
                    <a:cubicBezTo>
                      <a:pt x="18683" y="416"/>
                      <a:pt x="18923" y="841"/>
                      <a:pt x="19149" y="1275"/>
                    </a:cubicBezTo>
                  </a:path>
                  <a:path w="19150" h="11267" stroke="0" extrusionOk="0">
                    <a:moveTo>
                      <a:pt x="18428" y="-1"/>
                    </a:moveTo>
                    <a:cubicBezTo>
                      <a:pt x="18683" y="416"/>
                      <a:pt x="18923" y="841"/>
                      <a:pt x="19149" y="1275"/>
                    </a:cubicBezTo>
                    <a:lnTo>
                      <a:pt x="0" y="11267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Arc 79"/>
              <p:cNvSpPr>
                <a:spLocks/>
              </p:cNvSpPr>
              <p:nvPr/>
            </p:nvSpPr>
            <p:spPr bwMode="auto">
              <a:xfrm>
                <a:off x="1723" y="2549"/>
                <a:ext cx="448" cy="226"/>
              </a:xfrm>
              <a:custGeom>
                <a:avLst/>
                <a:gdLst>
                  <a:gd name="G0" fmla="+- 0 0 0"/>
                  <a:gd name="G1" fmla="+- 9992 0 0"/>
                  <a:gd name="G2" fmla="+- 21600 0 0"/>
                  <a:gd name="T0" fmla="*/ 19150 w 19794"/>
                  <a:gd name="T1" fmla="*/ 0 h 9992"/>
                  <a:gd name="T2" fmla="*/ 19794 w 19794"/>
                  <a:gd name="T3" fmla="*/ 1345 h 9992"/>
                  <a:gd name="T4" fmla="*/ 0 w 19794"/>
                  <a:gd name="T5" fmla="*/ 9992 h 99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794" h="9992" fill="none" extrusionOk="0">
                    <a:moveTo>
                      <a:pt x="19149" y="0"/>
                    </a:moveTo>
                    <a:cubicBezTo>
                      <a:pt x="19379" y="440"/>
                      <a:pt x="19594" y="889"/>
                      <a:pt x="19793" y="1345"/>
                    </a:cubicBezTo>
                  </a:path>
                  <a:path w="19794" h="9992" stroke="0" extrusionOk="0">
                    <a:moveTo>
                      <a:pt x="19149" y="0"/>
                    </a:moveTo>
                    <a:cubicBezTo>
                      <a:pt x="19379" y="440"/>
                      <a:pt x="19594" y="889"/>
                      <a:pt x="19793" y="1345"/>
                    </a:cubicBezTo>
                    <a:lnTo>
                      <a:pt x="0" y="9992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Line 81"/>
              <p:cNvSpPr>
                <a:spLocks noChangeShapeType="1"/>
              </p:cNvSpPr>
              <p:nvPr/>
            </p:nvSpPr>
            <p:spPr bwMode="auto">
              <a:xfrm>
                <a:off x="2157" y="2549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Arc 82"/>
              <p:cNvSpPr>
                <a:spLocks/>
              </p:cNvSpPr>
              <p:nvPr/>
            </p:nvSpPr>
            <p:spPr bwMode="auto">
              <a:xfrm>
                <a:off x="1723" y="2385"/>
                <a:ext cx="371" cy="390"/>
              </a:xfrm>
              <a:custGeom>
                <a:avLst/>
                <a:gdLst>
                  <a:gd name="G0" fmla="+- 0 0 0"/>
                  <a:gd name="G1" fmla="+- 17272 0 0"/>
                  <a:gd name="G2" fmla="+- 21600 0 0"/>
                  <a:gd name="T0" fmla="*/ 12971 w 16389"/>
                  <a:gd name="T1" fmla="*/ 0 h 17272"/>
                  <a:gd name="T2" fmla="*/ 16389 w 16389"/>
                  <a:gd name="T3" fmla="*/ 3202 h 17272"/>
                  <a:gd name="T4" fmla="*/ 0 w 16389"/>
                  <a:gd name="T5" fmla="*/ 17272 h 172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389" h="17272" fill="none" extrusionOk="0">
                    <a:moveTo>
                      <a:pt x="12970" y="0"/>
                    </a:moveTo>
                    <a:cubicBezTo>
                      <a:pt x="14222" y="940"/>
                      <a:pt x="15368" y="2014"/>
                      <a:pt x="16388" y="3202"/>
                    </a:cubicBezTo>
                  </a:path>
                  <a:path w="16389" h="17272" stroke="0" extrusionOk="0">
                    <a:moveTo>
                      <a:pt x="12970" y="0"/>
                    </a:moveTo>
                    <a:cubicBezTo>
                      <a:pt x="14222" y="940"/>
                      <a:pt x="15368" y="2014"/>
                      <a:pt x="16388" y="3202"/>
                    </a:cubicBezTo>
                    <a:lnTo>
                      <a:pt x="0" y="17272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Arc 83"/>
              <p:cNvSpPr>
                <a:spLocks/>
              </p:cNvSpPr>
              <p:nvPr/>
            </p:nvSpPr>
            <p:spPr bwMode="auto">
              <a:xfrm>
                <a:off x="1723" y="2457"/>
                <a:ext cx="433" cy="318"/>
              </a:xfrm>
              <a:custGeom>
                <a:avLst/>
                <a:gdLst>
                  <a:gd name="G0" fmla="+- 0 0 0"/>
                  <a:gd name="G1" fmla="+- 14070 0 0"/>
                  <a:gd name="G2" fmla="+- 21600 0 0"/>
                  <a:gd name="T0" fmla="*/ 16389 w 19150"/>
                  <a:gd name="T1" fmla="*/ 0 h 14070"/>
                  <a:gd name="T2" fmla="*/ 19150 w 19150"/>
                  <a:gd name="T3" fmla="*/ 4078 h 14070"/>
                  <a:gd name="T4" fmla="*/ 0 w 19150"/>
                  <a:gd name="T5" fmla="*/ 14070 h 140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150" h="14070" fill="none" extrusionOk="0">
                    <a:moveTo>
                      <a:pt x="16388" y="0"/>
                    </a:moveTo>
                    <a:cubicBezTo>
                      <a:pt x="17461" y="1249"/>
                      <a:pt x="18388" y="2617"/>
                      <a:pt x="19149" y="4078"/>
                    </a:cubicBezTo>
                  </a:path>
                  <a:path w="19150" h="14070" stroke="0" extrusionOk="0">
                    <a:moveTo>
                      <a:pt x="16388" y="0"/>
                    </a:moveTo>
                    <a:cubicBezTo>
                      <a:pt x="17461" y="1249"/>
                      <a:pt x="18388" y="2617"/>
                      <a:pt x="19149" y="4078"/>
                    </a:cubicBezTo>
                    <a:lnTo>
                      <a:pt x="0" y="1407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Line 85"/>
              <p:cNvSpPr>
                <a:spLocks noChangeShapeType="1"/>
              </p:cNvSpPr>
              <p:nvPr/>
            </p:nvSpPr>
            <p:spPr bwMode="auto">
              <a:xfrm>
                <a:off x="2093" y="2458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Rectangle 86"/>
              <p:cNvSpPr>
                <a:spLocks noChangeArrowheads="1"/>
              </p:cNvSpPr>
              <p:nvPr/>
            </p:nvSpPr>
            <p:spPr bwMode="auto">
              <a:xfrm rot="20640000">
                <a:off x="2403" y="2412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6747/2015</a:t>
                </a:r>
              </a:p>
            </p:txBody>
          </p:sp>
          <p:sp>
            <p:nvSpPr>
              <p:cNvPr id="276" name="Line 87"/>
              <p:cNvSpPr>
                <a:spLocks noChangeShapeType="1"/>
              </p:cNvSpPr>
              <p:nvPr/>
            </p:nvSpPr>
            <p:spPr bwMode="auto">
              <a:xfrm flipV="1">
                <a:off x="2351" y="2576"/>
                <a:ext cx="75" cy="2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Rectangle 88"/>
              <p:cNvSpPr>
                <a:spLocks noChangeArrowheads="1"/>
              </p:cNvSpPr>
              <p:nvPr/>
            </p:nvSpPr>
            <p:spPr bwMode="auto">
              <a:xfrm rot="20940000">
                <a:off x="2353" y="2528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8319/2015</a:t>
                </a:r>
              </a:p>
            </p:txBody>
          </p:sp>
          <p:sp>
            <p:nvSpPr>
              <p:cNvPr id="278" name="Line 89"/>
              <p:cNvSpPr>
                <a:spLocks noChangeShapeType="1"/>
              </p:cNvSpPr>
              <p:nvPr/>
            </p:nvSpPr>
            <p:spPr bwMode="auto">
              <a:xfrm>
                <a:off x="2361" y="2657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Arc 90"/>
              <p:cNvSpPr>
                <a:spLocks/>
              </p:cNvSpPr>
              <p:nvPr/>
            </p:nvSpPr>
            <p:spPr bwMode="auto">
              <a:xfrm>
                <a:off x="1723" y="2599"/>
                <a:ext cx="633" cy="176"/>
              </a:xfrm>
              <a:custGeom>
                <a:avLst/>
                <a:gdLst>
                  <a:gd name="G0" fmla="+- 0 0 0"/>
                  <a:gd name="G1" fmla="+- 5868 0 0"/>
                  <a:gd name="G2" fmla="+- 21600 0 0"/>
                  <a:gd name="T0" fmla="*/ 20788 w 21053"/>
                  <a:gd name="T1" fmla="*/ 0 h 5868"/>
                  <a:gd name="T2" fmla="*/ 21053 w 21053"/>
                  <a:gd name="T3" fmla="*/ 1038 h 5868"/>
                  <a:gd name="T4" fmla="*/ 0 w 21053"/>
                  <a:gd name="T5" fmla="*/ 5868 h 58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053" h="5868" fill="none" extrusionOk="0">
                    <a:moveTo>
                      <a:pt x="20787" y="0"/>
                    </a:moveTo>
                    <a:cubicBezTo>
                      <a:pt x="20884" y="343"/>
                      <a:pt x="20973" y="689"/>
                      <a:pt x="21053" y="1037"/>
                    </a:cubicBezTo>
                  </a:path>
                  <a:path w="21053" h="5868" stroke="0" extrusionOk="0">
                    <a:moveTo>
                      <a:pt x="20787" y="0"/>
                    </a:moveTo>
                    <a:cubicBezTo>
                      <a:pt x="20884" y="343"/>
                      <a:pt x="20973" y="689"/>
                      <a:pt x="21053" y="1037"/>
                    </a:cubicBezTo>
                    <a:lnTo>
                      <a:pt x="0" y="5868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" name="Arc 91"/>
              <p:cNvSpPr>
                <a:spLocks/>
              </p:cNvSpPr>
              <p:nvPr/>
            </p:nvSpPr>
            <p:spPr bwMode="auto">
              <a:xfrm>
                <a:off x="1723" y="2630"/>
                <a:ext cx="639" cy="145"/>
              </a:xfrm>
              <a:custGeom>
                <a:avLst/>
                <a:gdLst>
                  <a:gd name="G0" fmla="+- 0 0 0"/>
                  <a:gd name="G1" fmla="+- 4830 0 0"/>
                  <a:gd name="G2" fmla="+- 21600 0 0"/>
                  <a:gd name="T0" fmla="*/ 21053 w 21239"/>
                  <a:gd name="T1" fmla="*/ 0 h 4830"/>
                  <a:gd name="T2" fmla="*/ 21239 w 21239"/>
                  <a:gd name="T3" fmla="*/ 896 h 4830"/>
                  <a:gd name="T4" fmla="*/ 0 w 21239"/>
                  <a:gd name="T5" fmla="*/ 4830 h 48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239" h="4830" fill="none" extrusionOk="0">
                    <a:moveTo>
                      <a:pt x="21053" y="-1"/>
                    </a:moveTo>
                    <a:cubicBezTo>
                      <a:pt x="21121" y="297"/>
                      <a:pt x="21183" y="596"/>
                      <a:pt x="21238" y="896"/>
                    </a:cubicBezTo>
                  </a:path>
                  <a:path w="21239" h="4830" stroke="0" extrusionOk="0">
                    <a:moveTo>
                      <a:pt x="21053" y="-1"/>
                    </a:moveTo>
                    <a:cubicBezTo>
                      <a:pt x="21121" y="297"/>
                      <a:pt x="21183" y="596"/>
                      <a:pt x="21238" y="896"/>
                    </a:cubicBezTo>
                    <a:lnTo>
                      <a:pt x="0" y="483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Rectangle 92"/>
              <p:cNvSpPr>
                <a:spLocks noChangeArrowheads="1"/>
              </p:cNvSpPr>
              <p:nvPr/>
            </p:nvSpPr>
            <p:spPr bwMode="auto">
              <a:xfrm rot="20820000">
                <a:off x="2286" y="2629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7</a:t>
                </a:r>
                <a:endParaRPr kumimoji="0" lang="zh-TW" altLang="zh-TW" sz="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2" name="Line 93"/>
              <p:cNvSpPr>
                <a:spLocks noChangeShapeType="1"/>
              </p:cNvSpPr>
              <p:nvPr/>
            </p:nvSpPr>
            <p:spPr bwMode="auto">
              <a:xfrm flipV="1">
                <a:off x="2200" y="2630"/>
                <a:ext cx="156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Arc 94"/>
              <p:cNvSpPr>
                <a:spLocks/>
              </p:cNvSpPr>
              <p:nvPr/>
            </p:nvSpPr>
            <p:spPr bwMode="auto">
              <a:xfrm>
                <a:off x="1723" y="2457"/>
                <a:ext cx="436" cy="318"/>
              </a:xfrm>
              <a:custGeom>
                <a:avLst/>
                <a:gdLst>
                  <a:gd name="G0" fmla="+- 0 0 0"/>
                  <a:gd name="G1" fmla="+- 14070 0 0"/>
                  <a:gd name="G2" fmla="+- 21600 0 0"/>
                  <a:gd name="T0" fmla="*/ 16389 w 19258"/>
                  <a:gd name="T1" fmla="*/ 0 h 14070"/>
                  <a:gd name="T2" fmla="*/ 19258 w 19258"/>
                  <a:gd name="T3" fmla="*/ 4288 h 14070"/>
                  <a:gd name="T4" fmla="*/ 0 w 19258"/>
                  <a:gd name="T5" fmla="*/ 14070 h 140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258" h="14070" fill="none" extrusionOk="0">
                    <a:moveTo>
                      <a:pt x="16388" y="0"/>
                    </a:moveTo>
                    <a:cubicBezTo>
                      <a:pt x="17513" y="1309"/>
                      <a:pt x="18476" y="2749"/>
                      <a:pt x="19258" y="4287"/>
                    </a:cubicBezTo>
                  </a:path>
                  <a:path w="19258" h="14070" stroke="0" extrusionOk="0">
                    <a:moveTo>
                      <a:pt x="16388" y="0"/>
                    </a:moveTo>
                    <a:cubicBezTo>
                      <a:pt x="17513" y="1309"/>
                      <a:pt x="18476" y="2749"/>
                      <a:pt x="19258" y="4287"/>
                    </a:cubicBezTo>
                    <a:lnTo>
                      <a:pt x="0" y="1407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" name="Arc 95"/>
              <p:cNvSpPr>
                <a:spLocks/>
              </p:cNvSpPr>
              <p:nvPr/>
            </p:nvSpPr>
            <p:spPr bwMode="auto">
              <a:xfrm>
                <a:off x="1723" y="2554"/>
                <a:ext cx="476" cy="221"/>
              </a:xfrm>
              <a:custGeom>
                <a:avLst/>
                <a:gdLst>
                  <a:gd name="G0" fmla="+- 0 0 0"/>
                  <a:gd name="G1" fmla="+- 9782 0 0"/>
                  <a:gd name="G2" fmla="+- 21600 0 0"/>
                  <a:gd name="T0" fmla="*/ 19258 w 21065"/>
                  <a:gd name="T1" fmla="*/ 0 h 9782"/>
                  <a:gd name="T2" fmla="*/ 21065 w 21065"/>
                  <a:gd name="T3" fmla="*/ 5003 h 9782"/>
                  <a:gd name="T4" fmla="*/ 0 w 21065"/>
                  <a:gd name="T5" fmla="*/ 9782 h 97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065" h="9782" fill="none" extrusionOk="0">
                    <a:moveTo>
                      <a:pt x="19258" y="-1"/>
                    </a:moveTo>
                    <a:cubicBezTo>
                      <a:pt x="20064" y="1586"/>
                      <a:pt x="20670" y="3267"/>
                      <a:pt x="21064" y="5003"/>
                    </a:cubicBezTo>
                  </a:path>
                  <a:path w="21065" h="9782" stroke="0" extrusionOk="0">
                    <a:moveTo>
                      <a:pt x="19258" y="-1"/>
                    </a:moveTo>
                    <a:cubicBezTo>
                      <a:pt x="20064" y="1586"/>
                      <a:pt x="20670" y="3267"/>
                      <a:pt x="21064" y="5003"/>
                    </a:cubicBezTo>
                    <a:lnTo>
                      <a:pt x="0" y="9782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" name="Line 97"/>
              <p:cNvSpPr>
                <a:spLocks noChangeShapeType="1"/>
              </p:cNvSpPr>
              <p:nvPr/>
            </p:nvSpPr>
            <p:spPr bwMode="auto">
              <a:xfrm>
                <a:off x="2157" y="2555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" name="Rectangle 98"/>
              <p:cNvSpPr>
                <a:spLocks noChangeArrowheads="1"/>
              </p:cNvSpPr>
              <p:nvPr/>
            </p:nvSpPr>
            <p:spPr bwMode="auto">
              <a:xfrm rot="21300000">
                <a:off x="2284" y="2650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D2/Taiwan/21389/2015</a:t>
                </a:r>
              </a:p>
            </p:txBody>
          </p:sp>
          <p:sp>
            <p:nvSpPr>
              <p:cNvPr id="288" name="Line 99"/>
              <p:cNvSpPr>
                <a:spLocks noChangeShapeType="1"/>
              </p:cNvSpPr>
              <p:nvPr/>
            </p:nvSpPr>
            <p:spPr bwMode="auto">
              <a:xfrm flipV="1">
                <a:off x="2206" y="2726"/>
                <a:ext cx="80" cy="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Arc 100"/>
              <p:cNvSpPr>
                <a:spLocks/>
              </p:cNvSpPr>
              <p:nvPr/>
            </p:nvSpPr>
            <p:spPr bwMode="auto">
              <a:xfrm>
                <a:off x="1723" y="2554"/>
                <a:ext cx="470" cy="221"/>
              </a:xfrm>
              <a:custGeom>
                <a:avLst/>
                <a:gdLst>
                  <a:gd name="G0" fmla="+- 0 0 0"/>
                  <a:gd name="G1" fmla="+- 9782 0 0"/>
                  <a:gd name="G2" fmla="+- 21600 0 0"/>
                  <a:gd name="T0" fmla="*/ 19258 w 20764"/>
                  <a:gd name="T1" fmla="*/ 0 h 9782"/>
                  <a:gd name="T2" fmla="*/ 20764 w 20764"/>
                  <a:gd name="T3" fmla="*/ 3831 h 9782"/>
                  <a:gd name="T4" fmla="*/ 0 w 20764"/>
                  <a:gd name="T5" fmla="*/ 9782 h 97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764" h="9782" fill="none" extrusionOk="0">
                    <a:moveTo>
                      <a:pt x="19258" y="-1"/>
                    </a:moveTo>
                    <a:cubicBezTo>
                      <a:pt x="19880" y="1226"/>
                      <a:pt x="20385" y="2508"/>
                      <a:pt x="20764" y="3830"/>
                    </a:cubicBezTo>
                  </a:path>
                  <a:path w="20764" h="9782" stroke="0" extrusionOk="0">
                    <a:moveTo>
                      <a:pt x="19258" y="-1"/>
                    </a:moveTo>
                    <a:cubicBezTo>
                      <a:pt x="19880" y="1226"/>
                      <a:pt x="20385" y="2508"/>
                      <a:pt x="20764" y="3830"/>
                    </a:cubicBezTo>
                    <a:lnTo>
                      <a:pt x="0" y="9782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Arc 101"/>
              <p:cNvSpPr>
                <a:spLocks/>
              </p:cNvSpPr>
              <p:nvPr/>
            </p:nvSpPr>
            <p:spPr bwMode="auto">
              <a:xfrm>
                <a:off x="1723" y="2641"/>
                <a:ext cx="487" cy="134"/>
              </a:xfrm>
              <a:custGeom>
                <a:avLst/>
                <a:gdLst>
                  <a:gd name="G0" fmla="+- 0 0 0"/>
                  <a:gd name="G1" fmla="+- 5951 0 0"/>
                  <a:gd name="G2" fmla="+- 21600 0 0"/>
                  <a:gd name="T0" fmla="*/ 20764 w 21516"/>
                  <a:gd name="T1" fmla="*/ 0 h 5951"/>
                  <a:gd name="T2" fmla="*/ 21516 w 21516"/>
                  <a:gd name="T3" fmla="*/ 4051 h 5951"/>
                  <a:gd name="T4" fmla="*/ 0 w 21516"/>
                  <a:gd name="T5" fmla="*/ 5951 h 59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516" h="5951" fill="none" extrusionOk="0">
                    <a:moveTo>
                      <a:pt x="20764" y="-1"/>
                    </a:moveTo>
                    <a:cubicBezTo>
                      <a:pt x="21143" y="1323"/>
                      <a:pt x="21395" y="2679"/>
                      <a:pt x="21516" y="4050"/>
                    </a:cubicBezTo>
                  </a:path>
                  <a:path w="21516" h="5951" stroke="0" extrusionOk="0">
                    <a:moveTo>
                      <a:pt x="20764" y="-1"/>
                    </a:moveTo>
                    <a:cubicBezTo>
                      <a:pt x="21143" y="1323"/>
                      <a:pt x="21395" y="2679"/>
                      <a:pt x="21516" y="4050"/>
                    </a:cubicBezTo>
                    <a:lnTo>
                      <a:pt x="0" y="5951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Line 103"/>
              <p:cNvSpPr>
                <a:spLocks noChangeShapeType="1"/>
              </p:cNvSpPr>
              <p:nvPr/>
            </p:nvSpPr>
            <p:spPr bwMode="auto">
              <a:xfrm>
                <a:off x="2190" y="2640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Rectangle 104"/>
              <p:cNvSpPr>
                <a:spLocks noChangeArrowheads="1"/>
              </p:cNvSpPr>
              <p:nvPr/>
            </p:nvSpPr>
            <p:spPr bwMode="auto">
              <a:xfrm>
                <a:off x="2305" y="2739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7582/2015</a:t>
                </a:r>
              </a:p>
            </p:txBody>
          </p:sp>
          <p:sp>
            <p:nvSpPr>
              <p:cNvPr id="294" name="Line 105"/>
              <p:cNvSpPr>
                <a:spLocks noChangeShapeType="1"/>
              </p:cNvSpPr>
              <p:nvPr/>
            </p:nvSpPr>
            <p:spPr bwMode="auto">
              <a:xfrm>
                <a:off x="2211" y="2780"/>
                <a:ext cx="81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" name="Rectangle 106"/>
              <p:cNvSpPr>
                <a:spLocks noChangeArrowheads="1"/>
              </p:cNvSpPr>
              <p:nvPr/>
            </p:nvSpPr>
            <p:spPr bwMode="auto">
              <a:xfrm rot="300000">
                <a:off x="2439" y="2841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33612/2015</a:t>
                </a:r>
              </a:p>
            </p:txBody>
          </p:sp>
          <p:sp>
            <p:nvSpPr>
              <p:cNvPr id="296" name="Line 107"/>
              <p:cNvSpPr>
                <a:spLocks noChangeShapeType="1"/>
              </p:cNvSpPr>
              <p:nvPr/>
            </p:nvSpPr>
            <p:spPr bwMode="auto">
              <a:xfrm>
                <a:off x="2206" y="2823"/>
                <a:ext cx="241" cy="2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Arc 108"/>
              <p:cNvSpPr>
                <a:spLocks/>
              </p:cNvSpPr>
              <p:nvPr/>
            </p:nvSpPr>
            <p:spPr bwMode="auto">
              <a:xfrm>
                <a:off x="1723" y="2774"/>
                <a:ext cx="489" cy="27"/>
              </a:xfrm>
              <a:custGeom>
                <a:avLst/>
                <a:gdLst>
                  <a:gd name="G0" fmla="+- 0 0 0"/>
                  <a:gd name="G1" fmla="+- 44 0 0"/>
                  <a:gd name="G2" fmla="+- 21600 0 0"/>
                  <a:gd name="T0" fmla="*/ 21600 w 21600"/>
                  <a:gd name="T1" fmla="*/ 0 h 1196"/>
                  <a:gd name="T2" fmla="*/ 21569 w 21600"/>
                  <a:gd name="T3" fmla="*/ 1196 h 1196"/>
                  <a:gd name="T4" fmla="*/ 0 w 21600"/>
                  <a:gd name="T5" fmla="*/ 44 h 11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600" h="1196" fill="none" extrusionOk="0">
                    <a:moveTo>
                      <a:pt x="21599" y="0"/>
                    </a:moveTo>
                    <a:cubicBezTo>
                      <a:pt x="21599" y="14"/>
                      <a:pt x="21600" y="29"/>
                      <a:pt x="21600" y="44"/>
                    </a:cubicBezTo>
                    <a:cubicBezTo>
                      <a:pt x="21600" y="428"/>
                      <a:pt x="21589" y="812"/>
                      <a:pt x="21569" y="1196"/>
                    </a:cubicBezTo>
                  </a:path>
                  <a:path w="21600" h="1196" stroke="0" extrusionOk="0">
                    <a:moveTo>
                      <a:pt x="21599" y="0"/>
                    </a:moveTo>
                    <a:cubicBezTo>
                      <a:pt x="21599" y="14"/>
                      <a:pt x="21600" y="29"/>
                      <a:pt x="21600" y="44"/>
                    </a:cubicBezTo>
                    <a:cubicBezTo>
                      <a:pt x="21600" y="428"/>
                      <a:pt x="21589" y="812"/>
                      <a:pt x="21569" y="1196"/>
                    </a:cubicBezTo>
                    <a:lnTo>
                      <a:pt x="0" y="44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Arc 109"/>
              <p:cNvSpPr>
                <a:spLocks/>
              </p:cNvSpPr>
              <p:nvPr/>
            </p:nvSpPr>
            <p:spPr bwMode="auto">
              <a:xfrm>
                <a:off x="1723" y="2775"/>
                <a:ext cx="488" cy="48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21569 w 21569"/>
                  <a:gd name="T1" fmla="*/ 1152 h 2119"/>
                  <a:gd name="T2" fmla="*/ 21496 w 21569"/>
                  <a:gd name="T3" fmla="*/ 2119 h 2119"/>
                  <a:gd name="T4" fmla="*/ 0 w 21569"/>
                  <a:gd name="T5" fmla="*/ 0 h 21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569" h="2119" fill="none" extrusionOk="0">
                    <a:moveTo>
                      <a:pt x="21569" y="1152"/>
                    </a:moveTo>
                    <a:cubicBezTo>
                      <a:pt x="21552" y="1474"/>
                      <a:pt x="21527" y="1797"/>
                      <a:pt x="21495" y="2118"/>
                    </a:cubicBezTo>
                  </a:path>
                  <a:path w="21569" h="2119" stroke="0" extrusionOk="0">
                    <a:moveTo>
                      <a:pt x="21569" y="1152"/>
                    </a:moveTo>
                    <a:cubicBezTo>
                      <a:pt x="21552" y="1474"/>
                      <a:pt x="21527" y="1797"/>
                      <a:pt x="21495" y="2118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Line 111"/>
              <p:cNvSpPr>
                <a:spLocks noChangeShapeType="1"/>
              </p:cNvSpPr>
              <p:nvPr/>
            </p:nvSpPr>
            <p:spPr bwMode="auto">
              <a:xfrm>
                <a:off x="2211" y="2801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Rectangle 112"/>
              <p:cNvSpPr>
                <a:spLocks noChangeArrowheads="1"/>
              </p:cNvSpPr>
              <p:nvPr/>
            </p:nvSpPr>
            <p:spPr bwMode="auto">
              <a:xfrm rot="600000">
                <a:off x="2195" y="2899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7379/2015</a:t>
                </a:r>
              </a:p>
            </p:txBody>
          </p:sp>
          <p:sp>
            <p:nvSpPr>
              <p:cNvPr id="302" name="Line 113"/>
              <p:cNvSpPr>
                <a:spLocks noChangeShapeType="1"/>
              </p:cNvSpPr>
              <p:nvPr/>
            </p:nvSpPr>
            <p:spPr bwMode="auto">
              <a:xfrm>
                <a:off x="2200" y="2866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Rectangle 114"/>
              <p:cNvSpPr>
                <a:spLocks noChangeArrowheads="1"/>
              </p:cNvSpPr>
              <p:nvPr/>
            </p:nvSpPr>
            <p:spPr bwMode="auto">
              <a:xfrm rot="960000">
                <a:off x="2477" y="3062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7881/2015</a:t>
                </a:r>
              </a:p>
            </p:txBody>
          </p:sp>
          <p:sp>
            <p:nvSpPr>
              <p:cNvPr id="304" name="Line 115"/>
              <p:cNvSpPr>
                <a:spLocks noChangeShapeType="1"/>
              </p:cNvSpPr>
              <p:nvPr/>
            </p:nvSpPr>
            <p:spPr bwMode="auto">
              <a:xfrm>
                <a:off x="2345" y="2957"/>
                <a:ext cx="156" cy="4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" name="Rectangle 116"/>
              <p:cNvSpPr>
                <a:spLocks noChangeArrowheads="1"/>
              </p:cNvSpPr>
              <p:nvPr/>
            </p:nvSpPr>
            <p:spPr bwMode="auto">
              <a:xfrm rot="1260000">
                <a:off x="2296" y="3114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8409/2015</a:t>
                </a:r>
              </a:p>
            </p:txBody>
          </p:sp>
          <p:sp>
            <p:nvSpPr>
              <p:cNvPr id="306" name="Line 117"/>
              <p:cNvSpPr>
                <a:spLocks noChangeShapeType="1"/>
              </p:cNvSpPr>
              <p:nvPr/>
            </p:nvSpPr>
            <p:spPr bwMode="auto">
              <a:xfrm>
                <a:off x="2324" y="3010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" name="Arc 118"/>
              <p:cNvSpPr>
                <a:spLocks/>
              </p:cNvSpPr>
              <p:nvPr/>
            </p:nvSpPr>
            <p:spPr bwMode="auto">
              <a:xfrm>
                <a:off x="1723" y="2775"/>
                <a:ext cx="623" cy="209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20728 w 20728"/>
                  <a:gd name="T1" fmla="*/ 6075 h 6971"/>
                  <a:gd name="T2" fmla="*/ 20444 w 20728"/>
                  <a:gd name="T3" fmla="*/ 6971 h 6971"/>
                  <a:gd name="T4" fmla="*/ 0 w 20728"/>
                  <a:gd name="T5" fmla="*/ 0 h 69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728" h="6971" fill="none" extrusionOk="0">
                    <a:moveTo>
                      <a:pt x="20728" y="6075"/>
                    </a:moveTo>
                    <a:cubicBezTo>
                      <a:pt x="20639" y="6375"/>
                      <a:pt x="20545" y="6674"/>
                      <a:pt x="20444" y="6971"/>
                    </a:cubicBezTo>
                  </a:path>
                  <a:path w="20728" h="6971" stroke="0" extrusionOk="0">
                    <a:moveTo>
                      <a:pt x="20728" y="6075"/>
                    </a:moveTo>
                    <a:cubicBezTo>
                      <a:pt x="20639" y="6375"/>
                      <a:pt x="20545" y="6674"/>
                      <a:pt x="20444" y="6971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Arc 119"/>
              <p:cNvSpPr>
                <a:spLocks/>
              </p:cNvSpPr>
              <p:nvPr/>
            </p:nvSpPr>
            <p:spPr bwMode="auto">
              <a:xfrm>
                <a:off x="1723" y="2775"/>
                <a:ext cx="615" cy="236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20444 w 20444"/>
                  <a:gd name="T1" fmla="*/ 6971 h 7876"/>
                  <a:gd name="T2" fmla="*/ 20113 w 20444"/>
                  <a:gd name="T3" fmla="*/ 7876 h 7876"/>
                  <a:gd name="T4" fmla="*/ 0 w 20444"/>
                  <a:gd name="T5" fmla="*/ 0 h 78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444" h="7876" fill="none" extrusionOk="0">
                    <a:moveTo>
                      <a:pt x="20444" y="6971"/>
                    </a:moveTo>
                    <a:cubicBezTo>
                      <a:pt x="20340" y="7275"/>
                      <a:pt x="20230" y="7576"/>
                      <a:pt x="20112" y="7875"/>
                    </a:cubicBezTo>
                  </a:path>
                  <a:path w="20444" h="7876" stroke="0" extrusionOk="0">
                    <a:moveTo>
                      <a:pt x="20444" y="6971"/>
                    </a:moveTo>
                    <a:cubicBezTo>
                      <a:pt x="20340" y="7275"/>
                      <a:pt x="20230" y="7576"/>
                      <a:pt x="20112" y="7875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Rectangle 120"/>
              <p:cNvSpPr>
                <a:spLocks noChangeArrowheads="1"/>
              </p:cNvSpPr>
              <p:nvPr/>
            </p:nvSpPr>
            <p:spPr bwMode="auto">
              <a:xfrm rot="1080000">
                <a:off x="2255" y="2959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5</a:t>
                </a:r>
                <a:endParaRPr kumimoji="0" lang="zh-TW" altLang="zh-TW" sz="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0" name="Line 121"/>
              <p:cNvSpPr>
                <a:spLocks noChangeShapeType="1"/>
              </p:cNvSpPr>
              <p:nvPr/>
            </p:nvSpPr>
            <p:spPr bwMode="auto">
              <a:xfrm>
                <a:off x="2184" y="2935"/>
                <a:ext cx="150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Arc 122"/>
              <p:cNvSpPr>
                <a:spLocks/>
              </p:cNvSpPr>
              <p:nvPr/>
            </p:nvSpPr>
            <p:spPr bwMode="auto">
              <a:xfrm>
                <a:off x="1723" y="2775"/>
                <a:ext cx="480" cy="123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21216 w 21216"/>
                  <a:gd name="T1" fmla="*/ 4056 h 5457"/>
                  <a:gd name="T2" fmla="*/ 20899 w 21216"/>
                  <a:gd name="T3" fmla="*/ 5457 h 5457"/>
                  <a:gd name="T4" fmla="*/ 0 w 21216"/>
                  <a:gd name="T5" fmla="*/ 0 h 54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216" h="5457" fill="none" extrusionOk="0">
                    <a:moveTo>
                      <a:pt x="21215" y="4055"/>
                    </a:moveTo>
                    <a:cubicBezTo>
                      <a:pt x="21125" y="4526"/>
                      <a:pt x="21020" y="4993"/>
                      <a:pt x="20899" y="5457"/>
                    </a:cubicBezTo>
                  </a:path>
                  <a:path w="21216" h="5457" stroke="0" extrusionOk="0">
                    <a:moveTo>
                      <a:pt x="21215" y="4055"/>
                    </a:moveTo>
                    <a:cubicBezTo>
                      <a:pt x="21125" y="4526"/>
                      <a:pt x="21020" y="4993"/>
                      <a:pt x="20899" y="5457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" name="Arc 123"/>
              <p:cNvSpPr>
                <a:spLocks/>
              </p:cNvSpPr>
              <p:nvPr/>
            </p:nvSpPr>
            <p:spPr bwMode="auto">
              <a:xfrm>
                <a:off x="1723" y="2775"/>
                <a:ext cx="473" cy="157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20899 w 20899"/>
                  <a:gd name="T1" fmla="*/ 5457 h 6964"/>
                  <a:gd name="T2" fmla="*/ 20446 w 20899"/>
                  <a:gd name="T3" fmla="*/ 6964 h 6964"/>
                  <a:gd name="T4" fmla="*/ 0 w 20899"/>
                  <a:gd name="T5" fmla="*/ 0 h 69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899" h="6964" fill="none" extrusionOk="0">
                    <a:moveTo>
                      <a:pt x="20899" y="5457"/>
                    </a:moveTo>
                    <a:cubicBezTo>
                      <a:pt x="20766" y="5964"/>
                      <a:pt x="20615" y="6467"/>
                      <a:pt x="20446" y="6964"/>
                    </a:cubicBezTo>
                  </a:path>
                  <a:path w="20899" h="6964" stroke="0" extrusionOk="0">
                    <a:moveTo>
                      <a:pt x="20899" y="5457"/>
                    </a:moveTo>
                    <a:cubicBezTo>
                      <a:pt x="20766" y="5964"/>
                      <a:pt x="20615" y="6467"/>
                      <a:pt x="20446" y="6964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" name="Line 125"/>
              <p:cNvSpPr>
                <a:spLocks noChangeShapeType="1"/>
              </p:cNvSpPr>
              <p:nvPr/>
            </p:nvSpPr>
            <p:spPr bwMode="auto">
              <a:xfrm>
                <a:off x="2195" y="2898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" name="Arc 126"/>
              <p:cNvSpPr>
                <a:spLocks/>
              </p:cNvSpPr>
              <p:nvPr/>
            </p:nvSpPr>
            <p:spPr bwMode="auto">
              <a:xfrm>
                <a:off x="1723" y="2775"/>
                <a:ext cx="488" cy="74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21569 w 21569"/>
                  <a:gd name="T1" fmla="*/ 1152 h 3278"/>
                  <a:gd name="T2" fmla="*/ 21350 w 21569"/>
                  <a:gd name="T3" fmla="*/ 3278 h 3278"/>
                  <a:gd name="T4" fmla="*/ 0 w 21569"/>
                  <a:gd name="T5" fmla="*/ 0 h 32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569" h="3278" fill="none" extrusionOk="0">
                    <a:moveTo>
                      <a:pt x="21569" y="1152"/>
                    </a:moveTo>
                    <a:cubicBezTo>
                      <a:pt x="21531" y="1863"/>
                      <a:pt x="21458" y="2573"/>
                      <a:pt x="21349" y="3277"/>
                    </a:cubicBezTo>
                  </a:path>
                  <a:path w="21569" h="3278" stroke="0" extrusionOk="0">
                    <a:moveTo>
                      <a:pt x="21569" y="1152"/>
                    </a:moveTo>
                    <a:cubicBezTo>
                      <a:pt x="21531" y="1863"/>
                      <a:pt x="21458" y="2573"/>
                      <a:pt x="21349" y="3277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" name="Arc 127"/>
              <p:cNvSpPr>
                <a:spLocks/>
              </p:cNvSpPr>
              <p:nvPr/>
            </p:nvSpPr>
            <p:spPr bwMode="auto">
              <a:xfrm>
                <a:off x="1723" y="2775"/>
                <a:ext cx="483" cy="123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21350 w 21350"/>
                  <a:gd name="T1" fmla="*/ 3278 h 5457"/>
                  <a:gd name="T2" fmla="*/ 20899 w 21350"/>
                  <a:gd name="T3" fmla="*/ 5457 h 5457"/>
                  <a:gd name="T4" fmla="*/ 0 w 21350"/>
                  <a:gd name="T5" fmla="*/ 0 h 54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350" h="5457" fill="none" extrusionOk="0">
                    <a:moveTo>
                      <a:pt x="21349" y="3277"/>
                    </a:moveTo>
                    <a:cubicBezTo>
                      <a:pt x="21237" y="4011"/>
                      <a:pt x="21086" y="4738"/>
                      <a:pt x="20899" y="5457"/>
                    </a:cubicBezTo>
                  </a:path>
                  <a:path w="21350" h="5457" stroke="0" extrusionOk="0">
                    <a:moveTo>
                      <a:pt x="21349" y="3277"/>
                    </a:moveTo>
                    <a:cubicBezTo>
                      <a:pt x="21237" y="4011"/>
                      <a:pt x="21086" y="4738"/>
                      <a:pt x="20899" y="5457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Line 129"/>
              <p:cNvSpPr>
                <a:spLocks noChangeShapeType="1"/>
              </p:cNvSpPr>
              <p:nvPr/>
            </p:nvSpPr>
            <p:spPr bwMode="auto">
              <a:xfrm>
                <a:off x="2206" y="2849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" name="Arc 130"/>
              <p:cNvSpPr>
                <a:spLocks/>
              </p:cNvSpPr>
              <p:nvPr/>
            </p:nvSpPr>
            <p:spPr bwMode="auto">
              <a:xfrm>
                <a:off x="1723" y="2641"/>
                <a:ext cx="488" cy="134"/>
              </a:xfrm>
              <a:custGeom>
                <a:avLst/>
                <a:gdLst>
                  <a:gd name="G0" fmla="+- 0 0 0"/>
                  <a:gd name="G1" fmla="+- 5951 0 0"/>
                  <a:gd name="G2" fmla="+- 21600 0 0"/>
                  <a:gd name="T0" fmla="*/ 20764 w 21567"/>
                  <a:gd name="T1" fmla="*/ 0 h 5951"/>
                  <a:gd name="T2" fmla="*/ 21567 w 21567"/>
                  <a:gd name="T3" fmla="*/ 4755 h 5951"/>
                  <a:gd name="T4" fmla="*/ 0 w 21567"/>
                  <a:gd name="T5" fmla="*/ 5951 h 59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567" h="5951" fill="none" extrusionOk="0">
                    <a:moveTo>
                      <a:pt x="20764" y="-1"/>
                    </a:moveTo>
                    <a:cubicBezTo>
                      <a:pt x="21208" y="1550"/>
                      <a:pt x="21477" y="3145"/>
                      <a:pt x="21566" y="4755"/>
                    </a:cubicBezTo>
                  </a:path>
                  <a:path w="21567" h="5951" stroke="0" extrusionOk="0">
                    <a:moveTo>
                      <a:pt x="20764" y="-1"/>
                    </a:moveTo>
                    <a:cubicBezTo>
                      <a:pt x="21208" y="1550"/>
                      <a:pt x="21477" y="3145"/>
                      <a:pt x="21566" y="4755"/>
                    </a:cubicBezTo>
                    <a:lnTo>
                      <a:pt x="0" y="5951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Arc 131"/>
              <p:cNvSpPr>
                <a:spLocks/>
              </p:cNvSpPr>
              <p:nvPr/>
            </p:nvSpPr>
            <p:spPr bwMode="auto">
              <a:xfrm>
                <a:off x="1723" y="2748"/>
                <a:ext cx="489" cy="101"/>
              </a:xfrm>
              <a:custGeom>
                <a:avLst/>
                <a:gdLst>
                  <a:gd name="G0" fmla="+- 0 0 0"/>
                  <a:gd name="G1" fmla="+- 1196 0 0"/>
                  <a:gd name="G2" fmla="+- 21600 0 0"/>
                  <a:gd name="T0" fmla="*/ 21567 w 21600"/>
                  <a:gd name="T1" fmla="*/ 0 h 4474"/>
                  <a:gd name="T2" fmla="*/ 21350 w 21600"/>
                  <a:gd name="T3" fmla="*/ 4474 h 4474"/>
                  <a:gd name="T4" fmla="*/ 0 w 21600"/>
                  <a:gd name="T5" fmla="*/ 1196 h 44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600" h="4474" fill="none" extrusionOk="0">
                    <a:moveTo>
                      <a:pt x="21566" y="0"/>
                    </a:moveTo>
                    <a:cubicBezTo>
                      <a:pt x="21588" y="398"/>
                      <a:pt x="21600" y="797"/>
                      <a:pt x="21600" y="1196"/>
                    </a:cubicBezTo>
                    <a:cubicBezTo>
                      <a:pt x="21600" y="2293"/>
                      <a:pt x="21516" y="3389"/>
                      <a:pt x="21349" y="4473"/>
                    </a:cubicBezTo>
                  </a:path>
                  <a:path w="21600" h="4474" stroke="0" extrusionOk="0">
                    <a:moveTo>
                      <a:pt x="21566" y="0"/>
                    </a:moveTo>
                    <a:cubicBezTo>
                      <a:pt x="21588" y="398"/>
                      <a:pt x="21600" y="797"/>
                      <a:pt x="21600" y="1196"/>
                    </a:cubicBezTo>
                    <a:cubicBezTo>
                      <a:pt x="21600" y="2293"/>
                      <a:pt x="21516" y="3389"/>
                      <a:pt x="21349" y="4473"/>
                    </a:cubicBezTo>
                    <a:lnTo>
                      <a:pt x="0" y="1196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" name="Line 133"/>
              <p:cNvSpPr>
                <a:spLocks noChangeShapeType="1"/>
              </p:cNvSpPr>
              <p:nvPr/>
            </p:nvSpPr>
            <p:spPr bwMode="auto">
              <a:xfrm>
                <a:off x="2211" y="2748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" name="Rectangle 134"/>
              <p:cNvSpPr>
                <a:spLocks noChangeArrowheads="1"/>
              </p:cNvSpPr>
              <p:nvPr/>
            </p:nvSpPr>
            <p:spPr bwMode="auto">
              <a:xfrm rot="1560000">
                <a:off x="2251" y="3197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7560/2015</a:t>
                </a:r>
              </a:p>
            </p:txBody>
          </p:sp>
          <p:sp>
            <p:nvSpPr>
              <p:cNvPr id="324" name="Line 135"/>
              <p:cNvSpPr>
                <a:spLocks noChangeShapeType="1"/>
              </p:cNvSpPr>
              <p:nvPr/>
            </p:nvSpPr>
            <p:spPr bwMode="auto">
              <a:xfrm>
                <a:off x="2232" y="3037"/>
                <a:ext cx="7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Rectangle 136"/>
              <p:cNvSpPr>
                <a:spLocks noChangeArrowheads="1"/>
              </p:cNvSpPr>
              <p:nvPr/>
            </p:nvSpPr>
            <p:spPr bwMode="auto">
              <a:xfrm rot="1920000">
                <a:off x="2406" y="3419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7345/2015</a:t>
                </a:r>
              </a:p>
            </p:txBody>
          </p:sp>
          <p:sp>
            <p:nvSpPr>
              <p:cNvPr id="326" name="Line 137"/>
              <p:cNvSpPr>
                <a:spLocks noChangeShapeType="1"/>
              </p:cNvSpPr>
              <p:nvPr/>
            </p:nvSpPr>
            <p:spPr bwMode="auto">
              <a:xfrm>
                <a:off x="2200" y="3075"/>
                <a:ext cx="274" cy="17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" name="Rectangle 138"/>
              <p:cNvSpPr>
                <a:spLocks noChangeArrowheads="1"/>
              </p:cNvSpPr>
              <p:nvPr/>
            </p:nvSpPr>
            <p:spPr bwMode="auto">
              <a:xfrm rot="2220000">
                <a:off x="2145" y="3367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D2/Taiwan/20063/2015</a:t>
                </a:r>
              </a:p>
            </p:txBody>
          </p:sp>
          <p:sp>
            <p:nvSpPr>
              <p:cNvPr id="328" name="Line 139"/>
              <p:cNvSpPr>
                <a:spLocks noChangeShapeType="1"/>
              </p:cNvSpPr>
              <p:nvPr/>
            </p:nvSpPr>
            <p:spPr bwMode="auto">
              <a:xfrm>
                <a:off x="2173" y="3117"/>
                <a:ext cx="65" cy="5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9" name="Arc 140"/>
              <p:cNvSpPr>
                <a:spLocks/>
              </p:cNvSpPr>
              <p:nvPr/>
            </p:nvSpPr>
            <p:spPr bwMode="auto">
              <a:xfrm>
                <a:off x="1723" y="2774"/>
                <a:ext cx="483" cy="326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8323 w 18323"/>
                  <a:gd name="T1" fmla="*/ 11439 h 12383"/>
                  <a:gd name="T2" fmla="*/ 17698 w 18323"/>
                  <a:gd name="T3" fmla="*/ 12383 h 12383"/>
                  <a:gd name="T4" fmla="*/ 0 w 18323"/>
                  <a:gd name="T5" fmla="*/ 0 h 123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323" h="12383" fill="none" extrusionOk="0">
                    <a:moveTo>
                      <a:pt x="18322" y="11438"/>
                    </a:moveTo>
                    <a:cubicBezTo>
                      <a:pt x="18122" y="11758"/>
                      <a:pt x="17914" y="12073"/>
                      <a:pt x="17698" y="12383"/>
                    </a:cubicBezTo>
                  </a:path>
                  <a:path w="18323" h="12383" stroke="0" extrusionOk="0">
                    <a:moveTo>
                      <a:pt x="18322" y="11438"/>
                    </a:moveTo>
                    <a:cubicBezTo>
                      <a:pt x="18122" y="11758"/>
                      <a:pt x="17914" y="12073"/>
                      <a:pt x="17698" y="12383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0" name="Arc 141"/>
              <p:cNvSpPr>
                <a:spLocks/>
              </p:cNvSpPr>
              <p:nvPr/>
            </p:nvSpPr>
            <p:spPr bwMode="auto">
              <a:xfrm>
                <a:off x="1723" y="2774"/>
                <a:ext cx="466" cy="348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7698 w 17698"/>
                  <a:gd name="T1" fmla="*/ 12383 h 13252"/>
                  <a:gd name="T2" fmla="*/ 17057 w 17698"/>
                  <a:gd name="T3" fmla="*/ 13252 h 13252"/>
                  <a:gd name="T4" fmla="*/ 0 w 17698"/>
                  <a:gd name="T5" fmla="*/ 0 h 132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98" h="13252" fill="none" extrusionOk="0">
                    <a:moveTo>
                      <a:pt x="17698" y="12383"/>
                    </a:moveTo>
                    <a:cubicBezTo>
                      <a:pt x="17491" y="12677"/>
                      <a:pt x="17277" y="12967"/>
                      <a:pt x="17057" y="13252"/>
                    </a:cubicBezTo>
                  </a:path>
                  <a:path w="17698" h="13252" stroke="0" extrusionOk="0">
                    <a:moveTo>
                      <a:pt x="17698" y="12383"/>
                    </a:moveTo>
                    <a:cubicBezTo>
                      <a:pt x="17491" y="12677"/>
                      <a:pt x="17277" y="12967"/>
                      <a:pt x="17057" y="13252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2" name="Line 143"/>
              <p:cNvSpPr>
                <a:spLocks noChangeShapeType="1"/>
              </p:cNvSpPr>
              <p:nvPr/>
            </p:nvSpPr>
            <p:spPr bwMode="auto">
              <a:xfrm>
                <a:off x="2190" y="3096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3" name="Rectangle 144"/>
              <p:cNvSpPr>
                <a:spLocks noChangeArrowheads="1"/>
              </p:cNvSpPr>
              <p:nvPr/>
            </p:nvSpPr>
            <p:spPr bwMode="auto">
              <a:xfrm rot="2520000">
                <a:off x="2019" y="3408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8401/2015</a:t>
                </a:r>
              </a:p>
            </p:txBody>
          </p:sp>
          <p:sp>
            <p:nvSpPr>
              <p:cNvPr id="334" name="Line 145"/>
              <p:cNvSpPr>
                <a:spLocks noChangeShapeType="1"/>
              </p:cNvSpPr>
              <p:nvPr/>
            </p:nvSpPr>
            <p:spPr bwMode="auto">
              <a:xfrm>
                <a:off x="2141" y="3160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5" name="Arc 146"/>
              <p:cNvSpPr>
                <a:spLocks/>
              </p:cNvSpPr>
              <p:nvPr/>
            </p:nvSpPr>
            <p:spPr bwMode="auto">
              <a:xfrm>
                <a:off x="1723" y="2774"/>
                <a:ext cx="466" cy="354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7698 w 17698"/>
                  <a:gd name="T1" fmla="*/ 12383 h 13462"/>
                  <a:gd name="T2" fmla="*/ 16892 w 17698"/>
                  <a:gd name="T3" fmla="*/ 13462 h 13462"/>
                  <a:gd name="T4" fmla="*/ 0 w 17698"/>
                  <a:gd name="T5" fmla="*/ 0 h 134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98" h="13462" fill="none" extrusionOk="0">
                    <a:moveTo>
                      <a:pt x="17698" y="12383"/>
                    </a:moveTo>
                    <a:cubicBezTo>
                      <a:pt x="17440" y="12750"/>
                      <a:pt x="17171" y="13110"/>
                      <a:pt x="16891" y="13461"/>
                    </a:cubicBezTo>
                  </a:path>
                  <a:path w="17698" h="13462" stroke="0" extrusionOk="0">
                    <a:moveTo>
                      <a:pt x="17698" y="12383"/>
                    </a:moveTo>
                    <a:cubicBezTo>
                      <a:pt x="17440" y="12750"/>
                      <a:pt x="17171" y="13110"/>
                      <a:pt x="16891" y="13461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6" name="Arc 147"/>
              <p:cNvSpPr>
                <a:spLocks/>
              </p:cNvSpPr>
              <p:nvPr/>
            </p:nvSpPr>
            <p:spPr bwMode="auto">
              <a:xfrm>
                <a:off x="1723" y="2774"/>
                <a:ext cx="445" cy="386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6892 w 16892"/>
                  <a:gd name="T1" fmla="*/ 13462 h 14668"/>
                  <a:gd name="T2" fmla="*/ 15856 w 16892"/>
                  <a:gd name="T3" fmla="*/ 14668 h 14668"/>
                  <a:gd name="T4" fmla="*/ 0 w 16892"/>
                  <a:gd name="T5" fmla="*/ 0 h 146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892" h="14668" fill="none" extrusionOk="0">
                    <a:moveTo>
                      <a:pt x="16891" y="13461"/>
                    </a:moveTo>
                    <a:cubicBezTo>
                      <a:pt x="16561" y="13876"/>
                      <a:pt x="16215" y="14278"/>
                      <a:pt x="15855" y="14667"/>
                    </a:cubicBezTo>
                  </a:path>
                  <a:path w="16892" h="14668" stroke="0" extrusionOk="0">
                    <a:moveTo>
                      <a:pt x="16891" y="13461"/>
                    </a:moveTo>
                    <a:cubicBezTo>
                      <a:pt x="16561" y="13876"/>
                      <a:pt x="16215" y="14278"/>
                      <a:pt x="15855" y="14667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8" name="Line 149"/>
              <p:cNvSpPr>
                <a:spLocks noChangeShapeType="1"/>
              </p:cNvSpPr>
              <p:nvPr/>
            </p:nvSpPr>
            <p:spPr bwMode="auto">
              <a:xfrm>
                <a:off x="2163" y="3128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9" name="Rectangle 150"/>
              <p:cNvSpPr>
                <a:spLocks noChangeArrowheads="1"/>
              </p:cNvSpPr>
              <p:nvPr/>
            </p:nvSpPr>
            <p:spPr bwMode="auto">
              <a:xfrm rot="2880000">
                <a:off x="2116" y="3637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8279/2015</a:t>
                </a:r>
              </a:p>
            </p:txBody>
          </p:sp>
          <p:sp>
            <p:nvSpPr>
              <p:cNvPr id="340" name="Line 151"/>
              <p:cNvSpPr>
                <a:spLocks noChangeShapeType="1"/>
              </p:cNvSpPr>
              <p:nvPr/>
            </p:nvSpPr>
            <p:spPr bwMode="auto">
              <a:xfrm>
                <a:off x="2211" y="3316"/>
                <a:ext cx="54" cy="5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1" name="Rectangle 152"/>
              <p:cNvSpPr>
                <a:spLocks noChangeArrowheads="1"/>
              </p:cNvSpPr>
              <p:nvPr/>
            </p:nvSpPr>
            <p:spPr bwMode="auto">
              <a:xfrm rot="3180000">
                <a:off x="2038" y="3705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8884/2015</a:t>
                </a:r>
              </a:p>
            </p:txBody>
          </p:sp>
          <p:sp>
            <p:nvSpPr>
              <p:cNvPr id="342" name="Line 153"/>
              <p:cNvSpPr>
                <a:spLocks noChangeShapeType="1"/>
              </p:cNvSpPr>
              <p:nvPr/>
            </p:nvSpPr>
            <p:spPr bwMode="auto">
              <a:xfrm>
                <a:off x="2157" y="3359"/>
                <a:ext cx="49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3" name="Arc 154"/>
              <p:cNvSpPr>
                <a:spLocks/>
              </p:cNvSpPr>
              <p:nvPr/>
            </p:nvSpPr>
            <p:spPr bwMode="auto">
              <a:xfrm>
                <a:off x="1723" y="2775"/>
                <a:ext cx="488" cy="564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4457 w 14457"/>
                  <a:gd name="T1" fmla="*/ 16049 h 16709"/>
                  <a:gd name="T2" fmla="*/ 13688 w 14457"/>
                  <a:gd name="T3" fmla="*/ 16709 h 16709"/>
                  <a:gd name="T4" fmla="*/ 0 w 14457"/>
                  <a:gd name="T5" fmla="*/ 0 h 167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457" h="16709" fill="none" extrusionOk="0">
                    <a:moveTo>
                      <a:pt x="14456" y="16048"/>
                    </a:moveTo>
                    <a:cubicBezTo>
                      <a:pt x="14205" y="16274"/>
                      <a:pt x="13949" y="16495"/>
                      <a:pt x="13688" y="16709"/>
                    </a:cubicBezTo>
                  </a:path>
                  <a:path w="14457" h="16709" stroke="0" extrusionOk="0">
                    <a:moveTo>
                      <a:pt x="14456" y="16048"/>
                    </a:moveTo>
                    <a:cubicBezTo>
                      <a:pt x="14205" y="16274"/>
                      <a:pt x="13949" y="16495"/>
                      <a:pt x="13688" y="16709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4" name="Arc 155"/>
              <p:cNvSpPr>
                <a:spLocks/>
              </p:cNvSpPr>
              <p:nvPr/>
            </p:nvSpPr>
            <p:spPr bwMode="auto">
              <a:xfrm>
                <a:off x="1723" y="2775"/>
                <a:ext cx="462" cy="585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3688 w 13688"/>
                  <a:gd name="T1" fmla="*/ 16709 h 17345"/>
                  <a:gd name="T2" fmla="*/ 12872 w 13688"/>
                  <a:gd name="T3" fmla="*/ 17345 h 17345"/>
                  <a:gd name="T4" fmla="*/ 0 w 13688"/>
                  <a:gd name="T5" fmla="*/ 0 h 173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688" h="17345" fill="none" extrusionOk="0">
                    <a:moveTo>
                      <a:pt x="13688" y="16709"/>
                    </a:moveTo>
                    <a:cubicBezTo>
                      <a:pt x="13421" y="16927"/>
                      <a:pt x="13149" y="17139"/>
                      <a:pt x="12872" y="17345"/>
                    </a:cubicBezTo>
                  </a:path>
                  <a:path w="13688" h="17345" stroke="0" extrusionOk="0">
                    <a:moveTo>
                      <a:pt x="13688" y="16709"/>
                    </a:moveTo>
                    <a:cubicBezTo>
                      <a:pt x="13421" y="16927"/>
                      <a:pt x="13149" y="17139"/>
                      <a:pt x="12872" y="17345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6" name="Line 157"/>
              <p:cNvSpPr>
                <a:spLocks noChangeShapeType="1"/>
              </p:cNvSpPr>
              <p:nvPr/>
            </p:nvSpPr>
            <p:spPr bwMode="auto">
              <a:xfrm>
                <a:off x="2131" y="3273"/>
                <a:ext cx="53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7" name="Rectangle 158"/>
              <p:cNvSpPr>
                <a:spLocks noChangeArrowheads="1"/>
              </p:cNvSpPr>
              <p:nvPr/>
            </p:nvSpPr>
            <p:spPr bwMode="auto">
              <a:xfrm rot="3480000">
                <a:off x="1936" y="3770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7206/2015</a:t>
                </a:r>
              </a:p>
            </p:txBody>
          </p:sp>
          <p:sp>
            <p:nvSpPr>
              <p:cNvPr id="348" name="Line 159"/>
              <p:cNvSpPr>
                <a:spLocks noChangeShapeType="1"/>
              </p:cNvSpPr>
              <p:nvPr/>
            </p:nvSpPr>
            <p:spPr bwMode="auto">
              <a:xfrm>
                <a:off x="2055" y="3326"/>
                <a:ext cx="86" cy="1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9" name="Arc 160"/>
              <p:cNvSpPr>
                <a:spLocks/>
              </p:cNvSpPr>
              <p:nvPr/>
            </p:nvSpPr>
            <p:spPr bwMode="auto">
              <a:xfrm>
                <a:off x="1723" y="2775"/>
                <a:ext cx="412" cy="530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3694 w 13694"/>
                  <a:gd name="T1" fmla="*/ 16704 h 17642"/>
                  <a:gd name="T2" fmla="*/ 12463 w 13694"/>
                  <a:gd name="T3" fmla="*/ 17642 h 17642"/>
                  <a:gd name="T4" fmla="*/ 0 w 13694"/>
                  <a:gd name="T5" fmla="*/ 0 h 176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694" h="17642" fill="none" extrusionOk="0">
                    <a:moveTo>
                      <a:pt x="13694" y="16704"/>
                    </a:moveTo>
                    <a:cubicBezTo>
                      <a:pt x="13295" y="17031"/>
                      <a:pt x="12884" y="17344"/>
                      <a:pt x="12462" y="17641"/>
                    </a:cubicBezTo>
                  </a:path>
                  <a:path w="13694" h="17642" stroke="0" extrusionOk="0">
                    <a:moveTo>
                      <a:pt x="13694" y="16704"/>
                    </a:moveTo>
                    <a:cubicBezTo>
                      <a:pt x="13295" y="17031"/>
                      <a:pt x="12884" y="17344"/>
                      <a:pt x="12462" y="17641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0" name="Arc 161"/>
              <p:cNvSpPr>
                <a:spLocks/>
              </p:cNvSpPr>
              <p:nvPr/>
            </p:nvSpPr>
            <p:spPr bwMode="auto">
              <a:xfrm>
                <a:off x="1723" y="2775"/>
                <a:ext cx="375" cy="553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2463 w 12463"/>
                  <a:gd name="T1" fmla="*/ 17642 h 18420"/>
                  <a:gd name="T2" fmla="*/ 11282 w 12463"/>
                  <a:gd name="T3" fmla="*/ 18420 h 18420"/>
                  <a:gd name="T4" fmla="*/ 0 w 12463"/>
                  <a:gd name="T5" fmla="*/ 0 h 184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63" h="18420" fill="none" extrusionOk="0">
                    <a:moveTo>
                      <a:pt x="12462" y="17641"/>
                    </a:moveTo>
                    <a:cubicBezTo>
                      <a:pt x="12077" y="17913"/>
                      <a:pt x="11683" y="18173"/>
                      <a:pt x="11281" y="18419"/>
                    </a:cubicBezTo>
                  </a:path>
                  <a:path w="12463" h="18420" stroke="0" extrusionOk="0">
                    <a:moveTo>
                      <a:pt x="12462" y="17641"/>
                    </a:moveTo>
                    <a:cubicBezTo>
                      <a:pt x="12077" y="17913"/>
                      <a:pt x="11683" y="18173"/>
                      <a:pt x="11281" y="18419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2" name="Line 163"/>
              <p:cNvSpPr>
                <a:spLocks noChangeShapeType="1"/>
              </p:cNvSpPr>
              <p:nvPr/>
            </p:nvSpPr>
            <p:spPr bwMode="auto">
              <a:xfrm>
                <a:off x="2050" y="3241"/>
                <a:ext cx="48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3" name="Rectangle 164"/>
              <p:cNvSpPr>
                <a:spLocks noChangeArrowheads="1"/>
              </p:cNvSpPr>
              <p:nvPr/>
            </p:nvSpPr>
            <p:spPr bwMode="auto">
              <a:xfrm rot="3840000">
                <a:off x="1803" y="3752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D2/Taiwan/24943/2015</a:t>
                </a:r>
              </a:p>
            </p:txBody>
          </p:sp>
          <p:sp>
            <p:nvSpPr>
              <p:cNvPr id="354" name="Line 165"/>
              <p:cNvSpPr>
                <a:spLocks noChangeShapeType="1"/>
              </p:cNvSpPr>
              <p:nvPr/>
            </p:nvSpPr>
            <p:spPr bwMode="auto">
              <a:xfrm>
                <a:off x="2007" y="3353"/>
                <a:ext cx="32" cy="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5" name="Rectangle 166"/>
              <p:cNvSpPr>
                <a:spLocks noChangeArrowheads="1"/>
              </p:cNvSpPr>
              <p:nvPr/>
            </p:nvSpPr>
            <p:spPr bwMode="auto">
              <a:xfrm rot="4140000">
                <a:off x="1788" y="4018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27233/2015</a:t>
                </a:r>
              </a:p>
            </p:txBody>
          </p:sp>
          <p:sp>
            <p:nvSpPr>
              <p:cNvPr id="356" name="Line 167"/>
              <p:cNvSpPr>
                <a:spLocks noChangeShapeType="1"/>
              </p:cNvSpPr>
              <p:nvPr/>
            </p:nvSpPr>
            <p:spPr bwMode="auto">
              <a:xfrm>
                <a:off x="2039" y="3605"/>
                <a:ext cx="27" cy="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7" name="Rectangle 168"/>
              <p:cNvSpPr>
                <a:spLocks noChangeArrowheads="1"/>
              </p:cNvSpPr>
              <p:nvPr/>
            </p:nvSpPr>
            <p:spPr bwMode="auto">
              <a:xfrm rot="4440000">
                <a:off x="1664" y="3986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6776/2015</a:t>
                </a:r>
              </a:p>
            </p:txBody>
          </p:sp>
          <p:sp>
            <p:nvSpPr>
              <p:cNvPr id="358" name="Line 169"/>
              <p:cNvSpPr>
                <a:spLocks noChangeShapeType="1"/>
              </p:cNvSpPr>
              <p:nvPr/>
            </p:nvSpPr>
            <p:spPr bwMode="auto">
              <a:xfrm>
                <a:off x="1959" y="3632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9" name="Rectangle 170"/>
              <p:cNvSpPr>
                <a:spLocks noChangeArrowheads="1"/>
              </p:cNvSpPr>
              <p:nvPr/>
            </p:nvSpPr>
            <p:spPr bwMode="auto">
              <a:xfrm rot="4800000">
                <a:off x="1541" y="4012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6907/2015</a:t>
                </a:r>
              </a:p>
            </p:txBody>
          </p:sp>
          <p:sp>
            <p:nvSpPr>
              <p:cNvPr id="360" name="Line 171"/>
              <p:cNvSpPr>
                <a:spLocks noChangeShapeType="1"/>
              </p:cNvSpPr>
              <p:nvPr/>
            </p:nvSpPr>
            <p:spPr bwMode="auto">
              <a:xfrm>
                <a:off x="1878" y="3648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1" name="Arc 172"/>
              <p:cNvSpPr>
                <a:spLocks/>
              </p:cNvSpPr>
              <p:nvPr/>
            </p:nvSpPr>
            <p:spPr bwMode="auto">
              <a:xfrm>
                <a:off x="1723" y="2775"/>
                <a:ext cx="238" cy="868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5766 w 5766"/>
                  <a:gd name="T1" fmla="*/ 20816 h 21086"/>
                  <a:gd name="T2" fmla="*/ 4683 w 5766"/>
                  <a:gd name="T3" fmla="*/ 21086 h 21086"/>
                  <a:gd name="T4" fmla="*/ 0 w 5766"/>
                  <a:gd name="T5" fmla="*/ 0 h 210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66" h="21086" fill="none" extrusionOk="0">
                    <a:moveTo>
                      <a:pt x="5766" y="20816"/>
                    </a:moveTo>
                    <a:cubicBezTo>
                      <a:pt x="5407" y="20915"/>
                      <a:pt x="5046" y="21005"/>
                      <a:pt x="4683" y="21086"/>
                    </a:cubicBezTo>
                  </a:path>
                  <a:path w="5766" h="21086" stroke="0" extrusionOk="0">
                    <a:moveTo>
                      <a:pt x="5766" y="20816"/>
                    </a:moveTo>
                    <a:cubicBezTo>
                      <a:pt x="5407" y="20915"/>
                      <a:pt x="5046" y="21005"/>
                      <a:pt x="4683" y="21086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2" name="Arc 173"/>
              <p:cNvSpPr>
                <a:spLocks/>
              </p:cNvSpPr>
              <p:nvPr/>
            </p:nvSpPr>
            <p:spPr bwMode="auto">
              <a:xfrm>
                <a:off x="1723" y="2775"/>
                <a:ext cx="193" cy="876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4683 w 4683"/>
                  <a:gd name="T1" fmla="*/ 21086 h 21268"/>
                  <a:gd name="T2" fmla="*/ 3772 w 4683"/>
                  <a:gd name="T3" fmla="*/ 21268 h 21268"/>
                  <a:gd name="T4" fmla="*/ 0 w 4683"/>
                  <a:gd name="T5" fmla="*/ 0 h 212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83" h="21268" fill="none" extrusionOk="0">
                    <a:moveTo>
                      <a:pt x="4683" y="21086"/>
                    </a:moveTo>
                    <a:cubicBezTo>
                      <a:pt x="4380" y="21153"/>
                      <a:pt x="4076" y="21214"/>
                      <a:pt x="3772" y="21268"/>
                    </a:cubicBezTo>
                  </a:path>
                  <a:path w="4683" h="21268" stroke="0" extrusionOk="0">
                    <a:moveTo>
                      <a:pt x="4683" y="21086"/>
                    </a:moveTo>
                    <a:cubicBezTo>
                      <a:pt x="4380" y="21153"/>
                      <a:pt x="4076" y="21214"/>
                      <a:pt x="3772" y="21268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4" name="Line 175"/>
              <p:cNvSpPr>
                <a:spLocks noChangeShapeType="1"/>
              </p:cNvSpPr>
              <p:nvPr/>
            </p:nvSpPr>
            <p:spPr bwMode="auto">
              <a:xfrm>
                <a:off x="1916" y="3643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5" name="Arc 176"/>
              <p:cNvSpPr>
                <a:spLocks/>
              </p:cNvSpPr>
              <p:nvPr/>
            </p:nvSpPr>
            <p:spPr bwMode="auto">
              <a:xfrm>
                <a:off x="1723" y="2775"/>
                <a:ext cx="312" cy="853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7571 w 7571"/>
                  <a:gd name="T1" fmla="*/ 20230 h 20713"/>
                  <a:gd name="T2" fmla="*/ 6127 w 7571"/>
                  <a:gd name="T3" fmla="*/ 20713 h 20713"/>
                  <a:gd name="T4" fmla="*/ 0 w 7571"/>
                  <a:gd name="T5" fmla="*/ 0 h 207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71" h="20713" fill="none" extrusionOk="0">
                    <a:moveTo>
                      <a:pt x="7570" y="20229"/>
                    </a:moveTo>
                    <a:cubicBezTo>
                      <a:pt x="7095" y="20407"/>
                      <a:pt x="6613" y="20568"/>
                      <a:pt x="6126" y="20712"/>
                    </a:cubicBezTo>
                  </a:path>
                  <a:path w="7571" h="20713" stroke="0" extrusionOk="0">
                    <a:moveTo>
                      <a:pt x="7570" y="20229"/>
                    </a:moveTo>
                    <a:cubicBezTo>
                      <a:pt x="7095" y="20407"/>
                      <a:pt x="6613" y="20568"/>
                      <a:pt x="6126" y="20712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6" name="Arc 177"/>
              <p:cNvSpPr>
                <a:spLocks/>
              </p:cNvSpPr>
              <p:nvPr/>
            </p:nvSpPr>
            <p:spPr bwMode="auto">
              <a:xfrm>
                <a:off x="1723" y="2775"/>
                <a:ext cx="253" cy="868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6127 w 6127"/>
                  <a:gd name="T1" fmla="*/ 20713 h 21086"/>
                  <a:gd name="T2" fmla="*/ 4683 w 6127"/>
                  <a:gd name="T3" fmla="*/ 21086 h 21086"/>
                  <a:gd name="T4" fmla="*/ 0 w 6127"/>
                  <a:gd name="T5" fmla="*/ 0 h 210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27" h="21086" fill="none" extrusionOk="0">
                    <a:moveTo>
                      <a:pt x="6126" y="20712"/>
                    </a:moveTo>
                    <a:cubicBezTo>
                      <a:pt x="5650" y="20853"/>
                      <a:pt x="5168" y="20978"/>
                      <a:pt x="4683" y="21086"/>
                    </a:cubicBezTo>
                  </a:path>
                  <a:path w="6127" h="21086" stroke="0" extrusionOk="0">
                    <a:moveTo>
                      <a:pt x="6126" y="20712"/>
                    </a:moveTo>
                    <a:cubicBezTo>
                      <a:pt x="5650" y="20853"/>
                      <a:pt x="5168" y="20978"/>
                      <a:pt x="4683" y="21086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7" name="Rectangle 178"/>
              <p:cNvSpPr>
                <a:spLocks noChangeArrowheads="1"/>
              </p:cNvSpPr>
              <p:nvPr/>
            </p:nvSpPr>
            <p:spPr bwMode="auto">
              <a:xfrm rot="4380000">
                <a:off x="1890" y="3558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96</a:t>
                </a:r>
                <a:endParaRPr kumimoji="0" lang="zh-TW" altLang="zh-TW" sz="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68" name="Line 179"/>
              <p:cNvSpPr>
                <a:spLocks noChangeShapeType="1"/>
              </p:cNvSpPr>
              <p:nvPr/>
            </p:nvSpPr>
            <p:spPr bwMode="auto">
              <a:xfrm>
                <a:off x="1905" y="3396"/>
                <a:ext cx="70" cy="23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9" name="Arc 180"/>
              <p:cNvSpPr>
                <a:spLocks/>
              </p:cNvSpPr>
              <p:nvPr/>
            </p:nvSpPr>
            <p:spPr bwMode="auto">
              <a:xfrm>
                <a:off x="1723" y="2775"/>
                <a:ext cx="284" cy="604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9435 w 9435"/>
                  <a:gd name="T1" fmla="*/ 19431 h 20127"/>
                  <a:gd name="T2" fmla="*/ 7839 w 9435"/>
                  <a:gd name="T3" fmla="*/ 20127 h 20127"/>
                  <a:gd name="T4" fmla="*/ 0 w 9435"/>
                  <a:gd name="T5" fmla="*/ 0 h 201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435" h="20127" fill="none" extrusionOk="0">
                    <a:moveTo>
                      <a:pt x="9434" y="19430"/>
                    </a:moveTo>
                    <a:cubicBezTo>
                      <a:pt x="8912" y="19684"/>
                      <a:pt x="8380" y="19916"/>
                      <a:pt x="7839" y="20127"/>
                    </a:cubicBezTo>
                  </a:path>
                  <a:path w="9435" h="20127" stroke="0" extrusionOk="0">
                    <a:moveTo>
                      <a:pt x="9434" y="19430"/>
                    </a:moveTo>
                    <a:cubicBezTo>
                      <a:pt x="8912" y="19684"/>
                      <a:pt x="8380" y="19916"/>
                      <a:pt x="7839" y="20127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0" name="Arc 181"/>
              <p:cNvSpPr>
                <a:spLocks/>
              </p:cNvSpPr>
              <p:nvPr/>
            </p:nvSpPr>
            <p:spPr bwMode="auto">
              <a:xfrm>
                <a:off x="1723" y="2775"/>
                <a:ext cx="236" cy="621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7839 w 7839"/>
                  <a:gd name="T1" fmla="*/ 20127 h 20685"/>
                  <a:gd name="T2" fmla="*/ 6219 w 7839"/>
                  <a:gd name="T3" fmla="*/ 20685 h 20685"/>
                  <a:gd name="T4" fmla="*/ 0 w 7839"/>
                  <a:gd name="T5" fmla="*/ 0 h 206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839" h="20685" fill="none" extrusionOk="0">
                    <a:moveTo>
                      <a:pt x="7839" y="20127"/>
                    </a:moveTo>
                    <a:cubicBezTo>
                      <a:pt x="7306" y="20334"/>
                      <a:pt x="6766" y="20520"/>
                      <a:pt x="6219" y="20685"/>
                    </a:cubicBezTo>
                  </a:path>
                  <a:path w="7839" h="20685" stroke="0" extrusionOk="0">
                    <a:moveTo>
                      <a:pt x="7839" y="20127"/>
                    </a:moveTo>
                    <a:cubicBezTo>
                      <a:pt x="7306" y="20334"/>
                      <a:pt x="6766" y="20520"/>
                      <a:pt x="6219" y="20685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2" name="Line 183"/>
              <p:cNvSpPr>
                <a:spLocks noChangeShapeType="1"/>
              </p:cNvSpPr>
              <p:nvPr/>
            </p:nvSpPr>
            <p:spPr bwMode="auto">
              <a:xfrm>
                <a:off x="1932" y="3300"/>
                <a:ext cx="27" cy="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3" name="Arc 184"/>
              <p:cNvSpPr>
                <a:spLocks/>
              </p:cNvSpPr>
              <p:nvPr/>
            </p:nvSpPr>
            <p:spPr bwMode="auto">
              <a:xfrm>
                <a:off x="1723" y="2774"/>
                <a:ext cx="326" cy="501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2375 w 12375"/>
                  <a:gd name="T1" fmla="*/ 17704 h 19037"/>
                  <a:gd name="T2" fmla="*/ 10206 w 12375"/>
                  <a:gd name="T3" fmla="*/ 19037 h 19037"/>
                  <a:gd name="T4" fmla="*/ 0 w 12375"/>
                  <a:gd name="T5" fmla="*/ 0 h 190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375" h="19037" fill="none" extrusionOk="0">
                    <a:moveTo>
                      <a:pt x="12374" y="17703"/>
                    </a:moveTo>
                    <a:cubicBezTo>
                      <a:pt x="11678" y="18190"/>
                      <a:pt x="10954" y="18635"/>
                      <a:pt x="10205" y="19036"/>
                    </a:cubicBezTo>
                  </a:path>
                  <a:path w="12375" h="19037" stroke="0" extrusionOk="0">
                    <a:moveTo>
                      <a:pt x="12374" y="17703"/>
                    </a:moveTo>
                    <a:cubicBezTo>
                      <a:pt x="11678" y="18190"/>
                      <a:pt x="10954" y="18635"/>
                      <a:pt x="10205" y="19036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4" name="Arc 185"/>
              <p:cNvSpPr>
                <a:spLocks/>
              </p:cNvSpPr>
              <p:nvPr/>
            </p:nvSpPr>
            <p:spPr bwMode="auto">
              <a:xfrm>
                <a:off x="1723" y="2774"/>
                <a:ext cx="269" cy="529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0206 w 10206"/>
                  <a:gd name="T1" fmla="*/ 19037 h 20104"/>
                  <a:gd name="T2" fmla="*/ 7899 w 10206"/>
                  <a:gd name="T3" fmla="*/ 20104 h 20104"/>
                  <a:gd name="T4" fmla="*/ 0 w 10206"/>
                  <a:gd name="T5" fmla="*/ 0 h 20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206" h="20104" fill="none" extrusionOk="0">
                    <a:moveTo>
                      <a:pt x="10205" y="19036"/>
                    </a:moveTo>
                    <a:cubicBezTo>
                      <a:pt x="9458" y="19437"/>
                      <a:pt x="8688" y="19793"/>
                      <a:pt x="7898" y="20103"/>
                    </a:cubicBezTo>
                  </a:path>
                  <a:path w="10206" h="20104" stroke="0" extrusionOk="0">
                    <a:moveTo>
                      <a:pt x="10205" y="19036"/>
                    </a:moveTo>
                    <a:cubicBezTo>
                      <a:pt x="9458" y="19437"/>
                      <a:pt x="8688" y="19793"/>
                      <a:pt x="7898" y="20103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6" name="Line 187"/>
              <p:cNvSpPr>
                <a:spLocks noChangeShapeType="1"/>
              </p:cNvSpPr>
              <p:nvPr/>
            </p:nvSpPr>
            <p:spPr bwMode="auto">
              <a:xfrm>
                <a:off x="1991" y="3273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7" name="Arc 188"/>
              <p:cNvSpPr>
                <a:spLocks/>
              </p:cNvSpPr>
              <p:nvPr/>
            </p:nvSpPr>
            <p:spPr bwMode="auto">
              <a:xfrm>
                <a:off x="1723" y="2774"/>
                <a:ext cx="445" cy="437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6892 w 16892"/>
                  <a:gd name="T1" fmla="*/ 13462 h 16636"/>
                  <a:gd name="T2" fmla="*/ 13776 w 16892"/>
                  <a:gd name="T3" fmla="*/ 16636 h 16636"/>
                  <a:gd name="T4" fmla="*/ 0 w 16892"/>
                  <a:gd name="T5" fmla="*/ 0 h 166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892" h="16636" fill="none" extrusionOk="0">
                    <a:moveTo>
                      <a:pt x="16891" y="13461"/>
                    </a:moveTo>
                    <a:cubicBezTo>
                      <a:pt x="15965" y="14624"/>
                      <a:pt x="14921" y="15688"/>
                      <a:pt x="13776" y="16636"/>
                    </a:cubicBezTo>
                  </a:path>
                  <a:path w="16892" h="16636" stroke="0" extrusionOk="0">
                    <a:moveTo>
                      <a:pt x="16891" y="13461"/>
                    </a:moveTo>
                    <a:cubicBezTo>
                      <a:pt x="15965" y="14624"/>
                      <a:pt x="14921" y="15688"/>
                      <a:pt x="13776" y="16636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8" name="Arc 189"/>
              <p:cNvSpPr>
                <a:spLocks/>
              </p:cNvSpPr>
              <p:nvPr/>
            </p:nvSpPr>
            <p:spPr bwMode="auto">
              <a:xfrm>
                <a:off x="1723" y="2774"/>
                <a:ext cx="363" cy="501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3776 w 13776"/>
                  <a:gd name="T1" fmla="*/ 16636 h 19037"/>
                  <a:gd name="T2" fmla="*/ 10206 w 13776"/>
                  <a:gd name="T3" fmla="*/ 19037 h 19037"/>
                  <a:gd name="T4" fmla="*/ 0 w 13776"/>
                  <a:gd name="T5" fmla="*/ 0 h 190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776" h="19037" fill="none" extrusionOk="0">
                    <a:moveTo>
                      <a:pt x="13776" y="16636"/>
                    </a:moveTo>
                    <a:cubicBezTo>
                      <a:pt x="12669" y="17553"/>
                      <a:pt x="11472" y="18357"/>
                      <a:pt x="10205" y="19036"/>
                    </a:cubicBezTo>
                  </a:path>
                  <a:path w="13776" h="19037" stroke="0" extrusionOk="0">
                    <a:moveTo>
                      <a:pt x="13776" y="16636"/>
                    </a:moveTo>
                    <a:cubicBezTo>
                      <a:pt x="12669" y="17553"/>
                      <a:pt x="11472" y="18357"/>
                      <a:pt x="10205" y="19036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0" name="Line 191"/>
              <p:cNvSpPr>
                <a:spLocks noChangeShapeType="1"/>
              </p:cNvSpPr>
              <p:nvPr/>
            </p:nvSpPr>
            <p:spPr bwMode="auto">
              <a:xfrm>
                <a:off x="2088" y="3208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1" name="Arc 192"/>
              <p:cNvSpPr>
                <a:spLocks/>
              </p:cNvSpPr>
              <p:nvPr/>
            </p:nvSpPr>
            <p:spPr bwMode="auto">
              <a:xfrm>
                <a:off x="1723" y="2774"/>
                <a:ext cx="507" cy="354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9259 w 19259"/>
                  <a:gd name="T1" fmla="*/ 9779 h 13462"/>
                  <a:gd name="T2" fmla="*/ 16892 w 19259"/>
                  <a:gd name="T3" fmla="*/ 13462 h 13462"/>
                  <a:gd name="T4" fmla="*/ 0 w 19259"/>
                  <a:gd name="T5" fmla="*/ 0 h 134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259" h="13462" fill="none" extrusionOk="0">
                    <a:moveTo>
                      <a:pt x="19259" y="9779"/>
                    </a:moveTo>
                    <a:cubicBezTo>
                      <a:pt x="18597" y="11083"/>
                      <a:pt x="17803" y="12317"/>
                      <a:pt x="16891" y="13461"/>
                    </a:cubicBezTo>
                  </a:path>
                  <a:path w="19259" h="13462" stroke="0" extrusionOk="0">
                    <a:moveTo>
                      <a:pt x="19259" y="9779"/>
                    </a:moveTo>
                    <a:cubicBezTo>
                      <a:pt x="18597" y="11083"/>
                      <a:pt x="17803" y="12317"/>
                      <a:pt x="16891" y="13461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2" name="Arc 193"/>
              <p:cNvSpPr>
                <a:spLocks/>
              </p:cNvSpPr>
              <p:nvPr/>
            </p:nvSpPr>
            <p:spPr bwMode="auto">
              <a:xfrm>
                <a:off x="1723" y="2774"/>
                <a:ext cx="445" cy="437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6892 w 16892"/>
                  <a:gd name="T1" fmla="*/ 13462 h 16636"/>
                  <a:gd name="T2" fmla="*/ 13776 w 16892"/>
                  <a:gd name="T3" fmla="*/ 16636 h 16636"/>
                  <a:gd name="T4" fmla="*/ 0 w 16892"/>
                  <a:gd name="T5" fmla="*/ 0 h 166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892" h="16636" fill="none" extrusionOk="0">
                    <a:moveTo>
                      <a:pt x="16891" y="13461"/>
                    </a:moveTo>
                    <a:cubicBezTo>
                      <a:pt x="15965" y="14624"/>
                      <a:pt x="14921" y="15688"/>
                      <a:pt x="13776" y="16636"/>
                    </a:cubicBezTo>
                  </a:path>
                  <a:path w="16892" h="16636" stroke="0" extrusionOk="0">
                    <a:moveTo>
                      <a:pt x="16891" y="13461"/>
                    </a:moveTo>
                    <a:cubicBezTo>
                      <a:pt x="15965" y="14624"/>
                      <a:pt x="14921" y="15688"/>
                      <a:pt x="13776" y="16636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4" name="Line 195"/>
              <p:cNvSpPr>
                <a:spLocks noChangeShapeType="1"/>
              </p:cNvSpPr>
              <p:nvPr/>
            </p:nvSpPr>
            <p:spPr bwMode="auto">
              <a:xfrm>
                <a:off x="2104" y="3075"/>
                <a:ext cx="64" cy="5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5" name="Arc 196"/>
              <p:cNvSpPr>
                <a:spLocks/>
              </p:cNvSpPr>
              <p:nvPr/>
            </p:nvSpPr>
            <p:spPr bwMode="auto">
              <a:xfrm>
                <a:off x="1723" y="2748"/>
                <a:ext cx="489" cy="171"/>
              </a:xfrm>
              <a:custGeom>
                <a:avLst/>
                <a:gdLst>
                  <a:gd name="G0" fmla="+- 0 0 0"/>
                  <a:gd name="G1" fmla="+- 1196 0 0"/>
                  <a:gd name="G2" fmla="+- 21600 0 0"/>
                  <a:gd name="T0" fmla="*/ 21567 w 21600"/>
                  <a:gd name="T1" fmla="*/ 0 h 7573"/>
                  <a:gd name="T2" fmla="*/ 20637 w 21600"/>
                  <a:gd name="T3" fmla="*/ 7573 h 7573"/>
                  <a:gd name="T4" fmla="*/ 0 w 21600"/>
                  <a:gd name="T5" fmla="*/ 1196 h 75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600" h="7573" fill="none" extrusionOk="0">
                    <a:moveTo>
                      <a:pt x="21566" y="0"/>
                    </a:moveTo>
                    <a:cubicBezTo>
                      <a:pt x="21588" y="398"/>
                      <a:pt x="21600" y="797"/>
                      <a:pt x="21600" y="1196"/>
                    </a:cubicBezTo>
                    <a:cubicBezTo>
                      <a:pt x="21600" y="3357"/>
                      <a:pt x="21275" y="5507"/>
                      <a:pt x="20637" y="7573"/>
                    </a:cubicBezTo>
                  </a:path>
                  <a:path w="21600" h="7573" stroke="0" extrusionOk="0">
                    <a:moveTo>
                      <a:pt x="21566" y="0"/>
                    </a:moveTo>
                    <a:cubicBezTo>
                      <a:pt x="21588" y="398"/>
                      <a:pt x="21600" y="797"/>
                      <a:pt x="21600" y="1196"/>
                    </a:cubicBezTo>
                    <a:cubicBezTo>
                      <a:pt x="21600" y="3357"/>
                      <a:pt x="21275" y="5507"/>
                      <a:pt x="20637" y="7573"/>
                    </a:cubicBezTo>
                    <a:lnTo>
                      <a:pt x="0" y="1196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6" name="Arc 197"/>
              <p:cNvSpPr>
                <a:spLocks/>
              </p:cNvSpPr>
              <p:nvPr/>
            </p:nvSpPr>
            <p:spPr bwMode="auto">
              <a:xfrm>
                <a:off x="1723" y="2775"/>
                <a:ext cx="467" cy="305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20637 w 20637"/>
                  <a:gd name="T1" fmla="*/ 6377 h 13516"/>
                  <a:gd name="T2" fmla="*/ 16849 w 20637"/>
                  <a:gd name="T3" fmla="*/ 13516 h 13516"/>
                  <a:gd name="T4" fmla="*/ 0 w 20637"/>
                  <a:gd name="T5" fmla="*/ 0 h 135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637" h="13516" fill="none" extrusionOk="0">
                    <a:moveTo>
                      <a:pt x="20637" y="6377"/>
                    </a:moveTo>
                    <a:cubicBezTo>
                      <a:pt x="19834" y="8973"/>
                      <a:pt x="18549" y="11395"/>
                      <a:pt x="16848" y="13515"/>
                    </a:cubicBezTo>
                  </a:path>
                  <a:path w="20637" h="13516" stroke="0" extrusionOk="0">
                    <a:moveTo>
                      <a:pt x="20637" y="6377"/>
                    </a:moveTo>
                    <a:cubicBezTo>
                      <a:pt x="19834" y="8973"/>
                      <a:pt x="18549" y="11395"/>
                      <a:pt x="16848" y="13515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8" name="Line 199"/>
              <p:cNvSpPr>
                <a:spLocks noChangeShapeType="1"/>
              </p:cNvSpPr>
              <p:nvPr/>
            </p:nvSpPr>
            <p:spPr bwMode="auto">
              <a:xfrm>
                <a:off x="2184" y="2919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9" name="Rectangle 200"/>
              <p:cNvSpPr>
                <a:spLocks noChangeArrowheads="1"/>
              </p:cNvSpPr>
              <p:nvPr/>
            </p:nvSpPr>
            <p:spPr bwMode="auto">
              <a:xfrm rot="5100000">
                <a:off x="1396" y="3631"/>
                <a:ext cx="84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000" b="1" i="0" u="none" strike="noStrike" cap="none" normalizeH="0" baseline="0" dirty="0">
                    <a:ln>
                      <a:noFill/>
                    </a:ln>
                    <a:solidFill>
                      <a:schemeClr val="accent2"/>
                    </a:solidFill>
                    <a:effectLst/>
                    <a:cs typeface="Arial" panose="020B0604020202020204" pitchFamily="34" charset="0"/>
                  </a:rPr>
                  <a:t>D2/Taiwan/17221/2015</a:t>
                </a:r>
              </a:p>
            </p:txBody>
          </p:sp>
          <p:sp>
            <p:nvSpPr>
              <p:cNvPr id="390" name="Line 201"/>
              <p:cNvSpPr>
                <a:spLocks noChangeShapeType="1"/>
              </p:cNvSpPr>
              <p:nvPr/>
            </p:nvSpPr>
            <p:spPr bwMode="auto">
              <a:xfrm>
                <a:off x="1760" y="3257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1" name="Arc 202"/>
              <p:cNvSpPr>
                <a:spLocks/>
              </p:cNvSpPr>
              <p:nvPr/>
            </p:nvSpPr>
            <p:spPr bwMode="auto">
              <a:xfrm>
                <a:off x="1723" y="2775"/>
                <a:ext cx="467" cy="380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20637 w 20637"/>
                  <a:gd name="T1" fmla="*/ 6377 h 16837"/>
                  <a:gd name="T2" fmla="*/ 13530 w 20637"/>
                  <a:gd name="T3" fmla="*/ 16837 h 16837"/>
                  <a:gd name="T4" fmla="*/ 0 w 20637"/>
                  <a:gd name="T5" fmla="*/ 0 h 168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637" h="16837" fill="none" extrusionOk="0">
                    <a:moveTo>
                      <a:pt x="20637" y="6377"/>
                    </a:moveTo>
                    <a:cubicBezTo>
                      <a:pt x="19364" y="10494"/>
                      <a:pt x="16889" y="14137"/>
                      <a:pt x="13530" y="16837"/>
                    </a:cubicBezTo>
                  </a:path>
                  <a:path w="20637" h="16837" stroke="0" extrusionOk="0">
                    <a:moveTo>
                      <a:pt x="20637" y="6377"/>
                    </a:moveTo>
                    <a:cubicBezTo>
                      <a:pt x="19364" y="10494"/>
                      <a:pt x="16889" y="14137"/>
                      <a:pt x="13530" y="16837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2" name="Arc 203"/>
              <p:cNvSpPr>
                <a:spLocks/>
              </p:cNvSpPr>
              <p:nvPr/>
            </p:nvSpPr>
            <p:spPr bwMode="auto">
              <a:xfrm>
                <a:off x="1723" y="2775"/>
                <a:ext cx="306" cy="486"/>
              </a:xfrm>
              <a:custGeom>
                <a:avLst/>
                <a:gdLst>
                  <a:gd name="G0" fmla="+- 0 0 0"/>
                  <a:gd name="G1" fmla="+- 0 0 0"/>
                  <a:gd name="G2" fmla="+- 21600 0 0"/>
                  <a:gd name="T0" fmla="*/ 13530 w 13530"/>
                  <a:gd name="T1" fmla="*/ 16837 h 21538"/>
                  <a:gd name="T2" fmla="*/ 1633 w 13530"/>
                  <a:gd name="T3" fmla="*/ 21538 h 21538"/>
                  <a:gd name="T4" fmla="*/ 0 w 13530"/>
                  <a:gd name="T5" fmla="*/ 0 h 215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530" h="21538" fill="none" extrusionOk="0">
                    <a:moveTo>
                      <a:pt x="13530" y="16837"/>
                    </a:moveTo>
                    <a:cubicBezTo>
                      <a:pt x="10130" y="19569"/>
                      <a:pt x="5982" y="21208"/>
                      <a:pt x="1633" y="21538"/>
                    </a:cubicBezTo>
                  </a:path>
                  <a:path w="13530" h="21538" stroke="0" extrusionOk="0">
                    <a:moveTo>
                      <a:pt x="13530" y="16837"/>
                    </a:moveTo>
                    <a:cubicBezTo>
                      <a:pt x="10130" y="19569"/>
                      <a:pt x="5982" y="21208"/>
                      <a:pt x="1633" y="21538"/>
                    </a:cubicBez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Line 206"/>
            <p:cNvSpPr>
              <a:spLocks noChangeShapeType="1"/>
            </p:cNvSpPr>
            <p:nvPr/>
          </p:nvSpPr>
          <p:spPr bwMode="auto">
            <a:xfrm>
              <a:off x="2023" y="3155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207"/>
            <p:cNvSpPr>
              <a:spLocks noChangeArrowheads="1"/>
            </p:cNvSpPr>
            <p:nvPr/>
          </p:nvSpPr>
          <p:spPr bwMode="auto">
            <a:xfrm rot="16200000">
              <a:off x="1301" y="3853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7385/2015</a:t>
              </a:r>
            </a:p>
          </p:txBody>
        </p:sp>
        <p:sp>
          <p:nvSpPr>
            <p:cNvPr id="8" name="Line 208"/>
            <p:cNvSpPr>
              <a:spLocks noChangeShapeType="1"/>
            </p:cNvSpPr>
            <p:nvPr/>
          </p:nvSpPr>
          <p:spPr bwMode="auto">
            <a:xfrm>
              <a:off x="1717" y="3342"/>
              <a:ext cx="0" cy="1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angle 209"/>
            <p:cNvSpPr>
              <a:spLocks noChangeArrowheads="1"/>
            </p:cNvSpPr>
            <p:nvPr/>
          </p:nvSpPr>
          <p:spPr bwMode="auto">
            <a:xfrm rot="16500000">
              <a:off x="1162" y="4160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27222/2015</a:t>
              </a:r>
            </a:p>
          </p:txBody>
        </p:sp>
        <p:sp>
          <p:nvSpPr>
            <p:cNvPr id="10" name="Line 210"/>
            <p:cNvSpPr>
              <a:spLocks noChangeShapeType="1"/>
            </p:cNvSpPr>
            <p:nvPr/>
          </p:nvSpPr>
          <p:spPr bwMode="auto">
            <a:xfrm flipH="1">
              <a:off x="1615" y="3337"/>
              <a:ext cx="49" cy="47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Arc 211"/>
            <p:cNvSpPr>
              <a:spLocks/>
            </p:cNvSpPr>
            <p:nvPr/>
          </p:nvSpPr>
          <p:spPr bwMode="auto">
            <a:xfrm>
              <a:off x="1690" y="2774"/>
              <a:ext cx="33" cy="568"/>
            </a:xfrm>
            <a:custGeom>
              <a:avLst/>
              <a:gdLst>
                <a:gd name="G0" fmla="+- 1251 0 0"/>
                <a:gd name="G1" fmla="+- 0 0 0"/>
                <a:gd name="G2" fmla="+- 21600 0 0"/>
                <a:gd name="T0" fmla="*/ 1023 w 1251"/>
                <a:gd name="T1" fmla="*/ 21599 h 21599"/>
                <a:gd name="T2" fmla="*/ 0 w 1251"/>
                <a:gd name="T3" fmla="*/ 21564 h 21599"/>
                <a:gd name="T4" fmla="*/ 1251 w 1251"/>
                <a:gd name="T5" fmla="*/ 0 h 215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51" h="21599" fill="none" extrusionOk="0">
                  <a:moveTo>
                    <a:pt x="1023" y="21598"/>
                  </a:moveTo>
                  <a:cubicBezTo>
                    <a:pt x="681" y="21595"/>
                    <a:pt x="340" y="21583"/>
                    <a:pt x="0" y="21563"/>
                  </a:cubicBezTo>
                </a:path>
                <a:path w="1251" h="21599" stroke="0" extrusionOk="0">
                  <a:moveTo>
                    <a:pt x="1023" y="21598"/>
                  </a:moveTo>
                  <a:cubicBezTo>
                    <a:pt x="681" y="21595"/>
                    <a:pt x="340" y="21583"/>
                    <a:pt x="0" y="21563"/>
                  </a:cubicBezTo>
                  <a:lnTo>
                    <a:pt x="1251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Arc 212"/>
            <p:cNvSpPr>
              <a:spLocks/>
            </p:cNvSpPr>
            <p:nvPr/>
          </p:nvSpPr>
          <p:spPr bwMode="auto">
            <a:xfrm>
              <a:off x="1664" y="2774"/>
              <a:ext cx="59" cy="567"/>
            </a:xfrm>
            <a:custGeom>
              <a:avLst/>
              <a:gdLst>
                <a:gd name="G0" fmla="+- 2247 0 0"/>
                <a:gd name="G1" fmla="+- 0 0 0"/>
                <a:gd name="G2" fmla="+- 21600 0 0"/>
                <a:gd name="T0" fmla="*/ 996 w 2247"/>
                <a:gd name="T1" fmla="*/ 21564 h 21564"/>
                <a:gd name="T2" fmla="*/ 0 w 2247"/>
                <a:gd name="T3" fmla="*/ 21483 h 21564"/>
                <a:gd name="T4" fmla="*/ 2247 w 2247"/>
                <a:gd name="T5" fmla="*/ 0 h 215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47" h="21564" fill="none" extrusionOk="0">
                  <a:moveTo>
                    <a:pt x="996" y="21563"/>
                  </a:moveTo>
                  <a:cubicBezTo>
                    <a:pt x="663" y="21544"/>
                    <a:pt x="331" y="21517"/>
                    <a:pt x="0" y="21482"/>
                  </a:cubicBezTo>
                </a:path>
                <a:path w="2247" h="21564" stroke="0" extrusionOk="0">
                  <a:moveTo>
                    <a:pt x="996" y="21563"/>
                  </a:moveTo>
                  <a:cubicBezTo>
                    <a:pt x="663" y="21544"/>
                    <a:pt x="331" y="21517"/>
                    <a:pt x="0" y="21482"/>
                  </a:cubicBezTo>
                  <a:lnTo>
                    <a:pt x="2247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Line 214"/>
            <p:cNvSpPr>
              <a:spLocks noChangeShapeType="1"/>
            </p:cNvSpPr>
            <p:nvPr/>
          </p:nvSpPr>
          <p:spPr bwMode="auto">
            <a:xfrm flipH="1">
              <a:off x="1690" y="3257"/>
              <a:ext cx="6" cy="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215"/>
            <p:cNvSpPr>
              <a:spLocks noChangeArrowheads="1"/>
            </p:cNvSpPr>
            <p:nvPr/>
          </p:nvSpPr>
          <p:spPr bwMode="auto">
            <a:xfrm rot="16860000">
              <a:off x="1118" y="3671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24449/2015</a:t>
              </a:r>
            </a:p>
          </p:txBody>
        </p:sp>
        <p:sp>
          <p:nvSpPr>
            <p:cNvPr id="16" name="Line 216"/>
            <p:cNvSpPr>
              <a:spLocks noChangeShapeType="1"/>
            </p:cNvSpPr>
            <p:nvPr/>
          </p:nvSpPr>
          <p:spPr bwMode="auto">
            <a:xfrm flipH="1">
              <a:off x="1610" y="3251"/>
              <a:ext cx="16" cy="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217"/>
            <p:cNvSpPr>
              <a:spLocks noChangeArrowheads="1"/>
            </p:cNvSpPr>
            <p:nvPr/>
          </p:nvSpPr>
          <p:spPr bwMode="auto">
            <a:xfrm rot="17160000">
              <a:off x="1053" y="3585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8925/2015</a:t>
              </a:r>
            </a:p>
          </p:txBody>
        </p:sp>
        <p:sp>
          <p:nvSpPr>
            <p:cNvPr id="18" name="Line 218"/>
            <p:cNvSpPr>
              <a:spLocks noChangeShapeType="1"/>
            </p:cNvSpPr>
            <p:nvPr/>
          </p:nvSpPr>
          <p:spPr bwMode="auto">
            <a:xfrm>
              <a:off x="1583" y="3241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Arc 219"/>
            <p:cNvSpPr>
              <a:spLocks/>
            </p:cNvSpPr>
            <p:nvPr/>
          </p:nvSpPr>
          <p:spPr bwMode="auto">
            <a:xfrm>
              <a:off x="1605" y="2775"/>
              <a:ext cx="118" cy="478"/>
            </a:xfrm>
            <a:custGeom>
              <a:avLst/>
              <a:gdLst>
                <a:gd name="G0" fmla="+- 5239 0 0"/>
                <a:gd name="G1" fmla="+- 0 0 0"/>
                <a:gd name="G2" fmla="+- 21600 0 0"/>
                <a:gd name="T0" fmla="*/ 934 w 5239"/>
                <a:gd name="T1" fmla="*/ 21167 h 21167"/>
                <a:gd name="T2" fmla="*/ 0 w 5239"/>
                <a:gd name="T3" fmla="*/ 20955 h 21167"/>
                <a:gd name="T4" fmla="*/ 5239 w 5239"/>
                <a:gd name="T5" fmla="*/ 0 h 21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39" h="21167" fill="none" extrusionOk="0">
                  <a:moveTo>
                    <a:pt x="934" y="21166"/>
                  </a:moveTo>
                  <a:cubicBezTo>
                    <a:pt x="621" y="21103"/>
                    <a:pt x="309" y="21032"/>
                    <a:pt x="-1" y="20955"/>
                  </a:cubicBezTo>
                </a:path>
                <a:path w="5239" h="21167" stroke="0" extrusionOk="0">
                  <a:moveTo>
                    <a:pt x="934" y="21166"/>
                  </a:moveTo>
                  <a:cubicBezTo>
                    <a:pt x="621" y="21103"/>
                    <a:pt x="309" y="21032"/>
                    <a:pt x="-1" y="20955"/>
                  </a:cubicBezTo>
                  <a:lnTo>
                    <a:pt x="5239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Arc 220"/>
            <p:cNvSpPr>
              <a:spLocks/>
            </p:cNvSpPr>
            <p:nvPr/>
          </p:nvSpPr>
          <p:spPr bwMode="auto">
            <a:xfrm>
              <a:off x="1583" y="2775"/>
              <a:ext cx="140" cy="473"/>
            </a:xfrm>
            <a:custGeom>
              <a:avLst/>
              <a:gdLst>
                <a:gd name="G0" fmla="+- 6203 0 0"/>
                <a:gd name="G1" fmla="+- 0 0 0"/>
                <a:gd name="G2" fmla="+- 21600 0 0"/>
                <a:gd name="T0" fmla="*/ 964 w 6203"/>
                <a:gd name="T1" fmla="*/ 20955 h 20955"/>
                <a:gd name="T2" fmla="*/ 0 w 6203"/>
                <a:gd name="T3" fmla="*/ 20690 h 20955"/>
                <a:gd name="T4" fmla="*/ 6203 w 6203"/>
                <a:gd name="T5" fmla="*/ 0 h 209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03" h="20955" fill="none" extrusionOk="0">
                  <a:moveTo>
                    <a:pt x="963" y="20955"/>
                  </a:moveTo>
                  <a:cubicBezTo>
                    <a:pt x="640" y="20874"/>
                    <a:pt x="319" y="20785"/>
                    <a:pt x="-1" y="20690"/>
                  </a:cubicBezTo>
                </a:path>
                <a:path w="6203" h="20955" stroke="0" extrusionOk="0">
                  <a:moveTo>
                    <a:pt x="963" y="20955"/>
                  </a:moveTo>
                  <a:cubicBezTo>
                    <a:pt x="640" y="20874"/>
                    <a:pt x="319" y="20785"/>
                    <a:pt x="-1" y="20690"/>
                  </a:cubicBezTo>
                  <a:lnTo>
                    <a:pt x="6203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Line 222"/>
            <p:cNvSpPr>
              <a:spLocks noChangeShapeType="1"/>
            </p:cNvSpPr>
            <p:nvPr/>
          </p:nvSpPr>
          <p:spPr bwMode="auto">
            <a:xfrm>
              <a:off x="1605" y="3246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Arc 223"/>
            <p:cNvSpPr>
              <a:spLocks/>
            </p:cNvSpPr>
            <p:nvPr/>
          </p:nvSpPr>
          <p:spPr bwMode="auto">
            <a:xfrm>
              <a:off x="1648" y="2775"/>
              <a:ext cx="75" cy="487"/>
            </a:xfrm>
            <a:custGeom>
              <a:avLst/>
              <a:gdLst>
                <a:gd name="G0" fmla="+- 3314 0 0"/>
                <a:gd name="G1" fmla="+- 0 0 0"/>
                <a:gd name="G2" fmla="+- 21600 0 0"/>
                <a:gd name="T0" fmla="*/ 2121 w 3314"/>
                <a:gd name="T1" fmla="*/ 21567 h 21567"/>
                <a:gd name="T2" fmla="*/ 0 w 3314"/>
                <a:gd name="T3" fmla="*/ 21344 h 21567"/>
                <a:gd name="T4" fmla="*/ 3314 w 3314"/>
                <a:gd name="T5" fmla="*/ 0 h 215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14" h="21567" fill="none" extrusionOk="0">
                  <a:moveTo>
                    <a:pt x="2120" y="21567"/>
                  </a:moveTo>
                  <a:cubicBezTo>
                    <a:pt x="1410" y="21527"/>
                    <a:pt x="702" y="21453"/>
                    <a:pt x="-1" y="21344"/>
                  </a:cubicBezTo>
                </a:path>
                <a:path w="3314" h="21567" stroke="0" extrusionOk="0">
                  <a:moveTo>
                    <a:pt x="2120" y="21567"/>
                  </a:moveTo>
                  <a:cubicBezTo>
                    <a:pt x="1410" y="21527"/>
                    <a:pt x="702" y="21453"/>
                    <a:pt x="-1" y="21344"/>
                  </a:cubicBezTo>
                  <a:lnTo>
                    <a:pt x="3314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Arc 224"/>
            <p:cNvSpPr>
              <a:spLocks/>
            </p:cNvSpPr>
            <p:nvPr/>
          </p:nvSpPr>
          <p:spPr bwMode="auto">
            <a:xfrm>
              <a:off x="1605" y="2775"/>
              <a:ext cx="118" cy="482"/>
            </a:xfrm>
            <a:custGeom>
              <a:avLst/>
              <a:gdLst>
                <a:gd name="G0" fmla="+- 5239 0 0"/>
                <a:gd name="G1" fmla="+- 0 0 0"/>
                <a:gd name="G2" fmla="+- 21600 0 0"/>
                <a:gd name="T0" fmla="*/ 1925 w 5239"/>
                <a:gd name="T1" fmla="*/ 21344 h 21344"/>
                <a:gd name="T2" fmla="*/ 0 w 5239"/>
                <a:gd name="T3" fmla="*/ 20955 h 21344"/>
                <a:gd name="T4" fmla="*/ 5239 w 5239"/>
                <a:gd name="T5" fmla="*/ 0 h 213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39" h="21344" fill="none" extrusionOk="0">
                  <a:moveTo>
                    <a:pt x="1924" y="21344"/>
                  </a:moveTo>
                  <a:cubicBezTo>
                    <a:pt x="1277" y="21243"/>
                    <a:pt x="635" y="21113"/>
                    <a:pt x="-1" y="20955"/>
                  </a:cubicBezTo>
                </a:path>
                <a:path w="5239" h="21344" stroke="0" extrusionOk="0">
                  <a:moveTo>
                    <a:pt x="1924" y="21344"/>
                  </a:moveTo>
                  <a:cubicBezTo>
                    <a:pt x="1277" y="21243"/>
                    <a:pt x="635" y="21113"/>
                    <a:pt x="-1" y="20955"/>
                  </a:cubicBezTo>
                  <a:lnTo>
                    <a:pt x="5239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Line 226"/>
            <p:cNvSpPr>
              <a:spLocks noChangeShapeType="1"/>
            </p:cNvSpPr>
            <p:nvPr/>
          </p:nvSpPr>
          <p:spPr bwMode="auto">
            <a:xfrm>
              <a:off x="1648" y="3257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Arc 227"/>
            <p:cNvSpPr>
              <a:spLocks/>
            </p:cNvSpPr>
            <p:nvPr/>
          </p:nvSpPr>
          <p:spPr bwMode="auto">
            <a:xfrm>
              <a:off x="1723" y="2775"/>
              <a:ext cx="306" cy="471"/>
            </a:xfrm>
            <a:custGeom>
              <a:avLst/>
              <a:gdLst>
                <a:gd name="G0" fmla="+- 0 0 0"/>
                <a:gd name="G1" fmla="+- 0 0 0"/>
                <a:gd name="G2" fmla="+- 21600 0 0"/>
                <a:gd name="T0" fmla="*/ 13530 w 13530"/>
                <a:gd name="T1" fmla="*/ 16837 h 20847"/>
                <a:gd name="T2" fmla="*/ 5654 w 13530"/>
                <a:gd name="T3" fmla="*/ 20847 h 20847"/>
                <a:gd name="T4" fmla="*/ 0 w 13530"/>
                <a:gd name="T5" fmla="*/ 0 h 208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530" h="20847" fill="none" extrusionOk="0">
                  <a:moveTo>
                    <a:pt x="13530" y="16837"/>
                  </a:moveTo>
                  <a:cubicBezTo>
                    <a:pt x="11209" y="18702"/>
                    <a:pt x="8527" y="20067"/>
                    <a:pt x="5653" y="20846"/>
                  </a:cubicBezTo>
                </a:path>
                <a:path w="13530" h="20847" stroke="0" extrusionOk="0">
                  <a:moveTo>
                    <a:pt x="13530" y="16837"/>
                  </a:moveTo>
                  <a:cubicBezTo>
                    <a:pt x="11209" y="18702"/>
                    <a:pt x="8527" y="20067"/>
                    <a:pt x="5653" y="20846"/>
                  </a:cubicBezTo>
                  <a:lnTo>
                    <a:pt x="0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Arc 228"/>
            <p:cNvSpPr>
              <a:spLocks/>
            </p:cNvSpPr>
            <p:nvPr/>
          </p:nvSpPr>
          <p:spPr bwMode="auto">
            <a:xfrm>
              <a:off x="1648" y="2775"/>
              <a:ext cx="203" cy="488"/>
            </a:xfrm>
            <a:custGeom>
              <a:avLst/>
              <a:gdLst>
                <a:gd name="G0" fmla="+- 3314 0 0"/>
                <a:gd name="G1" fmla="+- 0 0 0"/>
                <a:gd name="G2" fmla="+- 21600 0 0"/>
                <a:gd name="T0" fmla="*/ 8968 w 8968"/>
                <a:gd name="T1" fmla="*/ 20847 h 21600"/>
                <a:gd name="T2" fmla="*/ 0 w 8968"/>
                <a:gd name="T3" fmla="*/ 21344 h 21600"/>
                <a:gd name="T4" fmla="*/ 3314 w 8968"/>
                <a:gd name="T5" fmla="*/ 0 h 21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968" h="21600" fill="none" extrusionOk="0">
                  <a:moveTo>
                    <a:pt x="8967" y="20846"/>
                  </a:moveTo>
                  <a:cubicBezTo>
                    <a:pt x="7124" y="21346"/>
                    <a:pt x="5223" y="21600"/>
                    <a:pt x="3314" y="21600"/>
                  </a:cubicBezTo>
                  <a:cubicBezTo>
                    <a:pt x="2204" y="21600"/>
                    <a:pt x="1096" y="21514"/>
                    <a:pt x="-1" y="21344"/>
                  </a:cubicBezTo>
                </a:path>
                <a:path w="8968" h="21600" stroke="0" extrusionOk="0">
                  <a:moveTo>
                    <a:pt x="8967" y="20846"/>
                  </a:moveTo>
                  <a:cubicBezTo>
                    <a:pt x="7124" y="21346"/>
                    <a:pt x="5223" y="21600"/>
                    <a:pt x="3314" y="21600"/>
                  </a:cubicBezTo>
                  <a:cubicBezTo>
                    <a:pt x="2204" y="21600"/>
                    <a:pt x="1096" y="21514"/>
                    <a:pt x="-1" y="21344"/>
                  </a:cubicBezTo>
                  <a:lnTo>
                    <a:pt x="3314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Line 230"/>
            <p:cNvSpPr>
              <a:spLocks noChangeShapeType="1"/>
            </p:cNvSpPr>
            <p:nvPr/>
          </p:nvSpPr>
          <p:spPr bwMode="auto">
            <a:xfrm>
              <a:off x="1846" y="3241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231"/>
            <p:cNvSpPr>
              <a:spLocks noChangeArrowheads="1"/>
            </p:cNvSpPr>
            <p:nvPr/>
          </p:nvSpPr>
          <p:spPr bwMode="auto">
            <a:xfrm rot="17460000">
              <a:off x="920" y="3698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6848/2015</a:t>
              </a:r>
            </a:p>
          </p:txBody>
        </p:sp>
        <p:sp>
          <p:nvSpPr>
            <p:cNvPr id="32" name="Line 232"/>
            <p:cNvSpPr>
              <a:spLocks noChangeShapeType="1"/>
            </p:cNvSpPr>
            <p:nvPr/>
          </p:nvSpPr>
          <p:spPr bwMode="auto">
            <a:xfrm flipH="1">
              <a:off x="1481" y="3225"/>
              <a:ext cx="59" cy="1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233"/>
            <p:cNvSpPr>
              <a:spLocks noChangeArrowheads="1"/>
            </p:cNvSpPr>
            <p:nvPr/>
          </p:nvSpPr>
          <p:spPr bwMode="auto">
            <a:xfrm rot="17820000">
              <a:off x="866" y="3583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6918/2015</a:t>
              </a:r>
            </a:p>
          </p:txBody>
        </p:sp>
        <p:sp>
          <p:nvSpPr>
            <p:cNvPr id="34" name="Line 234"/>
            <p:cNvSpPr>
              <a:spLocks noChangeShapeType="1"/>
            </p:cNvSpPr>
            <p:nvPr/>
          </p:nvSpPr>
          <p:spPr bwMode="auto">
            <a:xfrm flipH="1">
              <a:off x="1465" y="3208"/>
              <a:ext cx="32" cy="7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Arc 235"/>
            <p:cNvSpPr>
              <a:spLocks/>
            </p:cNvSpPr>
            <p:nvPr/>
          </p:nvSpPr>
          <p:spPr bwMode="auto">
            <a:xfrm>
              <a:off x="1519" y="2775"/>
              <a:ext cx="204" cy="452"/>
            </a:xfrm>
            <a:custGeom>
              <a:avLst/>
              <a:gdLst>
                <a:gd name="G0" fmla="+- 9003 0 0"/>
                <a:gd name="G1" fmla="+- 0 0 0"/>
                <a:gd name="G2" fmla="+- 21600 0 0"/>
                <a:gd name="T0" fmla="*/ 880 w 9003"/>
                <a:gd name="T1" fmla="*/ 20015 h 20015"/>
                <a:gd name="T2" fmla="*/ 0 w 9003"/>
                <a:gd name="T3" fmla="*/ 19634 h 20015"/>
                <a:gd name="T4" fmla="*/ 9003 w 9003"/>
                <a:gd name="T5" fmla="*/ 0 h 200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03" h="20015" fill="none" extrusionOk="0">
                  <a:moveTo>
                    <a:pt x="880" y="20014"/>
                  </a:moveTo>
                  <a:cubicBezTo>
                    <a:pt x="583" y="19894"/>
                    <a:pt x="290" y="19767"/>
                    <a:pt x="-1" y="19634"/>
                  </a:cubicBezTo>
                </a:path>
                <a:path w="9003" h="20015" stroke="0" extrusionOk="0">
                  <a:moveTo>
                    <a:pt x="880" y="20014"/>
                  </a:moveTo>
                  <a:cubicBezTo>
                    <a:pt x="583" y="19894"/>
                    <a:pt x="290" y="19767"/>
                    <a:pt x="-1" y="19634"/>
                  </a:cubicBezTo>
                  <a:lnTo>
                    <a:pt x="9003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Arc 236"/>
            <p:cNvSpPr>
              <a:spLocks/>
            </p:cNvSpPr>
            <p:nvPr/>
          </p:nvSpPr>
          <p:spPr bwMode="auto">
            <a:xfrm>
              <a:off x="1497" y="2775"/>
              <a:ext cx="226" cy="443"/>
            </a:xfrm>
            <a:custGeom>
              <a:avLst/>
              <a:gdLst>
                <a:gd name="G0" fmla="+- 9978 0 0"/>
                <a:gd name="G1" fmla="+- 0 0 0"/>
                <a:gd name="G2" fmla="+- 21600 0 0"/>
                <a:gd name="T0" fmla="*/ 975 w 9978"/>
                <a:gd name="T1" fmla="*/ 19634 h 19634"/>
                <a:gd name="T2" fmla="*/ 0 w 9978"/>
                <a:gd name="T3" fmla="*/ 19157 h 19634"/>
                <a:gd name="T4" fmla="*/ 9978 w 9978"/>
                <a:gd name="T5" fmla="*/ 0 h 196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78" h="19634" fill="none" extrusionOk="0">
                  <a:moveTo>
                    <a:pt x="974" y="19634"/>
                  </a:moveTo>
                  <a:cubicBezTo>
                    <a:pt x="645" y="19483"/>
                    <a:pt x="320" y="19324"/>
                    <a:pt x="-1" y="19157"/>
                  </a:cubicBezTo>
                </a:path>
                <a:path w="9978" h="19634" stroke="0" extrusionOk="0">
                  <a:moveTo>
                    <a:pt x="974" y="19634"/>
                  </a:moveTo>
                  <a:cubicBezTo>
                    <a:pt x="645" y="19483"/>
                    <a:pt x="320" y="19324"/>
                    <a:pt x="-1" y="19157"/>
                  </a:cubicBezTo>
                  <a:lnTo>
                    <a:pt x="9978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Line 238"/>
            <p:cNvSpPr>
              <a:spLocks noChangeShapeType="1"/>
            </p:cNvSpPr>
            <p:nvPr/>
          </p:nvSpPr>
          <p:spPr bwMode="auto">
            <a:xfrm>
              <a:off x="1519" y="3214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Arc 239"/>
            <p:cNvSpPr>
              <a:spLocks/>
            </p:cNvSpPr>
            <p:nvPr/>
          </p:nvSpPr>
          <p:spPr bwMode="auto">
            <a:xfrm>
              <a:off x="1685" y="2775"/>
              <a:ext cx="161" cy="483"/>
            </a:xfrm>
            <a:custGeom>
              <a:avLst/>
              <a:gdLst>
                <a:gd name="G0" fmla="+- 1696 0 0"/>
                <a:gd name="G1" fmla="+- 0 0 0"/>
                <a:gd name="G2" fmla="+- 21600 0 0"/>
                <a:gd name="T0" fmla="*/ 7203 w 7203"/>
                <a:gd name="T1" fmla="*/ 20886 h 21600"/>
                <a:gd name="T2" fmla="*/ 0 w 7203"/>
                <a:gd name="T3" fmla="*/ 21533 h 21600"/>
                <a:gd name="T4" fmla="*/ 1696 w 7203"/>
                <a:gd name="T5" fmla="*/ 0 h 21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03" h="21600" fill="none" extrusionOk="0">
                  <a:moveTo>
                    <a:pt x="7203" y="20886"/>
                  </a:moveTo>
                  <a:cubicBezTo>
                    <a:pt x="5405" y="21360"/>
                    <a:pt x="3554" y="21600"/>
                    <a:pt x="1696" y="21600"/>
                  </a:cubicBezTo>
                  <a:cubicBezTo>
                    <a:pt x="1130" y="21600"/>
                    <a:pt x="564" y="21577"/>
                    <a:pt x="-1" y="21533"/>
                  </a:cubicBezTo>
                </a:path>
                <a:path w="7203" h="21600" stroke="0" extrusionOk="0">
                  <a:moveTo>
                    <a:pt x="7203" y="20886"/>
                  </a:moveTo>
                  <a:cubicBezTo>
                    <a:pt x="5405" y="21360"/>
                    <a:pt x="3554" y="21600"/>
                    <a:pt x="1696" y="21600"/>
                  </a:cubicBezTo>
                  <a:cubicBezTo>
                    <a:pt x="1130" y="21600"/>
                    <a:pt x="564" y="21577"/>
                    <a:pt x="-1" y="21533"/>
                  </a:cubicBezTo>
                  <a:lnTo>
                    <a:pt x="1696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Arc 240"/>
            <p:cNvSpPr>
              <a:spLocks/>
            </p:cNvSpPr>
            <p:nvPr/>
          </p:nvSpPr>
          <p:spPr bwMode="auto">
            <a:xfrm>
              <a:off x="1524" y="2775"/>
              <a:ext cx="199" cy="481"/>
            </a:xfrm>
            <a:custGeom>
              <a:avLst/>
              <a:gdLst>
                <a:gd name="G0" fmla="+- 8910 0 0"/>
                <a:gd name="G1" fmla="+- 0 0 0"/>
                <a:gd name="G2" fmla="+- 21600 0 0"/>
                <a:gd name="T0" fmla="*/ 7214 w 8910"/>
                <a:gd name="T1" fmla="*/ 21533 h 21533"/>
                <a:gd name="T2" fmla="*/ 0 w 8910"/>
                <a:gd name="T3" fmla="*/ 19677 h 21533"/>
                <a:gd name="T4" fmla="*/ 8910 w 8910"/>
                <a:gd name="T5" fmla="*/ 0 h 215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910" h="21533" fill="none" extrusionOk="0">
                  <a:moveTo>
                    <a:pt x="7213" y="21533"/>
                  </a:moveTo>
                  <a:cubicBezTo>
                    <a:pt x="4719" y="21336"/>
                    <a:pt x="2279" y="20708"/>
                    <a:pt x="0" y="19676"/>
                  </a:cubicBezTo>
                </a:path>
                <a:path w="8910" h="21533" stroke="0" extrusionOk="0">
                  <a:moveTo>
                    <a:pt x="7213" y="21533"/>
                  </a:moveTo>
                  <a:cubicBezTo>
                    <a:pt x="4719" y="21336"/>
                    <a:pt x="2279" y="20708"/>
                    <a:pt x="0" y="19676"/>
                  </a:cubicBezTo>
                  <a:lnTo>
                    <a:pt x="8910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Line 242"/>
            <p:cNvSpPr>
              <a:spLocks noChangeShapeType="1"/>
            </p:cNvSpPr>
            <p:nvPr/>
          </p:nvSpPr>
          <p:spPr bwMode="auto">
            <a:xfrm>
              <a:off x="1680" y="3257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243"/>
            <p:cNvSpPr>
              <a:spLocks noChangeArrowheads="1"/>
            </p:cNvSpPr>
            <p:nvPr/>
          </p:nvSpPr>
          <p:spPr bwMode="auto">
            <a:xfrm rot="18120000">
              <a:off x="742" y="3615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D2/Taiwan/21890/2015</a:t>
              </a:r>
            </a:p>
          </p:txBody>
        </p:sp>
        <p:sp>
          <p:nvSpPr>
            <p:cNvPr id="44" name="Line 244"/>
            <p:cNvSpPr>
              <a:spLocks noChangeShapeType="1"/>
            </p:cNvSpPr>
            <p:nvPr/>
          </p:nvSpPr>
          <p:spPr bwMode="auto">
            <a:xfrm flipH="1">
              <a:off x="1374" y="3187"/>
              <a:ext cx="91" cy="1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tangle 245"/>
            <p:cNvSpPr>
              <a:spLocks noChangeArrowheads="1"/>
            </p:cNvSpPr>
            <p:nvPr/>
          </p:nvSpPr>
          <p:spPr bwMode="auto">
            <a:xfrm rot="18420000">
              <a:off x="711" y="3494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D2/Taiwan/23573/2015</a:t>
              </a:r>
            </a:p>
          </p:txBody>
        </p:sp>
        <p:sp>
          <p:nvSpPr>
            <p:cNvPr id="46" name="Line 246"/>
            <p:cNvSpPr>
              <a:spLocks noChangeShapeType="1"/>
            </p:cNvSpPr>
            <p:nvPr/>
          </p:nvSpPr>
          <p:spPr bwMode="auto">
            <a:xfrm flipH="1">
              <a:off x="1374" y="3155"/>
              <a:ext cx="53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Arc 247"/>
            <p:cNvSpPr>
              <a:spLocks/>
            </p:cNvSpPr>
            <p:nvPr/>
          </p:nvSpPr>
          <p:spPr bwMode="auto">
            <a:xfrm>
              <a:off x="1445" y="2775"/>
              <a:ext cx="278" cy="408"/>
            </a:xfrm>
            <a:custGeom>
              <a:avLst/>
              <a:gdLst>
                <a:gd name="G0" fmla="+- 12432 0 0"/>
                <a:gd name="G1" fmla="+- 0 0 0"/>
                <a:gd name="G2" fmla="+- 21600 0 0"/>
                <a:gd name="T0" fmla="*/ 876 w 12432"/>
                <a:gd name="T1" fmla="*/ 18249 h 18249"/>
                <a:gd name="T2" fmla="*/ 0 w 12432"/>
                <a:gd name="T3" fmla="*/ 17664 h 18249"/>
                <a:gd name="T4" fmla="*/ 12432 w 12432"/>
                <a:gd name="T5" fmla="*/ 0 h 182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432" h="18249" fill="none" extrusionOk="0">
                  <a:moveTo>
                    <a:pt x="876" y="18248"/>
                  </a:moveTo>
                  <a:cubicBezTo>
                    <a:pt x="579" y="18060"/>
                    <a:pt x="287" y="17865"/>
                    <a:pt x="0" y="17663"/>
                  </a:cubicBezTo>
                </a:path>
                <a:path w="12432" h="18249" stroke="0" extrusionOk="0">
                  <a:moveTo>
                    <a:pt x="876" y="18248"/>
                  </a:moveTo>
                  <a:cubicBezTo>
                    <a:pt x="579" y="18060"/>
                    <a:pt x="287" y="17865"/>
                    <a:pt x="0" y="17663"/>
                  </a:cubicBezTo>
                  <a:lnTo>
                    <a:pt x="12432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Arc 248"/>
            <p:cNvSpPr>
              <a:spLocks/>
            </p:cNvSpPr>
            <p:nvPr/>
          </p:nvSpPr>
          <p:spPr bwMode="auto">
            <a:xfrm>
              <a:off x="1426" y="2775"/>
              <a:ext cx="297" cy="395"/>
            </a:xfrm>
            <a:custGeom>
              <a:avLst/>
              <a:gdLst>
                <a:gd name="G0" fmla="+- 13265 0 0"/>
                <a:gd name="G1" fmla="+- 0 0 0"/>
                <a:gd name="G2" fmla="+- 21600 0 0"/>
                <a:gd name="T0" fmla="*/ 833 w 13265"/>
                <a:gd name="T1" fmla="*/ 17664 h 17664"/>
                <a:gd name="T2" fmla="*/ 0 w 13265"/>
                <a:gd name="T3" fmla="*/ 17047 h 17664"/>
                <a:gd name="T4" fmla="*/ 13265 w 13265"/>
                <a:gd name="T5" fmla="*/ 0 h 176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265" h="17664" fill="none" extrusionOk="0">
                  <a:moveTo>
                    <a:pt x="833" y="17663"/>
                  </a:moveTo>
                  <a:cubicBezTo>
                    <a:pt x="550" y="17464"/>
                    <a:pt x="272" y="17259"/>
                    <a:pt x="0" y="17046"/>
                  </a:cubicBezTo>
                </a:path>
                <a:path w="13265" h="17664" stroke="0" extrusionOk="0">
                  <a:moveTo>
                    <a:pt x="833" y="17663"/>
                  </a:moveTo>
                  <a:cubicBezTo>
                    <a:pt x="550" y="17464"/>
                    <a:pt x="272" y="17259"/>
                    <a:pt x="0" y="17046"/>
                  </a:cubicBezTo>
                  <a:lnTo>
                    <a:pt x="13265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Line 250"/>
            <p:cNvSpPr>
              <a:spLocks noChangeShapeType="1"/>
            </p:cNvSpPr>
            <p:nvPr/>
          </p:nvSpPr>
          <p:spPr bwMode="auto">
            <a:xfrm>
              <a:off x="1444" y="3171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Arc 251"/>
            <p:cNvSpPr>
              <a:spLocks/>
            </p:cNvSpPr>
            <p:nvPr/>
          </p:nvSpPr>
          <p:spPr bwMode="auto">
            <a:xfrm>
              <a:off x="1557" y="2775"/>
              <a:ext cx="166" cy="481"/>
            </a:xfrm>
            <a:custGeom>
              <a:avLst/>
              <a:gdLst>
                <a:gd name="G0" fmla="+- 7436 0 0"/>
                <a:gd name="G1" fmla="+- 0 0 0"/>
                <a:gd name="G2" fmla="+- 21600 0 0"/>
                <a:gd name="T0" fmla="*/ 5740 w 7436"/>
                <a:gd name="T1" fmla="*/ 21533 h 21533"/>
                <a:gd name="T2" fmla="*/ 0 w 7436"/>
                <a:gd name="T3" fmla="*/ 20280 h 21533"/>
                <a:gd name="T4" fmla="*/ 7436 w 7436"/>
                <a:gd name="T5" fmla="*/ 0 h 215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36" h="21533" fill="none" extrusionOk="0">
                  <a:moveTo>
                    <a:pt x="5739" y="21533"/>
                  </a:moveTo>
                  <a:cubicBezTo>
                    <a:pt x="3778" y="21378"/>
                    <a:pt x="1847" y="20957"/>
                    <a:pt x="0" y="20279"/>
                  </a:cubicBezTo>
                </a:path>
                <a:path w="7436" h="21533" stroke="0" extrusionOk="0">
                  <a:moveTo>
                    <a:pt x="5739" y="21533"/>
                  </a:moveTo>
                  <a:cubicBezTo>
                    <a:pt x="3778" y="21378"/>
                    <a:pt x="1847" y="20957"/>
                    <a:pt x="0" y="20279"/>
                  </a:cubicBezTo>
                  <a:lnTo>
                    <a:pt x="7436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Arc 252"/>
            <p:cNvSpPr>
              <a:spLocks/>
            </p:cNvSpPr>
            <p:nvPr/>
          </p:nvSpPr>
          <p:spPr bwMode="auto">
            <a:xfrm>
              <a:off x="1445" y="2775"/>
              <a:ext cx="278" cy="453"/>
            </a:xfrm>
            <a:custGeom>
              <a:avLst/>
              <a:gdLst>
                <a:gd name="G0" fmla="+- 12432 0 0"/>
                <a:gd name="G1" fmla="+- 0 0 0"/>
                <a:gd name="G2" fmla="+- 21600 0 0"/>
                <a:gd name="T0" fmla="*/ 4996 w 12432"/>
                <a:gd name="T1" fmla="*/ 20280 h 20280"/>
                <a:gd name="T2" fmla="*/ 0 w 12432"/>
                <a:gd name="T3" fmla="*/ 17664 h 20280"/>
                <a:gd name="T4" fmla="*/ 12432 w 12432"/>
                <a:gd name="T5" fmla="*/ 0 h 20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432" h="20280" fill="none" extrusionOk="0">
                  <a:moveTo>
                    <a:pt x="4996" y="20279"/>
                  </a:moveTo>
                  <a:cubicBezTo>
                    <a:pt x="3223" y="19629"/>
                    <a:pt x="1543" y="18750"/>
                    <a:pt x="0" y="17663"/>
                  </a:cubicBezTo>
                </a:path>
                <a:path w="12432" h="20280" stroke="0" extrusionOk="0">
                  <a:moveTo>
                    <a:pt x="4996" y="20279"/>
                  </a:moveTo>
                  <a:cubicBezTo>
                    <a:pt x="3223" y="19629"/>
                    <a:pt x="1543" y="18750"/>
                    <a:pt x="0" y="17663"/>
                  </a:cubicBezTo>
                  <a:lnTo>
                    <a:pt x="12432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Line 254"/>
            <p:cNvSpPr>
              <a:spLocks noChangeShapeType="1"/>
            </p:cNvSpPr>
            <p:nvPr/>
          </p:nvSpPr>
          <p:spPr bwMode="auto">
            <a:xfrm>
              <a:off x="1556" y="323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ectangle 255"/>
            <p:cNvSpPr>
              <a:spLocks noChangeArrowheads="1"/>
            </p:cNvSpPr>
            <p:nvPr/>
          </p:nvSpPr>
          <p:spPr bwMode="auto">
            <a:xfrm rot="18780000">
              <a:off x="585" y="3493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8217/2015</a:t>
              </a:r>
            </a:p>
          </p:txBody>
        </p:sp>
        <p:sp>
          <p:nvSpPr>
            <p:cNvPr id="56" name="Line 256"/>
            <p:cNvSpPr>
              <a:spLocks noChangeShapeType="1"/>
            </p:cNvSpPr>
            <p:nvPr/>
          </p:nvSpPr>
          <p:spPr bwMode="auto">
            <a:xfrm flipH="1">
              <a:off x="1283" y="3128"/>
              <a:ext cx="112" cy="1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Rectangle 257"/>
            <p:cNvSpPr>
              <a:spLocks noChangeArrowheads="1"/>
            </p:cNvSpPr>
            <p:nvPr/>
          </p:nvSpPr>
          <p:spPr bwMode="auto">
            <a:xfrm rot="19080000">
              <a:off x="573" y="3370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D2/Taiwan/21321/2015</a:t>
              </a:r>
            </a:p>
          </p:txBody>
        </p:sp>
        <p:sp>
          <p:nvSpPr>
            <p:cNvPr id="58" name="Line 258"/>
            <p:cNvSpPr>
              <a:spLocks noChangeShapeType="1"/>
            </p:cNvSpPr>
            <p:nvPr/>
          </p:nvSpPr>
          <p:spPr bwMode="auto">
            <a:xfrm flipH="1">
              <a:off x="1299" y="3096"/>
              <a:ext cx="59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Arc 259"/>
            <p:cNvSpPr>
              <a:spLocks/>
            </p:cNvSpPr>
            <p:nvPr/>
          </p:nvSpPr>
          <p:spPr bwMode="auto">
            <a:xfrm>
              <a:off x="1378" y="2775"/>
              <a:ext cx="345" cy="351"/>
            </a:xfrm>
            <a:custGeom>
              <a:avLst/>
              <a:gdLst>
                <a:gd name="G0" fmla="+- 15422 0 0"/>
                <a:gd name="G1" fmla="+- 0 0 0"/>
                <a:gd name="G2" fmla="+- 21600 0 0"/>
                <a:gd name="T0" fmla="*/ 608 w 15422"/>
                <a:gd name="T1" fmla="*/ 15720 h 15720"/>
                <a:gd name="T2" fmla="*/ 0 w 15422"/>
                <a:gd name="T3" fmla="*/ 15124 h 15720"/>
                <a:gd name="T4" fmla="*/ 15422 w 15422"/>
                <a:gd name="T5" fmla="*/ 0 h 157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22" h="15720" fill="none" extrusionOk="0">
                  <a:moveTo>
                    <a:pt x="608" y="15719"/>
                  </a:moveTo>
                  <a:cubicBezTo>
                    <a:pt x="401" y="15525"/>
                    <a:pt x="198" y="15326"/>
                    <a:pt x="0" y="15123"/>
                  </a:cubicBezTo>
                </a:path>
                <a:path w="15422" h="15720" stroke="0" extrusionOk="0">
                  <a:moveTo>
                    <a:pt x="608" y="15719"/>
                  </a:moveTo>
                  <a:cubicBezTo>
                    <a:pt x="401" y="15525"/>
                    <a:pt x="198" y="15326"/>
                    <a:pt x="0" y="15123"/>
                  </a:cubicBezTo>
                  <a:lnTo>
                    <a:pt x="15422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Arc 260"/>
            <p:cNvSpPr>
              <a:spLocks/>
            </p:cNvSpPr>
            <p:nvPr/>
          </p:nvSpPr>
          <p:spPr bwMode="auto">
            <a:xfrm>
              <a:off x="1363" y="2775"/>
              <a:ext cx="360" cy="338"/>
            </a:xfrm>
            <a:custGeom>
              <a:avLst/>
              <a:gdLst>
                <a:gd name="G0" fmla="+- 16114 0 0"/>
                <a:gd name="G1" fmla="+- 0 0 0"/>
                <a:gd name="G2" fmla="+- 21600 0 0"/>
                <a:gd name="T0" fmla="*/ 692 w 16114"/>
                <a:gd name="T1" fmla="*/ 15124 h 15124"/>
                <a:gd name="T2" fmla="*/ 0 w 16114"/>
                <a:gd name="T3" fmla="*/ 14384 h 15124"/>
                <a:gd name="T4" fmla="*/ 16114 w 16114"/>
                <a:gd name="T5" fmla="*/ 0 h 15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114" h="15124" fill="none" extrusionOk="0">
                  <a:moveTo>
                    <a:pt x="692" y="15123"/>
                  </a:moveTo>
                  <a:cubicBezTo>
                    <a:pt x="455" y="14882"/>
                    <a:pt x="224" y="14635"/>
                    <a:pt x="0" y="14383"/>
                  </a:cubicBezTo>
                </a:path>
                <a:path w="16114" h="15124" stroke="0" extrusionOk="0">
                  <a:moveTo>
                    <a:pt x="692" y="15123"/>
                  </a:moveTo>
                  <a:cubicBezTo>
                    <a:pt x="455" y="14882"/>
                    <a:pt x="224" y="14635"/>
                    <a:pt x="0" y="14383"/>
                  </a:cubicBezTo>
                  <a:lnTo>
                    <a:pt x="16114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Line 262"/>
            <p:cNvSpPr>
              <a:spLocks noChangeShapeType="1"/>
            </p:cNvSpPr>
            <p:nvPr/>
          </p:nvSpPr>
          <p:spPr bwMode="auto">
            <a:xfrm>
              <a:off x="1374" y="3112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Arc 263"/>
            <p:cNvSpPr>
              <a:spLocks/>
            </p:cNvSpPr>
            <p:nvPr/>
          </p:nvSpPr>
          <p:spPr bwMode="auto">
            <a:xfrm>
              <a:off x="1462" y="2775"/>
              <a:ext cx="261" cy="453"/>
            </a:xfrm>
            <a:custGeom>
              <a:avLst/>
              <a:gdLst>
                <a:gd name="G0" fmla="+- 11679 0 0"/>
                <a:gd name="G1" fmla="+- 0 0 0"/>
                <a:gd name="G2" fmla="+- 21600 0 0"/>
                <a:gd name="T0" fmla="*/ 4243 w 11679"/>
                <a:gd name="T1" fmla="*/ 20280 h 20280"/>
                <a:gd name="T2" fmla="*/ 0 w 11679"/>
                <a:gd name="T3" fmla="*/ 18171 h 20280"/>
                <a:gd name="T4" fmla="*/ 11679 w 11679"/>
                <a:gd name="T5" fmla="*/ 0 h 20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79" h="20280" fill="none" extrusionOk="0">
                  <a:moveTo>
                    <a:pt x="4243" y="20279"/>
                  </a:moveTo>
                  <a:cubicBezTo>
                    <a:pt x="2755" y="19734"/>
                    <a:pt x="1332" y="19027"/>
                    <a:pt x="0" y="18170"/>
                  </a:cubicBezTo>
                </a:path>
                <a:path w="11679" h="20280" stroke="0" extrusionOk="0">
                  <a:moveTo>
                    <a:pt x="4243" y="20279"/>
                  </a:moveTo>
                  <a:cubicBezTo>
                    <a:pt x="2755" y="19734"/>
                    <a:pt x="1332" y="19027"/>
                    <a:pt x="0" y="18170"/>
                  </a:cubicBezTo>
                  <a:lnTo>
                    <a:pt x="11679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Arc 264"/>
            <p:cNvSpPr>
              <a:spLocks/>
            </p:cNvSpPr>
            <p:nvPr/>
          </p:nvSpPr>
          <p:spPr bwMode="auto">
            <a:xfrm>
              <a:off x="1378" y="2775"/>
              <a:ext cx="345" cy="406"/>
            </a:xfrm>
            <a:custGeom>
              <a:avLst/>
              <a:gdLst>
                <a:gd name="G0" fmla="+- 15422 0 0"/>
                <a:gd name="G1" fmla="+- 0 0 0"/>
                <a:gd name="G2" fmla="+- 21600 0 0"/>
                <a:gd name="T0" fmla="*/ 3743 w 15422"/>
                <a:gd name="T1" fmla="*/ 18171 h 18171"/>
                <a:gd name="T2" fmla="*/ 0 w 15422"/>
                <a:gd name="T3" fmla="*/ 15124 h 18171"/>
                <a:gd name="T4" fmla="*/ 15422 w 15422"/>
                <a:gd name="T5" fmla="*/ 0 h 18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22" h="18171" fill="none" extrusionOk="0">
                  <a:moveTo>
                    <a:pt x="3743" y="18170"/>
                  </a:moveTo>
                  <a:cubicBezTo>
                    <a:pt x="2385" y="17297"/>
                    <a:pt x="1130" y="16276"/>
                    <a:pt x="0" y="15123"/>
                  </a:cubicBezTo>
                </a:path>
                <a:path w="15422" h="18171" stroke="0" extrusionOk="0">
                  <a:moveTo>
                    <a:pt x="3743" y="18170"/>
                  </a:moveTo>
                  <a:cubicBezTo>
                    <a:pt x="2385" y="17297"/>
                    <a:pt x="1130" y="16276"/>
                    <a:pt x="0" y="15123"/>
                  </a:cubicBezTo>
                  <a:lnTo>
                    <a:pt x="15422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Line 266"/>
            <p:cNvSpPr>
              <a:spLocks noChangeShapeType="1"/>
            </p:cNvSpPr>
            <p:nvPr/>
          </p:nvSpPr>
          <p:spPr bwMode="auto">
            <a:xfrm>
              <a:off x="1460" y="3182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ectangle 267"/>
            <p:cNvSpPr>
              <a:spLocks noChangeArrowheads="1"/>
            </p:cNvSpPr>
            <p:nvPr/>
          </p:nvSpPr>
          <p:spPr bwMode="auto">
            <a:xfrm rot="19380000">
              <a:off x="403" y="3396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7067/2015</a:t>
              </a:r>
            </a:p>
          </p:txBody>
        </p:sp>
        <p:sp>
          <p:nvSpPr>
            <p:cNvPr id="68" name="Line 268"/>
            <p:cNvSpPr>
              <a:spLocks noChangeShapeType="1"/>
            </p:cNvSpPr>
            <p:nvPr/>
          </p:nvSpPr>
          <p:spPr bwMode="auto">
            <a:xfrm flipH="1">
              <a:off x="1138" y="3107"/>
              <a:ext cx="128" cy="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tangle 269"/>
            <p:cNvSpPr>
              <a:spLocks noChangeArrowheads="1"/>
            </p:cNvSpPr>
            <p:nvPr/>
          </p:nvSpPr>
          <p:spPr bwMode="auto">
            <a:xfrm rot="19740000">
              <a:off x="472" y="3229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D2/Taiwan/19966/2015</a:t>
              </a:r>
            </a:p>
          </p:txBody>
        </p:sp>
        <p:sp>
          <p:nvSpPr>
            <p:cNvPr id="70" name="Line 270"/>
            <p:cNvSpPr>
              <a:spLocks noChangeShapeType="1"/>
            </p:cNvSpPr>
            <p:nvPr/>
          </p:nvSpPr>
          <p:spPr bwMode="auto">
            <a:xfrm>
              <a:off x="1240" y="3058"/>
              <a:ext cx="0" cy="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Arc 271"/>
            <p:cNvSpPr>
              <a:spLocks/>
            </p:cNvSpPr>
            <p:nvPr/>
          </p:nvSpPr>
          <p:spPr bwMode="auto">
            <a:xfrm>
              <a:off x="1254" y="2775"/>
              <a:ext cx="469" cy="330"/>
            </a:xfrm>
            <a:custGeom>
              <a:avLst/>
              <a:gdLst>
                <a:gd name="G0" fmla="+- 17986 0 0"/>
                <a:gd name="G1" fmla="+- 0 0 0"/>
                <a:gd name="G2" fmla="+- 21600 0 0"/>
                <a:gd name="T0" fmla="*/ 491 w 17986"/>
                <a:gd name="T1" fmla="*/ 12668 h 12668"/>
                <a:gd name="T2" fmla="*/ 0 w 17986"/>
                <a:gd name="T3" fmla="*/ 11961 h 12668"/>
                <a:gd name="T4" fmla="*/ 17986 w 17986"/>
                <a:gd name="T5" fmla="*/ 0 h 126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986" h="12668" fill="none" extrusionOk="0">
                  <a:moveTo>
                    <a:pt x="490" y="12668"/>
                  </a:moveTo>
                  <a:cubicBezTo>
                    <a:pt x="322" y="12435"/>
                    <a:pt x="158" y="12199"/>
                    <a:pt x="0" y="11960"/>
                  </a:cubicBezTo>
                </a:path>
                <a:path w="17986" h="12668" stroke="0" extrusionOk="0">
                  <a:moveTo>
                    <a:pt x="490" y="12668"/>
                  </a:moveTo>
                  <a:cubicBezTo>
                    <a:pt x="322" y="12435"/>
                    <a:pt x="158" y="12199"/>
                    <a:pt x="0" y="11960"/>
                  </a:cubicBezTo>
                  <a:lnTo>
                    <a:pt x="17986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Arc 272"/>
            <p:cNvSpPr>
              <a:spLocks/>
            </p:cNvSpPr>
            <p:nvPr/>
          </p:nvSpPr>
          <p:spPr bwMode="auto">
            <a:xfrm>
              <a:off x="1238" y="2775"/>
              <a:ext cx="485" cy="311"/>
            </a:xfrm>
            <a:custGeom>
              <a:avLst/>
              <a:gdLst>
                <a:gd name="G0" fmla="+- 18578 0 0"/>
                <a:gd name="G1" fmla="+- 0 0 0"/>
                <a:gd name="G2" fmla="+- 21600 0 0"/>
                <a:gd name="T0" fmla="*/ 592 w 18578"/>
                <a:gd name="T1" fmla="*/ 11961 h 11961"/>
                <a:gd name="T2" fmla="*/ 0 w 18578"/>
                <a:gd name="T3" fmla="*/ 11019 h 11961"/>
                <a:gd name="T4" fmla="*/ 18578 w 18578"/>
                <a:gd name="T5" fmla="*/ 0 h 119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578" h="11961" fill="none" extrusionOk="0">
                  <a:moveTo>
                    <a:pt x="592" y="11960"/>
                  </a:moveTo>
                  <a:cubicBezTo>
                    <a:pt x="386" y="11652"/>
                    <a:pt x="189" y="11338"/>
                    <a:pt x="0" y="11018"/>
                  </a:cubicBezTo>
                </a:path>
                <a:path w="18578" h="11961" stroke="0" extrusionOk="0">
                  <a:moveTo>
                    <a:pt x="592" y="11960"/>
                  </a:moveTo>
                  <a:cubicBezTo>
                    <a:pt x="386" y="11652"/>
                    <a:pt x="189" y="11338"/>
                    <a:pt x="0" y="11018"/>
                  </a:cubicBezTo>
                  <a:lnTo>
                    <a:pt x="18578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Line 274"/>
            <p:cNvSpPr>
              <a:spLocks noChangeShapeType="1"/>
            </p:cNvSpPr>
            <p:nvPr/>
          </p:nvSpPr>
          <p:spPr bwMode="auto">
            <a:xfrm flipH="1">
              <a:off x="1250" y="3037"/>
              <a:ext cx="70" cy="4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Rectangle 275"/>
            <p:cNvSpPr>
              <a:spLocks noChangeArrowheads="1"/>
            </p:cNvSpPr>
            <p:nvPr/>
          </p:nvSpPr>
          <p:spPr bwMode="auto">
            <a:xfrm rot="20040000">
              <a:off x="435" y="3154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31689/2015</a:t>
              </a:r>
            </a:p>
          </p:txBody>
        </p:sp>
        <p:sp>
          <p:nvSpPr>
            <p:cNvPr id="76" name="Line 276"/>
            <p:cNvSpPr>
              <a:spLocks noChangeShapeType="1"/>
            </p:cNvSpPr>
            <p:nvPr/>
          </p:nvSpPr>
          <p:spPr bwMode="auto">
            <a:xfrm flipH="1">
              <a:off x="1213" y="2989"/>
              <a:ext cx="75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Rectangle 277"/>
            <p:cNvSpPr>
              <a:spLocks noChangeArrowheads="1"/>
            </p:cNvSpPr>
            <p:nvPr/>
          </p:nvSpPr>
          <p:spPr bwMode="auto">
            <a:xfrm rot="20340000">
              <a:off x="472" y="3043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7640/2015</a:t>
              </a:r>
            </a:p>
          </p:txBody>
        </p:sp>
        <p:sp>
          <p:nvSpPr>
            <p:cNvPr id="78" name="Line 278"/>
            <p:cNvSpPr>
              <a:spLocks noChangeShapeType="1"/>
            </p:cNvSpPr>
            <p:nvPr/>
          </p:nvSpPr>
          <p:spPr bwMode="auto">
            <a:xfrm>
              <a:off x="1266" y="2941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279"/>
            <p:cNvSpPr>
              <a:spLocks noChangeArrowheads="1"/>
            </p:cNvSpPr>
            <p:nvPr/>
          </p:nvSpPr>
          <p:spPr bwMode="auto">
            <a:xfrm rot="20700000">
              <a:off x="212" y="3024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D2/Taiwan/22089/2015</a:t>
              </a:r>
            </a:p>
          </p:txBody>
        </p:sp>
        <p:sp>
          <p:nvSpPr>
            <p:cNvPr id="80" name="Line 280"/>
            <p:cNvSpPr>
              <a:spLocks noChangeShapeType="1"/>
            </p:cNvSpPr>
            <p:nvPr/>
          </p:nvSpPr>
          <p:spPr bwMode="auto">
            <a:xfrm flipH="1">
              <a:off x="1020" y="2903"/>
              <a:ext cx="23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Arc 281"/>
            <p:cNvSpPr>
              <a:spLocks/>
            </p:cNvSpPr>
            <p:nvPr/>
          </p:nvSpPr>
          <p:spPr bwMode="auto">
            <a:xfrm>
              <a:off x="1258" y="2775"/>
              <a:ext cx="465" cy="171"/>
            </a:xfrm>
            <a:custGeom>
              <a:avLst/>
              <a:gdLst>
                <a:gd name="G0" fmla="+- 20574 0 0"/>
                <a:gd name="G1" fmla="+- 0 0 0"/>
                <a:gd name="G2" fmla="+- 21600 0 0"/>
                <a:gd name="T0" fmla="*/ 349 w 20574"/>
                <a:gd name="T1" fmla="*/ 7583 h 7583"/>
                <a:gd name="T2" fmla="*/ 0 w 20574"/>
                <a:gd name="T3" fmla="*/ 6578 h 7583"/>
                <a:gd name="T4" fmla="*/ 20574 w 20574"/>
                <a:gd name="T5" fmla="*/ 0 h 75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574" h="7583" fill="none" extrusionOk="0">
                  <a:moveTo>
                    <a:pt x="348" y="7583"/>
                  </a:moveTo>
                  <a:cubicBezTo>
                    <a:pt x="224" y="7250"/>
                    <a:pt x="108" y="6915"/>
                    <a:pt x="-1" y="6578"/>
                  </a:cubicBezTo>
                </a:path>
                <a:path w="20574" h="7583" stroke="0" extrusionOk="0">
                  <a:moveTo>
                    <a:pt x="348" y="7583"/>
                  </a:moveTo>
                  <a:cubicBezTo>
                    <a:pt x="224" y="7250"/>
                    <a:pt x="108" y="6915"/>
                    <a:pt x="-1" y="6578"/>
                  </a:cubicBezTo>
                  <a:lnTo>
                    <a:pt x="20574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Arc 282"/>
            <p:cNvSpPr>
              <a:spLocks/>
            </p:cNvSpPr>
            <p:nvPr/>
          </p:nvSpPr>
          <p:spPr bwMode="auto">
            <a:xfrm>
              <a:off x="1252" y="2775"/>
              <a:ext cx="471" cy="148"/>
            </a:xfrm>
            <a:custGeom>
              <a:avLst/>
              <a:gdLst>
                <a:gd name="G0" fmla="+- 20847 0 0"/>
                <a:gd name="G1" fmla="+- 0 0 0"/>
                <a:gd name="G2" fmla="+- 21600 0 0"/>
                <a:gd name="T0" fmla="*/ 273 w 20847"/>
                <a:gd name="T1" fmla="*/ 6578 h 6578"/>
                <a:gd name="T2" fmla="*/ 0 w 20847"/>
                <a:gd name="T3" fmla="*/ 5653 h 6578"/>
                <a:gd name="T4" fmla="*/ 20847 w 20847"/>
                <a:gd name="T5" fmla="*/ 0 h 65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847" h="6578" fill="none" extrusionOk="0">
                  <a:moveTo>
                    <a:pt x="272" y="6578"/>
                  </a:moveTo>
                  <a:cubicBezTo>
                    <a:pt x="175" y="6271"/>
                    <a:pt x="84" y="5963"/>
                    <a:pt x="-1" y="5653"/>
                  </a:cubicBezTo>
                </a:path>
                <a:path w="20847" h="6578" stroke="0" extrusionOk="0">
                  <a:moveTo>
                    <a:pt x="272" y="6578"/>
                  </a:moveTo>
                  <a:cubicBezTo>
                    <a:pt x="175" y="6271"/>
                    <a:pt x="84" y="5963"/>
                    <a:pt x="-1" y="5653"/>
                  </a:cubicBezTo>
                  <a:lnTo>
                    <a:pt x="20847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Line 284"/>
            <p:cNvSpPr>
              <a:spLocks noChangeShapeType="1"/>
            </p:cNvSpPr>
            <p:nvPr/>
          </p:nvSpPr>
          <p:spPr bwMode="auto">
            <a:xfrm>
              <a:off x="1261" y="2919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Rectangle 285"/>
            <p:cNvSpPr>
              <a:spLocks noChangeArrowheads="1"/>
            </p:cNvSpPr>
            <p:nvPr/>
          </p:nvSpPr>
          <p:spPr bwMode="auto">
            <a:xfrm rot="21000000">
              <a:off x="353" y="2899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8366/2015</a:t>
              </a:r>
            </a:p>
          </p:txBody>
        </p:sp>
        <p:sp>
          <p:nvSpPr>
            <p:cNvPr id="86" name="Line 286"/>
            <p:cNvSpPr>
              <a:spLocks noChangeShapeType="1"/>
            </p:cNvSpPr>
            <p:nvPr/>
          </p:nvSpPr>
          <p:spPr bwMode="auto">
            <a:xfrm flipH="1">
              <a:off x="1165" y="2860"/>
              <a:ext cx="80" cy="1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Rectangle 287"/>
            <p:cNvSpPr>
              <a:spLocks noChangeArrowheads="1"/>
            </p:cNvSpPr>
            <p:nvPr/>
          </p:nvSpPr>
          <p:spPr bwMode="auto">
            <a:xfrm rot="21300000">
              <a:off x="181" y="2817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8364/2015</a:t>
              </a:r>
            </a:p>
          </p:txBody>
        </p:sp>
        <p:sp>
          <p:nvSpPr>
            <p:cNvPr id="88" name="Line 288"/>
            <p:cNvSpPr>
              <a:spLocks noChangeShapeType="1"/>
            </p:cNvSpPr>
            <p:nvPr/>
          </p:nvSpPr>
          <p:spPr bwMode="auto">
            <a:xfrm flipH="1">
              <a:off x="998" y="2812"/>
              <a:ext cx="242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Rectangle 289"/>
            <p:cNvSpPr>
              <a:spLocks noChangeArrowheads="1"/>
            </p:cNvSpPr>
            <p:nvPr/>
          </p:nvSpPr>
          <p:spPr bwMode="auto">
            <a:xfrm>
              <a:off x="416" y="2724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D2/Taiwan/22749/2015</a:t>
              </a:r>
            </a:p>
          </p:txBody>
        </p:sp>
        <p:sp>
          <p:nvSpPr>
            <p:cNvPr id="90" name="Line 290"/>
            <p:cNvSpPr>
              <a:spLocks noChangeShapeType="1"/>
            </p:cNvSpPr>
            <p:nvPr/>
          </p:nvSpPr>
          <p:spPr bwMode="auto">
            <a:xfrm>
              <a:off x="1234" y="2769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Arc 291"/>
            <p:cNvSpPr>
              <a:spLocks/>
            </p:cNvSpPr>
            <p:nvPr/>
          </p:nvSpPr>
          <p:spPr bwMode="auto">
            <a:xfrm>
              <a:off x="1235" y="2775"/>
              <a:ext cx="488" cy="37"/>
            </a:xfrm>
            <a:custGeom>
              <a:avLst/>
              <a:gdLst>
                <a:gd name="G0" fmla="+- 21590 0 0"/>
                <a:gd name="G1" fmla="+- 0 0 0"/>
                <a:gd name="G2" fmla="+- 21600 0 0"/>
                <a:gd name="T0" fmla="*/ 53 w 21590"/>
                <a:gd name="T1" fmla="*/ 1653 h 1653"/>
                <a:gd name="T2" fmla="*/ 0 w 21590"/>
                <a:gd name="T3" fmla="*/ 672 h 1653"/>
                <a:gd name="T4" fmla="*/ 21590 w 21590"/>
                <a:gd name="T5" fmla="*/ 0 h 16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590" h="1653" fill="none" extrusionOk="0">
                  <a:moveTo>
                    <a:pt x="53" y="1652"/>
                  </a:moveTo>
                  <a:cubicBezTo>
                    <a:pt x="28" y="1326"/>
                    <a:pt x="10" y="999"/>
                    <a:pt x="0" y="671"/>
                  </a:cubicBezTo>
                </a:path>
                <a:path w="21590" h="1653" stroke="0" extrusionOk="0">
                  <a:moveTo>
                    <a:pt x="53" y="1652"/>
                  </a:moveTo>
                  <a:cubicBezTo>
                    <a:pt x="28" y="1326"/>
                    <a:pt x="10" y="999"/>
                    <a:pt x="0" y="671"/>
                  </a:cubicBezTo>
                  <a:lnTo>
                    <a:pt x="21590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Arc 292"/>
            <p:cNvSpPr>
              <a:spLocks/>
            </p:cNvSpPr>
            <p:nvPr/>
          </p:nvSpPr>
          <p:spPr bwMode="auto">
            <a:xfrm>
              <a:off x="1234" y="2769"/>
              <a:ext cx="489" cy="21"/>
            </a:xfrm>
            <a:custGeom>
              <a:avLst/>
              <a:gdLst>
                <a:gd name="G0" fmla="+- 21600 0 0"/>
                <a:gd name="G1" fmla="+- 266 0 0"/>
                <a:gd name="G2" fmla="+- 21600 0 0"/>
                <a:gd name="T0" fmla="*/ 10 w 21600"/>
                <a:gd name="T1" fmla="*/ 938 h 938"/>
                <a:gd name="T2" fmla="*/ 2 w 21600"/>
                <a:gd name="T3" fmla="*/ 0 h 938"/>
                <a:gd name="T4" fmla="*/ 21600 w 21600"/>
                <a:gd name="T5" fmla="*/ 266 h 9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938" fill="none" extrusionOk="0">
                  <a:moveTo>
                    <a:pt x="10" y="937"/>
                  </a:moveTo>
                  <a:cubicBezTo>
                    <a:pt x="3" y="714"/>
                    <a:pt x="0" y="490"/>
                    <a:pt x="0" y="266"/>
                  </a:cubicBezTo>
                  <a:cubicBezTo>
                    <a:pt x="0" y="177"/>
                    <a:pt x="0" y="88"/>
                    <a:pt x="1" y="-1"/>
                  </a:cubicBezTo>
                </a:path>
                <a:path w="21600" h="938" stroke="0" extrusionOk="0">
                  <a:moveTo>
                    <a:pt x="10" y="937"/>
                  </a:moveTo>
                  <a:cubicBezTo>
                    <a:pt x="3" y="714"/>
                    <a:pt x="0" y="490"/>
                    <a:pt x="0" y="266"/>
                  </a:cubicBezTo>
                  <a:cubicBezTo>
                    <a:pt x="0" y="177"/>
                    <a:pt x="0" y="88"/>
                    <a:pt x="1" y="-1"/>
                  </a:cubicBezTo>
                  <a:lnTo>
                    <a:pt x="21600" y="266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Line 294"/>
            <p:cNvSpPr>
              <a:spLocks noChangeShapeType="1"/>
            </p:cNvSpPr>
            <p:nvPr/>
          </p:nvSpPr>
          <p:spPr bwMode="auto">
            <a:xfrm>
              <a:off x="1234" y="279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Rectangle 295"/>
            <p:cNvSpPr>
              <a:spLocks noChangeArrowheads="1"/>
            </p:cNvSpPr>
            <p:nvPr/>
          </p:nvSpPr>
          <p:spPr bwMode="auto">
            <a:xfrm rot="360000">
              <a:off x="338" y="2621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6767/2015</a:t>
              </a:r>
            </a:p>
          </p:txBody>
        </p:sp>
        <p:sp>
          <p:nvSpPr>
            <p:cNvPr id="96" name="Line 296"/>
            <p:cNvSpPr>
              <a:spLocks noChangeShapeType="1"/>
            </p:cNvSpPr>
            <p:nvPr/>
          </p:nvSpPr>
          <p:spPr bwMode="auto">
            <a:xfrm flipH="1" flipV="1">
              <a:off x="1159" y="2710"/>
              <a:ext cx="81" cy="1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Rectangle 297"/>
            <p:cNvSpPr>
              <a:spLocks noChangeArrowheads="1"/>
            </p:cNvSpPr>
            <p:nvPr/>
          </p:nvSpPr>
          <p:spPr bwMode="auto">
            <a:xfrm rot="660000">
              <a:off x="271" y="2514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8009/2015</a:t>
              </a:r>
            </a:p>
          </p:txBody>
        </p:sp>
        <p:sp>
          <p:nvSpPr>
            <p:cNvPr id="98" name="Line 298"/>
            <p:cNvSpPr>
              <a:spLocks noChangeShapeType="1"/>
            </p:cNvSpPr>
            <p:nvPr/>
          </p:nvSpPr>
          <p:spPr bwMode="auto">
            <a:xfrm flipH="1" flipV="1">
              <a:off x="1089" y="2646"/>
              <a:ext cx="156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Rectangle 299"/>
            <p:cNvSpPr>
              <a:spLocks noChangeArrowheads="1"/>
            </p:cNvSpPr>
            <p:nvPr/>
          </p:nvSpPr>
          <p:spPr bwMode="auto">
            <a:xfrm rot="960000">
              <a:off x="376" y="2445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D2/Taiwan/22864/2015</a:t>
              </a:r>
            </a:p>
          </p:txBody>
        </p:sp>
        <p:sp>
          <p:nvSpPr>
            <p:cNvPr id="100" name="Line 300"/>
            <p:cNvSpPr>
              <a:spLocks noChangeShapeType="1"/>
            </p:cNvSpPr>
            <p:nvPr/>
          </p:nvSpPr>
          <p:spPr bwMode="auto">
            <a:xfrm flipH="1" flipV="1">
              <a:off x="1181" y="2608"/>
              <a:ext cx="75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Arc 301"/>
            <p:cNvSpPr>
              <a:spLocks/>
            </p:cNvSpPr>
            <p:nvPr/>
          </p:nvSpPr>
          <p:spPr bwMode="auto">
            <a:xfrm>
              <a:off x="1244" y="2657"/>
              <a:ext cx="479" cy="118"/>
            </a:xfrm>
            <a:custGeom>
              <a:avLst/>
              <a:gdLst>
                <a:gd name="G0" fmla="+- 21167 0 0"/>
                <a:gd name="G1" fmla="+- 5238 0 0"/>
                <a:gd name="G2" fmla="+- 21600 0 0"/>
                <a:gd name="T0" fmla="*/ 0 w 21167"/>
                <a:gd name="T1" fmla="*/ 934 h 5238"/>
                <a:gd name="T2" fmla="*/ 212 w 21167"/>
                <a:gd name="T3" fmla="*/ 0 h 5238"/>
                <a:gd name="T4" fmla="*/ 21167 w 21167"/>
                <a:gd name="T5" fmla="*/ 5238 h 52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167" h="5238" fill="none" extrusionOk="0">
                  <a:moveTo>
                    <a:pt x="0" y="934"/>
                  </a:moveTo>
                  <a:cubicBezTo>
                    <a:pt x="63" y="621"/>
                    <a:pt x="134" y="309"/>
                    <a:pt x="211" y="-1"/>
                  </a:cubicBezTo>
                </a:path>
                <a:path w="21167" h="5238" stroke="0" extrusionOk="0">
                  <a:moveTo>
                    <a:pt x="0" y="934"/>
                  </a:moveTo>
                  <a:cubicBezTo>
                    <a:pt x="63" y="621"/>
                    <a:pt x="134" y="309"/>
                    <a:pt x="211" y="-1"/>
                  </a:cubicBezTo>
                  <a:lnTo>
                    <a:pt x="21167" y="5238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Arc 302"/>
            <p:cNvSpPr>
              <a:spLocks/>
            </p:cNvSpPr>
            <p:nvPr/>
          </p:nvSpPr>
          <p:spPr bwMode="auto">
            <a:xfrm>
              <a:off x="1249" y="2635"/>
              <a:ext cx="474" cy="140"/>
            </a:xfrm>
            <a:custGeom>
              <a:avLst/>
              <a:gdLst>
                <a:gd name="G0" fmla="+- 20955 0 0"/>
                <a:gd name="G1" fmla="+- 6214 0 0"/>
                <a:gd name="G2" fmla="+- 21600 0 0"/>
                <a:gd name="T0" fmla="*/ 0 w 20955"/>
                <a:gd name="T1" fmla="*/ 976 h 6214"/>
                <a:gd name="T2" fmla="*/ 268 w 20955"/>
                <a:gd name="T3" fmla="*/ 0 h 6214"/>
                <a:gd name="T4" fmla="*/ 20955 w 20955"/>
                <a:gd name="T5" fmla="*/ 6214 h 62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955" h="6214" fill="none" extrusionOk="0">
                  <a:moveTo>
                    <a:pt x="-1" y="975"/>
                  </a:moveTo>
                  <a:cubicBezTo>
                    <a:pt x="81" y="648"/>
                    <a:pt x="171" y="323"/>
                    <a:pt x="268" y="0"/>
                  </a:cubicBezTo>
                </a:path>
                <a:path w="20955" h="6214" stroke="0" extrusionOk="0">
                  <a:moveTo>
                    <a:pt x="-1" y="975"/>
                  </a:moveTo>
                  <a:cubicBezTo>
                    <a:pt x="81" y="648"/>
                    <a:pt x="171" y="323"/>
                    <a:pt x="268" y="0"/>
                  </a:cubicBezTo>
                  <a:lnTo>
                    <a:pt x="20955" y="6214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Line 304"/>
            <p:cNvSpPr>
              <a:spLocks noChangeShapeType="1"/>
            </p:cNvSpPr>
            <p:nvPr/>
          </p:nvSpPr>
          <p:spPr bwMode="auto">
            <a:xfrm>
              <a:off x="1250" y="2657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Arc 305"/>
            <p:cNvSpPr>
              <a:spLocks/>
            </p:cNvSpPr>
            <p:nvPr/>
          </p:nvSpPr>
          <p:spPr bwMode="auto">
            <a:xfrm>
              <a:off x="1238" y="2689"/>
              <a:ext cx="485" cy="86"/>
            </a:xfrm>
            <a:custGeom>
              <a:avLst/>
              <a:gdLst>
                <a:gd name="G0" fmla="+- 21466 0 0"/>
                <a:gd name="G1" fmla="+- 3794 0 0"/>
                <a:gd name="G2" fmla="+- 21600 0 0"/>
                <a:gd name="T0" fmla="*/ 0 w 21466"/>
                <a:gd name="T1" fmla="*/ 1389 h 3794"/>
                <a:gd name="T2" fmla="*/ 202 w 21466"/>
                <a:gd name="T3" fmla="*/ 0 h 3794"/>
                <a:gd name="T4" fmla="*/ 21466 w 21466"/>
                <a:gd name="T5" fmla="*/ 3794 h 37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466" h="3794" fill="none" extrusionOk="0">
                  <a:moveTo>
                    <a:pt x="0" y="1389"/>
                  </a:moveTo>
                  <a:cubicBezTo>
                    <a:pt x="52" y="923"/>
                    <a:pt x="119" y="460"/>
                    <a:pt x="201" y="-1"/>
                  </a:cubicBezTo>
                </a:path>
                <a:path w="21466" h="3794" stroke="0" extrusionOk="0">
                  <a:moveTo>
                    <a:pt x="0" y="1389"/>
                  </a:moveTo>
                  <a:cubicBezTo>
                    <a:pt x="52" y="923"/>
                    <a:pt x="119" y="460"/>
                    <a:pt x="201" y="-1"/>
                  </a:cubicBezTo>
                  <a:lnTo>
                    <a:pt x="21466" y="3794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Arc 306"/>
            <p:cNvSpPr>
              <a:spLocks/>
            </p:cNvSpPr>
            <p:nvPr/>
          </p:nvSpPr>
          <p:spPr bwMode="auto">
            <a:xfrm>
              <a:off x="1242" y="2657"/>
              <a:ext cx="481" cy="118"/>
            </a:xfrm>
            <a:custGeom>
              <a:avLst/>
              <a:gdLst>
                <a:gd name="G0" fmla="+- 21264 0 0"/>
                <a:gd name="G1" fmla="+- 5238 0 0"/>
                <a:gd name="G2" fmla="+- 21600 0 0"/>
                <a:gd name="T0" fmla="*/ 0 w 21264"/>
                <a:gd name="T1" fmla="*/ 1444 h 5238"/>
                <a:gd name="T2" fmla="*/ 309 w 21264"/>
                <a:gd name="T3" fmla="*/ 0 h 5238"/>
                <a:gd name="T4" fmla="*/ 21264 w 21264"/>
                <a:gd name="T5" fmla="*/ 5238 h 52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264" h="5238" fill="none" extrusionOk="0">
                  <a:moveTo>
                    <a:pt x="-1" y="1443"/>
                  </a:moveTo>
                  <a:cubicBezTo>
                    <a:pt x="86" y="959"/>
                    <a:pt x="189" y="477"/>
                    <a:pt x="308" y="-1"/>
                  </a:cubicBezTo>
                </a:path>
                <a:path w="21264" h="5238" stroke="0" extrusionOk="0">
                  <a:moveTo>
                    <a:pt x="-1" y="1443"/>
                  </a:moveTo>
                  <a:cubicBezTo>
                    <a:pt x="86" y="959"/>
                    <a:pt x="189" y="477"/>
                    <a:pt x="308" y="-1"/>
                  </a:cubicBezTo>
                  <a:lnTo>
                    <a:pt x="21264" y="5238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Line 308"/>
            <p:cNvSpPr>
              <a:spLocks noChangeShapeType="1"/>
            </p:cNvSpPr>
            <p:nvPr/>
          </p:nvSpPr>
          <p:spPr bwMode="auto">
            <a:xfrm>
              <a:off x="1245" y="2689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Arc 309"/>
            <p:cNvSpPr>
              <a:spLocks/>
            </p:cNvSpPr>
            <p:nvPr/>
          </p:nvSpPr>
          <p:spPr bwMode="auto">
            <a:xfrm>
              <a:off x="1234" y="2737"/>
              <a:ext cx="489" cy="53"/>
            </a:xfrm>
            <a:custGeom>
              <a:avLst/>
              <a:gdLst>
                <a:gd name="G0" fmla="+- 21600 0 0"/>
                <a:gd name="G1" fmla="+- 1677 0 0"/>
                <a:gd name="G2" fmla="+- 21600 0 0"/>
                <a:gd name="T0" fmla="*/ 10 w 21600"/>
                <a:gd name="T1" fmla="*/ 2349 h 2349"/>
                <a:gd name="T2" fmla="*/ 65 w 21600"/>
                <a:gd name="T3" fmla="*/ 0 h 2349"/>
                <a:gd name="T4" fmla="*/ 21600 w 21600"/>
                <a:gd name="T5" fmla="*/ 1677 h 23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2349" fill="none" extrusionOk="0">
                  <a:moveTo>
                    <a:pt x="10" y="2348"/>
                  </a:moveTo>
                  <a:cubicBezTo>
                    <a:pt x="3" y="2125"/>
                    <a:pt x="0" y="1901"/>
                    <a:pt x="0" y="1677"/>
                  </a:cubicBezTo>
                  <a:cubicBezTo>
                    <a:pt x="0" y="1117"/>
                    <a:pt x="21" y="557"/>
                    <a:pt x="65" y="0"/>
                  </a:cubicBezTo>
                </a:path>
                <a:path w="21600" h="2349" stroke="0" extrusionOk="0">
                  <a:moveTo>
                    <a:pt x="10" y="2348"/>
                  </a:moveTo>
                  <a:cubicBezTo>
                    <a:pt x="3" y="2125"/>
                    <a:pt x="0" y="1901"/>
                    <a:pt x="0" y="1677"/>
                  </a:cubicBezTo>
                  <a:cubicBezTo>
                    <a:pt x="0" y="1117"/>
                    <a:pt x="21" y="557"/>
                    <a:pt x="65" y="0"/>
                  </a:cubicBezTo>
                  <a:lnTo>
                    <a:pt x="21600" y="167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Arc 310"/>
            <p:cNvSpPr>
              <a:spLocks/>
            </p:cNvSpPr>
            <p:nvPr/>
          </p:nvSpPr>
          <p:spPr bwMode="auto">
            <a:xfrm>
              <a:off x="1236" y="2689"/>
              <a:ext cx="487" cy="86"/>
            </a:xfrm>
            <a:custGeom>
              <a:avLst/>
              <a:gdLst>
                <a:gd name="G0" fmla="+- 21535 0 0"/>
                <a:gd name="G1" fmla="+- 3794 0 0"/>
                <a:gd name="G2" fmla="+- 21600 0 0"/>
                <a:gd name="T0" fmla="*/ 0 w 21535"/>
                <a:gd name="T1" fmla="*/ 2117 h 3794"/>
                <a:gd name="T2" fmla="*/ 271 w 21535"/>
                <a:gd name="T3" fmla="*/ 0 h 3794"/>
                <a:gd name="T4" fmla="*/ 21535 w 21535"/>
                <a:gd name="T5" fmla="*/ 3794 h 37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535" h="3794" fill="none" extrusionOk="0">
                  <a:moveTo>
                    <a:pt x="0" y="2117"/>
                  </a:moveTo>
                  <a:cubicBezTo>
                    <a:pt x="55" y="1407"/>
                    <a:pt x="145" y="700"/>
                    <a:pt x="270" y="-1"/>
                  </a:cubicBezTo>
                </a:path>
                <a:path w="21535" h="3794" stroke="0" extrusionOk="0">
                  <a:moveTo>
                    <a:pt x="0" y="2117"/>
                  </a:moveTo>
                  <a:cubicBezTo>
                    <a:pt x="55" y="1407"/>
                    <a:pt x="145" y="700"/>
                    <a:pt x="270" y="-1"/>
                  </a:cubicBezTo>
                  <a:lnTo>
                    <a:pt x="21535" y="3794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Line 312"/>
            <p:cNvSpPr>
              <a:spLocks noChangeShapeType="1"/>
            </p:cNvSpPr>
            <p:nvPr/>
          </p:nvSpPr>
          <p:spPr bwMode="auto">
            <a:xfrm>
              <a:off x="1240" y="2737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Arc 313"/>
            <p:cNvSpPr>
              <a:spLocks/>
            </p:cNvSpPr>
            <p:nvPr/>
          </p:nvSpPr>
          <p:spPr bwMode="auto">
            <a:xfrm>
              <a:off x="1235" y="2775"/>
              <a:ext cx="488" cy="81"/>
            </a:xfrm>
            <a:custGeom>
              <a:avLst/>
              <a:gdLst>
                <a:gd name="G0" fmla="+- 21580 0 0"/>
                <a:gd name="G1" fmla="+- 0 0 0"/>
                <a:gd name="G2" fmla="+- 21600 0 0"/>
                <a:gd name="T0" fmla="*/ 277 w 21580"/>
                <a:gd name="T1" fmla="*/ 3573 h 3573"/>
                <a:gd name="T2" fmla="*/ 0 w 21580"/>
                <a:gd name="T3" fmla="*/ 929 h 3573"/>
                <a:gd name="T4" fmla="*/ 21580 w 21580"/>
                <a:gd name="T5" fmla="*/ 0 h 35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580" h="3573" fill="none" extrusionOk="0">
                  <a:moveTo>
                    <a:pt x="277" y="3572"/>
                  </a:moveTo>
                  <a:cubicBezTo>
                    <a:pt x="130" y="2698"/>
                    <a:pt x="38" y="1815"/>
                    <a:pt x="-1" y="929"/>
                  </a:cubicBezTo>
                </a:path>
                <a:path w="21580" h="3573" stroke="0" extrusionOk="0">
                  <a:moveTo>
                    <a:pt x="277" y="3572"/>
                  </a:moveTo>
                  <a:cubicBezTo>
                    <a:pt x="130" y="2698"/>
                    <a:pt x="38" y="1815"/>
                    <a:pt x="-1" y="929"/>
                  </a:cubicBezTo>
                  <a:lnTo>
                    <a:pt x="21580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Arc 314"/>
            <p:cNvSpPr>
              <a:spLocks/>
            </p:cNvSpPr>
            <p:nvPr/>
          </p:nvSpPr>
          <p:spPr bwMode="auto">
            <a:xfrm>
              <a:off x="1234" y="2737"/>
              <a:ext cx="489" cy="59"/>
            </a:xfrm>
            <a:custGeom>
              <a:avLst/>
              <a:gdLst>
                <a:gd name="G0" fmla="+- 21600 0 0"/>
                <a:gd name="G1" fmla="+- 1677 0 0"/>
                <a:gd name="G2" fmla="+- 21600 0 0"/>
                <a:gd name="T0" fmla="*/ 20 w 21600"/>
                <a:gd name="T1" fmla="*/ 2606 h 2606"/>
                <a:gd name="T2" fmla="*/ 65 w 21600"/>
                <a:gd name="T3" fmla="*/ 0 h 2606"/>
                <a:gd name="T4" fmla="*/ 21600 w 21600"/>
                <a:gd name="T5" fmla="*/ 1677 h 26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2606" fill="none" extrusionOk="0">
                  <a:moveTo>
                    <a:pt x="19" y="2606"/>
                  </a:moveTo>
                  <a:cubicBezTo>
                    <a:pt x="6" y="2296"/>
                    <a:pt x="0" y="1986"/>
                    <a:pt x="0" y="1677"/>
                  </a:cubicBezTo>
                  <a:cubicBezTo>
                    <a:pt x="0" y="1117"/>
                    <a:pt x="21" y="557"/>
                    <a:pt x="65" y="0"/>
                  </a:cubicBezTo>
                </a:path>
                <a:path w="21600" h="2606" stroke="0" extrusionOk="0">
                  <a:moveTo>
                    <a:pt x="19" y="2606"/>
                  </a:moveTo>
                  <a:cubicBezTo>
                    <a:pt x="6" y="2296"/>
                    <a:pt x="0" y="1986"/>
                    <a:pt x="0" y="1677"/>
                  </a:cubicBezTo>
                  <a:cubicBezTo>
                    <a:pt x="0" y="1117"/>
                    <a:pt x="21" y="557"/>
                    <a:pt x="65" y="0"/>
                  </a:cubicBezTo>
                  <a:lnTo>
                    <a:pt x="21600" y="167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Line 316"/>
            <p:cNvSpPr>
              <a:spLocks noChangeShapeType="1"/>
            </p:cNvSpPr>
            <p:nvPr/>
          </p:nvSpPr>
          <p:spPr bwMode="auto">
            <a:xfrm>
              <a:off x="1240" y="2796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Arc 317"/>
            <p:cNvSpPr>
              <a:spLocks/>
            </p:cNvSpPr>
            <p:nvPr/>
          </p:nvSpPr>
          <p:spPr bwMode="auto">
            <a:xfrm>
              <a:off x="1247" y="2775"/>
              <a:ext cx="476" cy="144"/>
            </a:xfrm>
            <a:custGeom>
              <a:avLst/>
              <a:gdLst>
                <a:gd name="G0" fmla="+- 21266 0 0"/>
                <a:gd name="G1" fmla="+- 0 0 0"/>
                <a:gd name="G2" fmla="+- 21600 0 0"/>
                <a:gd name="T0" fmla="*/ 646 w 21266"/>
                <a:gd name="T1" fmla="*/ 6434 h 6434"/>
                <a:gd name="T2" fmla="*/ 0 w 21266"/>
                <a:gd name="T3" fmla="*/ 3785 h 6434"/>
                <a:gd name="T4" fmla="*/ 21266 w 21266"/>
                <a:gd name="T5" fmla="*/ 0 h 64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266" h="6434" fill="none" extrusionOk="0">
                  <a:moveTo>
                    <a:pt x="646" y="6433"/>
                  </a:moveTo>
                  <a:cubicBezTo>
                    <a:pt x="375" y="5565"/>
                    <a:pt x="159" y="4680"/>
                    <a:pt x="0" y="3784"/>
                  </a:cubicBezTo>
                </a:path>
                <a:path w="21266" h="6434" stroke="0" extrusionOk="0">
                  <a:moveTo>
                    <a:pt x="646" y="6433"/>
                  </a:moveTo>
                  <a:cubicBezTo>
                    <a:pt x="375" y="5565"/>
                    <a:pt x="159" y="4680"/>
                    <a:pt x="0" y="3784"/>
                  </a:cubicBezTo>
                  <a:lnTo>
                    <a:pt x="21266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Arc 318"/>
            <p:cNvSpPr>
              <a:spLocks/>
            </p:cNvSpPr>
            <p:nvPr/>
          </p:nvSpPr>
          <p:spPr bwMode="auto">
            <a:xfrm>
              <a:off x="1240" y="2775"/>
              <a:ext cx="483" cy="85"/>
            </a:xfrm>
            <a:custGeom>
              <a:avLst/>
              <a:gdLst>
                <a:gd name="G0" fmla="+- 21580 0 0"/>
                <a:gd name="G1" fmla="+- 0 0 0"/>
                <a:gd name="G2" fmla="+- 21600 0 0"/>
                <a:gd name="T0" fmla="*/ 314 w 21580"/>
                <a:gd name="T1" fmla="*/ 3785 h 3785"/>
                <a:gd name="T2" fmla="*/ 0 w 21580"/>
                <a:gd name="T3" fmla="*/ 939 h 3785"/>
                <a:gd name="T4" fmla="*/ 21580 w 21580"/>
                <a:gd name="T5" fmla="*/ 0 h 37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580" h="3785" fill="none" extrusionOk="0">
                  <a:moveTo>
                    <a:pt x="314" y="3784"/>
                  </a:moveTo>
                  <a:cubicBezTo>
                    <a:pt x="146" y="2844"/>
                    <a:pt x="41" y="1893"/>
                    <a:pt x="0" y="938"/>
                  </a:cubicBezTo>
                </a:path>
                <a:path w="21580" h="3785" stroke="0" extrusionOk="0">
                  <a:moveTo>
                    <a:pt x="314" y="3784"/>
                  </a:moveTo>
                  <a:cubicBezTo>
                    <a:pt x="146" y="2844"/>
                    <a:pt x="41" y="1893"/>
                    <a:pt x="0" y="938"/>
                  </a:cubicBezTo>
                  <a:lnTo>
                    <a:pt x="21580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Line 320"/>
            <p:cNvSpPr>
              <a:spLocks noChangeShapeType="1"/>
            </p:cNvSpPr>
            <p:nvPr/>
          </p:nvSpPr>
          <p:spPr bwMode="auto">
            <a:xfrm>
              <a:off x="1245" y="286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Arc 321"/>
            <p:cNvSpPr>
              <a:spLocks/>
            </p:cNvSpPr>
            <p:nvPr/>
          </p:nvSpPr>
          <p:spPr bwMode="auto">
            <a:xfrm>
              <a:off x="1263" y="2775"/>
              <a:ext cx="460" cy="208"/>
            </a:xfrm>
            <a:custGeom>
              <a:avLst/>
              <a:gdLst>
                <a:gd name="G0" fmla="+- 20555 0 0"/>
                <a:gd name="G1" fmla="+- 0 0 0"/>
                <a:gd name="G2" fmla="+- 21600 0 0"/>
                <a:gd name="T0" fmla="*/ 1072 w 20555"/>
                <a:gd name="T1" fmla="*/ 9326 h 9326"/>
                <a:gd name="T2" fmla="*/ 0 w 20555"/>
                <a:gd name="T3" fmla="*/ 6636 h 9326"/>
                <a:gd name="T4" fmla="*/ 20555 w 20555"/>
                <a:gd name="T5" fmla="*/ 0 h 93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555" h="9326" fill="none" extrusionOk="0">
                  <a:moveTo>
                    <a:pt x="1072" y="9325"/>
                  </a:moveTo>
                  <a:cubicBezTo>
                    <a:pt x="654" y="8454"/>
                    <a:pt x="296" y="7555"/>
                    <a:pt x="-1" y="6636"/>
                  </a:cubicBezTo>
                </a:path>
                <a:path w="20555" h="9326" stroke="0" extrusionOk="0">
                  <a:moveTo>
                    <a:pt x="1072" y="9325"/>
                  </a:moveTo>
                  <a:cubicBezTo>
                    <a:pt x="654" y="8454"/>
                    <a:pt x="296" y="7555"/>
                    <a:pt x="-1" y="6636"/>
                  </a:cubicBezTo>
                  <a:lnTo>
                    <a:pt x="20555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Arc 322"/>
            <p:cNvSpPr>
              <a:spLocks/>
            </p:cNvSpPr>
            <p:nvPr/>
          </p:nvSpPr>
          <p:spPr bwMode="auto">
            <a:xfrm>
              <a:off x="1247" y="2775"/>
              <a:ext cx="476" cy="148"/>
            </a:xfrm>
            <a:custGeom>
              <a:avLst/>
              <a:gdLst>
                <a:gd name="G0" fmla="+- 21266 0 0"/>
                <a:gd name="G1" fmla="+- 0 0 0"/>
                <a:gd name="G2" fmla="+- 21600 0 0"/>
                <a:gd name="T0" fmla="*/ 711 w 21266"/>
                <a:gd name="T1" fmla="*/ 6636 h 6636"/>
                <a:gd name="T2" fmla="*/ 0 w 21266"/>
                <a:gd name="T3" fmla="*/ 3785 h 6636"/>
                <a:gd name="T4" fmla="*/ 21266 w 21266"/>
                <a:gd name="T5" fmla="*/ 0 h 66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266" h="6636" fill="none" extrusionOk="0">
                  <a:moveTo>
                    <a:pt x="710" y="6636"/>
                  </a:moveTo>
                  <a:cubicBezTo>
                    <a:pt x="409" y="5702"/>
                    <a:pt x="172" y="4750"/>
                    <a:pt x="0" y="3784"/>
                  </a:cubicBezTo>
                </a:path>
                <a:path w="21266" h="6636" stroke="0" extrusionOk="0">
                  <a:moveTo>
                    <a:pt x="710" y="6636"/>
                  </a:moveTo>
                  <a:cubicBezTo>
                    <a:pt x="409" y="5702"/>
                    <a:pt x="172" y="4750"/>
                    <a:pt x="0" y="3784"/>
                  </a:cubicBezTo>
                  <a:lnTo>
                    <a:pt x="21266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Line 324"/>
            <p:cNvSpPr>
              <a:spLocks noChangeShapeType="1"/>
            </p:cNvSpPr>
            <p:nvPr/>
          </p:nvSpPr>
          <p:spPr bwMode="auto">
            <a:xfrm>
              <a:off x="1261" y="2924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Arc 325"/>
            <p:cNvSpPr>
              <a:spLocks/>
            </p:cNvSpPr>
            <p:nvPr/>
          </p:nvSpPr>
          <p:spPr bwMode="auto">
            <a:xfrm>
              <a:off x="1287" y="2775"/>
              <a:ext cx="436" cy="267"/>
            </a:xfrm>
            <a:custGeom>
              <a:avLst/>
              <a:gdLst>
                <a:gd name="G0" fmla="+- 19483 0 0"/>
                <a:gd name="G1" fmla="+- 0 0 0"/>
                <a:gd name="G2" fmla="+- 21600 0 0"/>
                <a:gd name="T0" fmla="*/ 1482 w 19483"/>
                <a:gd name="T1" fmla="*/ 11939 h 11939"/>
                <a:gd name="T2" fmla="*/ 0 w 19483"/>
                <a:gd name="T3" fmla="*/ 9326 h 11939"/>
                <a:gd name="T4" fmla="*/ 19483 w 19483"/>
                <a:gd name="T5" fmla="*/ 0 h 119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483" h="11939" fill="none" extrusionOk="0">
                  <a:moveTo>
                    <a:pt x="1482" y="11938"/>
                  </a:moveTo>
                  <a:cubicBezTo>
                    <a:pt x="928" y="11103"/>
                    <a:pt x="432" y="10230"/>
                    <a:pt x="0" y="9325"/>
                  </a:cubicBezTo>
                </a:path>
                <a:path w="19483" h="11939" stroke="0" extrusionOk="0">
                  <a:moveTo>
                    <a:pt x="1482" y="11938"/>
                  </a:moveTo>
                  <a:cubicBezTo>
                    <a:pt x="928" y="11103"/>
                    <a:pt x="432" y="10230"/>
                    <a:pt x="0" y="9325"/>
                  </a:cubicBezTo>
                  <a:lnTo>
                    <a:pt x="19483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Arc 326"/>
            <p:cNvSpPr>
              <a:spLocks/>
            </p:cNvSpPr>
            <p:nvPr/>
          </p:nvSpPr>
          <p:spPr bwMode="auto">
            <a:xfrm>
              <a:off x="1263" y="2775"/>
              <a:ext cx="460" cy="208"/>
            </a:xfrm>
            <a:custGeom>
              <a:avLst/>
              <a:gdLst>
                <a:gd name="G0" fmla="+- 20555 0 0"/>
                <a:gd name="G1" fmla="+- 0 0 0"/>
                <a:gd name="G2" fmla="+- 21600 0 0"/>
                <a:gd name="T0" fmla="*/ 1072 w 20555"/>
                <a:gd name="T1" fmla="*/ 9326 h 9326"/>
                <a:gd name="T2" fmla="*/ 0 w 20555"/>
                <a:gd name="T3" fmla="*/ 6636 h 9326"/>
                <a:gd name="T4" fmla="*/ 20555 w 20555"/>
                <a:gd name="T5" fmla="*/ 0 h 93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555" h="9326" fill="none" extrusionOk="0">
                  <a:moveTo>
                    <a:pt x="1072" y="9325"/>
                  </a:moveTo>
                  <a:cubicBezTo>
                    <a:pt x="654" y="8454"/>
                    <a:pt x="296" y="7555"/>
                    <a:pt x="-1" y="6636"/>
                  </a:cubicBezTo>
                </a:path>
                <a:path w="20555" h="9326" stroke="0" extrusionOk="0">
                  <a:moveTo>
                    <a:pt x="1072" y="9325"/>
                  </a:moveTo>
                  <a:cubicBezTo>
                    <a:pt x="654" y="8454"/>
                    <a:pt x="296" y="7555"/>
                    <a:pt x="-1" y="6636"/>
                  </a:cubicBezTo>
                  <a:lnTo>
                    <a:pt x="20555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Line 328"/>
            <p:cNvSpPr>
              <a:spLocks noChangeShapeType="1"/>
            </p:cNvSpPr>
            <p:nvPr/>
          </p:nvSpPr>
          <p:spPr bwMode="auto">
            <a:xfrm>
              <a:off x="1288" y="2983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Arc 329"/>
            <p:cNvSpPr>
              <a:spLocks/>
            </p:cNvSpPr>
            <p:nvPr/>
          </p:nvSpPr>
          <p:spPr bwMode="auto">
            <a:xfrm>
              <a:off x="1363" y="2775"/>
              <a:ext cx="360" cy="406"/>
            </a:xfrm>
            <a:custGeom>
              <a:avLst/>
              <a:gdLst>
                <a:gd name="G0" fmla="+- 16114 0 0"/>
                <a:gd name="G1" fmla="+- 0 0 0"/>
                <a:gd name="G2" fmla="+- 21600 0 0"/>
                <a:gd name="T0" fmla="*/ 4435 w 16114"/>
                <a:gd name="T1" fmla="*/ 18171 h 18171"/>
                <a:gd name="T2" fmla="*/ 0 w 16114"/>
                <a:gd name="T3" fmla="*/ 14384 h 18171"/>
                <a:gd name="T4" fmla="*/ 16114 w 16114"/>
                <a:gd name="T5" fmla="*/ 0 h 18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114" h="18171" fill="none" extrusionOk="0">
                  <a:moveTo>
                    <a:pt x="4435" y="18170"/>
                  </a:moveTo>
                  <a:cubicBezTo>
                    <a:pt x="2792" y="17114"/>
                    <a:pt x="1300" y="15840"/>
                    <a:pt x="0" y="14383"/>
                  </a:cubicBezTo>
                </a:path>
                <a:path w="16114" h="18171" stroke="0" extrusionOk="0">
                  <a:moveTo>
                    <a:pt x="4435" y="18170"/>
                  </a:moveTo>
                  <a:cubicBezTo>
                    <a:pt x="2792" y="17114"/>
                    <a:pt x="1300" y="15840"/>
                    <a:pt x="0" y="14383"/>
                  </a:cubicBezTo>
                  <a:lnTo>
                    <a:pt x="16114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Arc 330"/>
            <p:cNvSpPr>
              <a:spLocks/>
            </p:cNvSpPr>
            <p:nvPr/>
          </p:nvSpPr>
          <p:spPr bwMode="auto">
            <a:xfrm>
              <a:off x="1287" y="2775"/>
              <a:ext cx="436" cy="321"/>
            </a:xfrm>
            <a:custGeom>
              <a:avLst/>
              <a:gdLst>
                <a:gd name="G0" fmla="+- 19483 0 0"/>
                <a:gd name="G1" fmla="+- 0 0 0"/>
                <a:gd name="G2" fmla="+- 21600 0 0"/>
                <a:gd name="T0" fmla="*/ 3369 w 19483"/>
                <a:gd name="T1" fmla="*/ 14384 h 14384"/>
                <a:gd name="T2" fmla="*/ 0 w 19483"/>
                <a:gd name="T3" fmla="*/ 9326 h 14384"/>
                <a:gd name="T4" fmla="*/ 19483 w 19483"/>
                <a:gd name="T5" fmla="*/ 0 h 143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483" h="14384" fill="none" extrusionOk="0">
                  <a:moveTo>
                    <a:pt x="3369" y="14383"/>
                  </a:moveTo>
                  <a:cubicBezTo>
                    <a:pt x="2013" y="12865"/>
                    <a:pt x="879" y="11162"/>
                    <a:pt x="0" y="9325"/>
                  </a:cubicBezTo>
                </a:path>
                <a:path w="19483" h="14384" stroke="0" extrusionOk="0">
                  <a:moveTo>
                    <a:pt x="3369" y="14383"/>
                  </a:moveTo>
                  <a:cubicBezTo>
                    <a:pt x="2013" y="12865"/>
                    <a:pt x="879" y="11162"/>
                    <a:pt x="0" y="9325"/>
                  </a:cubicBezTo>
                  <a:lnTo>
                    <a:pt x="19483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Line 332"/>
            <p:cNvSpPr>
              <a:spLocks noChangeShapeType="1"/>
            </p:cNvSpPr>
            <p:nvPr/>
          </p:nvSpPr>
          <p:spPr bwMode="auto">
            <a:xfrm>
              <a:off x="1358" y="3096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Rectangle 333"/>
            <p:cNvSpPr>
              <a:spLocks noChangeArrowheads="1"/>
            </p:cNvSpPr>
            <p:nvPr/>
          </p:nvSpPr>
          <p:spPr bwMode="auto">
            <a:xfrm rot="1320000">
              <a:off x="471" y="2380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7299/2015</a:t>
              </a:r>
            </a:p>
          </p:txBody>
        </p:sp>
        <p:sp>
          <p:nvSpPr>
            <p:cNvPr id="134" name="Line 334"/>
            <p:cNvSpPr>
              <a:spLocks noChangeShapeType="1"/>
            </p:cNvSpPr>
            <p:nvPr/>
          </p:nvSpPr>
          <p:spPr bwMode="auto">
            <a:xfrm>
              <a:off x="1272" y="2592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Arc 335"/>
            <p:cNvSpPr>
              <a:spLocks/>
            </p:cNvSpPr>
            <p:nvPr/>
          </p:nvSpPr>
          <p:spPr bwMode="auto">
            <a:xfrm>
              <a:off x="1247" y="2775"/>
              <a:ext cx="476" cy="321"/>
            </a:xfrm>
            <a:custGeom>
              <a:avLst/>
              <a:gdLst>
                <a:gd name="G0" fmla="+- 21297 0 0"/>
                <a:gd name="G1" fmla="+- 0 0 0"/>
                <a:gd name="G2" fmla="+- 21600 0 0"/>
                <a:gd name="T0" fmla="*/ 5183 w 21297"/>
                <a:gd name="T1" fmla="*/ 14384 h 14384"/>
                <a:gd name="T2" fmla="*/ 0 w 21297"/>
                <a:gd name="T3" fmla="*/ 3606 h 14384"/>
                <a:gd name="T4" fmla="*/ 21297 w 21297"/>
                <a:gd name="T5" fmla="*/ 0 h 143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297" h="14384" fill="none" extrusionOk="0">
                  <a:moveTo>
                    <a:pt x="5183" y="14383"/>
                  </a:moveTo>
                  <a:cubicBezTo>
                    <a:pt x="2475" y="11350"/>
                    <a:pt x="678" y="7614"/>
                    <a:pt x="0" y="3605"/>
                  </a:cubicBezTo>
                </a:path>
                <a:path w="21297" h="14384" stroke="0" extrusionOk="0">
                  <a:moveTo>
                    <a:pt x="5183" y="14383"/>
                  </a:moveTo>
                  <a:cubicBezTo>
                    <a:pt x="2475" y="11350"/>
                    <a:pt x="678" y="7614"/>
                    <a:pt x="0" y="3605"/>
                  </a:cubicBezTo>
                  <a:lnTo>
                    <a:pt x="21297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Arc 336"/>
            <p:cNvSpPr>
              <a:spLocks/>
            </p:cNvSpPr>
            <p:nvPr/>
          </p:nvSpPr>
          <p:spPr bwMode="auto">
            <a:xfrm>
              <a:off x="1240" y="2592"/>
              <a:ext cx="483" cy="264"/>
            </a:xfrm>
            <a:custGeom>
              <a:avLst/>
              <a:gdLst>
                <a:gd name="G0" fmla="+- 21600 0 0"/>
                <a:gd name="G1" fmla="+- 8207 0 0"/>
                <a:gd name="G2" fmla="+- 21600 0 0"/>
                <a:gd name="T0" fmla="*/ 303 w 21600"/>
                <a:gd name="T1" fmla="*/ 11813 h 11813"/>
                <a:gd name="T2" fmla="*/ 1620 w 21600"/>
                <a:gd name="T3" fmla="*/ 0 h 11813"/>
                <a:gd name="T4" fmla="*/ 21600 w 21600"/>
                <a:gd name="T5" fmla="*/ 8207 h 118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11813" fill="none" extrusionOk="0">
                  <a:moveTo>
                    <a:pt x="303" y="11812"/>
                  </a:moveTo>
                  <a:cubicBezTo>
                    <a:pt x="101" y="10621"/>
                    <a:pt x="0" y="9415"/>
                    <a:pt x="0" y="8207"/>
                  </a:cubicBezTo>
                  <a:cubicBezTo>
                    <a:pt x="0" y="5391"/>
                    <a:pt x="550" y="2603"/>
                    <a:pt x="1619" y="-1"/>
                  </a:cubicBezTo>
                </a:path>
                <a:path w="21600" h="11813" stroke="0" extrusionOk="0">
                  <a:moveTo>
                    <a:pt x="303" y="11812"/>
                  </a:moveTo>
                  <a:cubicBezTo>
                    <a:pt x="101" y="10621"/>
                    <a:pt x="0" y="9415"/>
                    <a:pt x="0" y="8207"/>
                  </a:cubicBezTo>
                  <a:cubicBezTo>
                    <a:pt x="0" y="5391"/>
                    <a:pt x="550" y="2603"/>
                    <a:pt x="1619" y="-1"/>
                  </a:cubicBezTo>
                  <a:lnTo>
                    <a:pt x="21600" y="820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Line 338"/>
            <p:cNvSpPr>
              <a:spLocks noChangeShapeType="1"/>
            </p:cNvSpPr>
            <p:nvPr/>
          </p:nvSpPr>
          <p:spPr bwMode="auto">
            <a:xfrm>
              <a:off x="1245" y="2855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Rectangle 339"/>
            <p:cNvSpPr>
              <a:spLocks noChangeArrowheads="1"/>
            </p:cNvSpPr>
            <p:nvPr/>
          </p:nvSpPr>
          <p:spPr bwMode="auto">
            <a:xfrm rot="1620000">
              <a:off x="510" y="2300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D2/Taiwan/19933/2015</a:t>
              </a:r>
            </a:p>
          </p:txBody>
        </p:sp>
        <p:sp>
          <p:nvSpPr>
            <p:cNvPr id="140" name="Line 340"/>
            <p:cNvSpPr>
              <a:spLocks noChangeShapeType="1"/>
            </p:cNvSpPr>
            <p:nvPr/>
          </p:nvSpPr>
          <p:spPr bwMode="auto">
            <a:xfrm>
              <a:off x="1293" y="2549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Arc 341"/>
            <p:cNvSpPr>
              <a:spLocks/>
            </p:cNvSpPr>
            <p:nvPr/>
          </p:nvSpPr>
          <p:spPr bwMode="auto">
            <a:xfrm>
              <a:off x="1240" y="2699"/>
              <a:ext cx="483" cy="156"/>
            </a:xfrm>
            <a:custGeom>
              <a:avLst/>
              <a:gdLst>
                <a:gd name="G0" fmla="+- 21600 0 0"/>
                <a:gd name="G1" fmla="+- 3395 0 0"/>
                <a:gd name="G2" fmla="+- 21600 0 0"/>
                <a:gd name="T0" fmla="*/ 303 w 21600"/>
                <a:gd name="T1" fmla="*/ 7001 h 7001"/>
                <a:gd name="T2" fmla="*/ 268 w 21600"/>
                <a:gd name="T3" fmla="*/ 0 h 7001"/>
                <a:gd name="T4" fmla="*/ 21600 w 21600"/>
                <a:gd name="T5" fmla="*/ 3395 h 70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7001" fill="none" extrusionOk="0">
                  <a:moveTo>
                    <a:pt x="303" y="7000"/>
                  </a:moveTo>
                  <a:cubicBezTo>
                    <a:pt x="101" y="5809"/>
                    <a:pt x="0" y="4603"/>
                    <a:pt x="0" y="3395"/>
                  </a:cubicBezTo>
                  <a:cubicBezTo>
                    <a:pt x="0" y="2258"/>
                    <a:pt x="89" y="1122"/>
                    <a:pt x="268" y="0"/>
                  </a:cubicBezTo>
                </a:path>
                <a:path w="21600" h="7001" stroke="0" extrusionOk="0">
                  <a:moveTo>
                    <a:pt x="303" y="7000"/>
                  </a:moveTo>
                  <a:cubicBezTo>
                    <a:pt x="101" y="5809"/>
                    <a:pt x="0" y="4603"/>
                    <a:pt x="0" y="3395"/>
                  </a:cubicBezTo>
                  <a:cubicBezTo>
                    <a:pt x="0" y="2258"/>
                    <a:pt x="89" y="1122"/>
                    <a:pt x="268" y="0"/>
                  </a:cubicBezTo>
                  <a:lnTo>
                    <a:pt x="21600" y="3395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Arc 342"/>
            <p:cNvSpPr>
              <a:spLocks/>
            </p:cNvSpPr>
            <p:nvPr/>
          </p:nvSpPr>
          <p:spPr bwMode="auto">
            <a:xfrm>
              <a:off x="1246" y="2550"/>
              <a:ext cx="477" cy="225"/>
            </a:xfrm>
            <a:custGeom>
              <a:avLst/>
              <a:gdLst>
                <a:gd name="G0" fmla="+- 21332 0 0"/>
                <a:gd name="G1" fmla="+- 10057 0 0"/>
                <a:gd name="G2" fmla="+- 21600 0 0"/>
                <a:gd name="T0" fmla="*/ 0 w 21332"/>
                <a:gd name="T1" fmla="*/ 6662 h 10057"/>
                <a:gd name="T2" fmla="*/ 2216 w 21332"/>
                <a:gd name="T3" fmla="*/ 0 h 10057"/>
                <a:gd name="T4" fmla="*/ 21332 w 21332"/>
                <a:gd name="T5" fmla="*/ 10057 h 100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332" h="10057" fill="none" extrusionOk="0">
                  <a:moveTo>
                    <a:pt x="0" y="6662"/>
                  </a:moveTo>
                  <a:cubicBezTo>
                    <a:pt x="370" y="4335"/>
                    <a:pt x="1119" y="2085"/>
                    <a:pt x="2216" y="0"/>
                  </a:cubicBezTo>
                </a:path>
                <a:path w="21332" h="10057" stroke="0" extrusionOk="0">
                  <a:moveTo>
                    <a:pt x="0" y="6662"/>
                  </a:moveTo>
                  <a:cubicBezTo>
                    <a:pt x="370" y="4335"/>
                    <a:pt x="1119" y="2085"/>
                    <a:pt x="2216" y="0"/>
                  </a:cubicBezTo>
                  <a:lnTo>
                    <a:pt x="21332" y="1005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Line 344"/>
            <p:cNvSpPr>
              <a:spLocks noChangeShapeType="1"/>
            </p:cNvSpPr>
            <p:nvPr/>
          </p:nvSpPr>
          <p:spPr bwMode="auto">
            <a:xfrm>
              <a:off x="1245" y="2699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Rectangle 345"/>
            <p:cNvSpPr>
              <a:spLocks noChangeArrowheads="1"/>
            </p:cNvSpPr>
            <p:nvPr/>
          </p:nvSpPr>
          <p:spPr bwMode="auto">
            <a:xfrm rot="1920000">
              <a:off x="282" y="2085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7165/2015</a:t>
              </a:r>
            </a:p>
          </p:txBody>
        </p:sp>
        <p:sp>
          <p:nvSpPr>
            <p:cNvPr id="146" name="Line 346"/>
            <p:cNvSpPr>
              <a:spLocks noChangeShapeType="1"/>
            </p:cNvSpPr>
            <p:nvPr/>
          </p:nvSpPr>
          <p:spPr bwMode="auto">
            <a:xfrm flipH="1" flipV="1">
              <a:off x="1046" y="2340"/>
              <a:ext cx="204" cy="1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Rectangle 347"/>
            <p:cNvSpPr>
              <a:spLocks noChangeArrowheads="1"/>
            </p:cNvSpPr>
            <p:nvPr/>
          </p:nvSpPr>
          <p:spPr bwMode="auto">
            <a:xfrm rot="2280000">
              <a:off x="348" y="1975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7075/2015</a:t>
              </a:r>
            </a:p>
          </p:txBody>
        </p:sp>
        <p:sp>
          <p:nvSpPr>
            <p:cNvPr id="148" name="Line 348"/>
            <p:cNvSpPr>
              <a:spLocks noChangeShapeType="1"/>
            </p:cNvSpPr>
            <p:nvPr/>
          </p:nvSpPr>
          <p:spPr bwMode="auto">
            <a:xfrm>
              <a:off x="1089" y="2276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Rectangle 349"/>
            <p:cNvSpPr>
              <a:spLocks noChangeArrowheads="1"/>
            </p:cNvSpPr>
            <p:nvPr/>
          </p:nvSpPr>
          <p:spPr bwMode="auto">
            <a:xfrm rot="2580000">
              <a:off x="304" y="1799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9011/2015</a:t>
              </a:r>
            </a:p>
          </p:txBody>
        </p:sp>
        <p:sp>
          <p:nvSpPr>
            <p:cNvPr id="150" name="Line 350"/>
            <p:cNvSpPr>
              <a:spLocks noChangeShapeType="1"/>
            </p:cNvSpPr>
            <p:nvPr/>
          </p:nvSpPr>
          <p:spPr bwMode="auto">
            <a:xfrm flipH="1" flipV="1">
              <a:off x="1020" y="2110"/>
              <a:ext cx="118" cy="1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Arc 351"/>
            <p:cNvSpPr>
              <a:spLocks/>
            </p:cNvSpPr>
            <p:nvPr/>
          </p:nvSpPr>
          <p:spPr bwMode="auto">
            <a:xfrm>
              <a:off x="1091" y="2251"/>
              <a:ext cx="632" cy="524"/>
            </a:xfrm>
            <a:custGeom>
              <a:avLst/>
              <a:gdLst>
                <a:gd name="G0" fmla="+- 16961 0 0"/>
                <a:gd name="G1" fmla="+- 14094 0 0"/>
                <a:gd name="G2" fmla="+- 21600 0 0"/>
                <a:gd name="T0" fmla="*/ 0 w 16961"/>
                <a:gd name="T1" fmla="*/ 719 h 14094"/>
                <a:gd name="T2" fmla="*/ 593 w 16961"/>
                <a:gd name="T3" fmla="*/ 0 h 14094"/>
                <a:gd name="T4" fmla="*/ 16961 w 16961"/>
                <a:gd name="T5" fmla="*/ 14094 h 140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961" h="14094" fill="none" extrusionOk="0">
                  <a:moveTo>
                    <a:pt x="0" y="719"/>
                  </a:moveTo>
                  <a:cubicBezTo>
                    <a:pt x="192" y="475"/>
                    <a:pt x="390" y="235"/>
                    <a:pt x="592" y="-1"/>
                  </a:cubicBezTo>
                </a:path>
                <a:path w="16961" h="14094" stroke="0" extrusionOk="0">
                  <a:moveTo>
                    <a:pt x="0" y="719"/>
                  </a:moveTo>
                  <a:cubicBezTo>
                    <a:pt x="192" y="475"/>
                    <a:pt x="390" y="235"/>
                    <a:pt x="592" y="-1"/>
                  </a:cubicBezTo>
                  <a:lnTo>
                    <a:pt x="16961" y="14094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Arc 352"/>
            <p:cNvSpPr>
              <a:spLocks/>
            </p:cNvSpPr>
            <p:nvPr/>
          </p:nvSpPr>
          <p:spPr bwMode="auto">
            <a:xfrm>
              <a:off x="1113" y="2222"/>
              <a:ext cx="610" cy="553"/>
            </a:xfrm>
            <a:custGeom>
              <a:avLst/>
              <a:gdLst>
                <a:gd name="G0" fmla="+- 16368 0 0"/>
                <a:gd name="G1" fmla="+- 14853 0 0"/>
                <a:gd name="G2" fmla="+- 21600 0 0"/>
                <a:gd name="T0" fmla="*/ 0 w 16368"/>
                <a:gd name="T1" fmla="*/ 759 h 14853"/>
                <a:gd name="T2" fmla="*/ 685 w 16368"/>
                <a:gd name="T3" fmla="*/ 0 h 14853"/>
                <a:gd name="T4" fmla="*/ 16368 w 16368"/>
                <a:gd name="T5" fmla="*/ 14853 h 148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368" h="14853" fill="none" extrusionOk="0">
                  <a:moveTo>
                    <a:pt x="-1" y="758"/>
                  </a:moveTo>
                  <a:cubicBezTo>
                    <a:pt x="222" y="500"/>
                    <a:pt x="450" y="247"/>
                    <a:pt x="685" y="0"/>
                  </a:cubicBezTo>
                </a:path>
                <a:path w="16368" h="14853" stroke="0" extrusionOk="0">
                  <a:moveTo>
                    <a:pt x="-1" y="758"/>
                  </a:moveTo>
                  <a:cubicBezTo>
                    <a:pt x="222" y="500"/>
                    <a:pt x="450" y="247"/>
                    <a:pt x="685" y="0"/>
                  </a:cubicBezTo>
                  <a:lnTo>
                    <a:pt x="16368" y="14853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Rectangle 353"/>
            <p:cNvSpPr>
              <a:spLocks noChangeArrowheads="1"/>
            </p:cNvSpPr>
            <p:nvPr/>
          </p:nvSpPr>
          <p:spPr bwMode="auto">
            <a:xfrm rot="2400000">
              <a:off x="1136" y="2221"/>
              <a:ext cx="7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8</a:t>
              </a:r>
              <a:endParaRPr kumimoji="0" lang="zh-TW" altLang="zh-TW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4" name="Line 354"/>
            <p:cNvSpPr>
              <a:spLocks noChangeShapeType="1"/>
            </p:cNvSpPr>
            <p:nvPr/>
          </p:nvSpPr>
          <p:spPr bwMode="auto">
            <a:xfrm flipH="1" flipV="1">
              <a:off x="1111" y="2249"/>
              <a:ext cx="182" cy="1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Arc 355"/>
            <p:cNvSpPr>
              <a:spLocks/>
            </p:cNvSpPr>
            <p:nvPr/>
          </p:nvSpPr>
          <p:spPr bwMode="auto">
            <a:xfrm>
              <a:off x="1250" y="2437"/>
              <a:ext cx="473" cy="338"/>
            </a:xfrm>
            <a:custGeom>
              <a:avLst/>
              <a:gdLst>
                <a:gd name="G0" fmla="+- 18126 0 0"/>
                <a:gd name="G1" fmla="+- 12969 0 0"/>
                <a:gd name="G2" fmla="+- 21600 0 0"/>
                <a:gd name="T0" fmla="*/ 0 w 18126"/>
                <a:gd name="T1" fmla="*/ 1222 h 12969"/>
                <a:gd name="T2" fmla="*/ 852 w 18126"/>
                <a:gd name="T3" fmla="*/ 0 h 12969"/>
                <a:gd name="T4" fmla="*/ 18126 w 18126"/>
                <a:gd name="T5" fmla="*/ 12969 h 129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126" h="12969" fill="none" extrusionOk="0">
                  <a:moveTo>
                    <a:pt x="-1" y="1221"/>
                  </a:moveTo>
                  <a:cubicBezTo>
                    <a:pt x="269" y="804"/>
                    <a:pt x="554" y="397"/>
                    <a:pt x="852" y="0"/>
                  </a:cubicBezTo>
                </a:path>
                <a:path w="18126" h="12969" stroke="0" extrusionOk="0">
                  <a:moveTo>
                    <a:pt x="-1" y="1221"/>
                  </a:moveTo>
                  <a:cubicBezTo>
                    <a:pt x="269" y="804"/>
                    <a:pt x="554" y="397"/>
                    <a:pt x="852" y="0"/>
                  </a:cubicBezTo>
                  <a:lnTo>
                    <a:pt x="18126" y="12969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Arc 356"/>
            <p:cNvSpPr>
              <a:spLocks/>
            </p:cNvSpPr>
            <p:nvPr/>
          </p:nvSpPr>
          <p:spPr bwMode="auto">
            <a:xfrm>
              <a:off x="1272" y="2408"/>
              <a:ext cx="451" cy="367"/>
            </a:xfrm>
            <a:custGeom>
              <a:avLst/>
              <a:gdLst>
                <a:gd name="G0" fmla="+- 17274 0 0"/>
                <a:gd name="G1" fmla="+- 14103 0 0"/>
                <a:gd name="G2" fmla="+- 21600 0 0"/>
                <a:gd name="T0" fmla="*/ 0 w 17274"/>
                <a:gd name="T1" fmla="*/ 1134 h 14103"/>
                <a:gd name="T2" fmla="*/ 913 w 17274"/>
                <a:gd name="T3" fmla="*/ 0 h 14103"/>
                <a:gd name="T4" fmla="*/ 17274 w 17274"/>
                <a:gd name="T5" fmla="*/ 14103 h 14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74" h="14103" fill="none" extrusionOk="0">
                  <a:moveTo>
                    <a:pt x="0" y="1134"/>
                  </a:moveTo>
                  <a:cubicBezTo>
                    <a:pt x="291" y="746"/>
                    <a:pt x="596" y="367"/>
                    <a:pt x="913" y="0"/>
                  </a:cubicBezTo>
                </a:path>
                <a:path w="17274" h="14103" stroke="0" extrusionOk="0">
                  <a:moveTo>
                    <a:pt x="0" y="1134"/>
                  </a:moveTo>
                  <a:cubicBezTo>
                    <a:pt x="291" y="746"/>
                    <a:pt x="596" y="367"/>
                    <a:pt x="913" y="0"/>
                  </a:cubicBezTo>
                  <a:lnTo>
                    <a:pt x="17274" y="14103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Line 358"/>
            <p:cNvSpPr>
              <a:spLocks noChangeShapeType="1"/>
            </p:cNvSpPr>
            <p:nvPr/>
          </p:nvSpPr>
          <p:spPr bwMode="auto">
            <a:xfrm flipH="1" flipV="1">
              <a:off x="1272" y="2437"/>
              <a:ext cx="64" cy="4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Arc 359"/>
            <p:cNvSpPr>
              <a:spLocks/>
            </p:cNvSpPr>
            <p:nvPr/>
          </p:nvSpPr>
          <p:spPr bwMode="auto">
            <a:xfrm>
              <a:off x="1246" y="2587"/>
              <a:ext cx="477" cy="188"/>
            </a:xfrm>
            <a:custGeom>
              <a:avLst/>
              <a:gdLst>
                <a:gd name="G0" fmla="+- 21332 0 0"/>
                <a:gd name="G1" fmla="+- 8397 0 0"/>
                <a:gd name="G2" fmla="+- 21600 0 0"/>
                <a:gd name="T0" fmla="*/ 0 w 21332"/>
                <a:gd name="T1" fmla="*/ 5002 h 8397"/>
                <a:gd name="T2" fmla="*/ 1431 w 21332"/>
                <a:gd name="T3" fmla="*/ 0 h 8397"/>
                <a:gd name="T4" fmla="*/ 21332 w 21332"/>
                <a:gd name="T5" fmla="*/ 8397 h 83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332" h="8397" fill="none" extrusionOk="0">
                  <a:moveTo>
                    <a:pt x="0" y="5002"/>
                  </a:moveTo>
                  <a:cubicBezTo>
                    <a:pt x="274" y="3283"/>
                    <a:pt x="754" y="1603"/>
                    <a:pt x="1430" y="-1"/>
                  </a:cubicBezTo>
                </a:path>
                <a:path w="21332" h="8397" stroke="0" extrusionOk="0">
                  <a:moveTo>
                    <a:pt x="0" y="5002"/>
                  </a:moveTo>
                  <a:cubicBezTo>
                    <a:pt x="274" y="3283"/>
                    <a:pt x="754" y="1603"/>
                    <a:pt x="1430" y="-1"/>
                  </a:cubicBezTo>
                  <a:lnTo>
                    <a:pt x="21332" y="839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Arc 360"/>
            <p:cNvSpPr>
              <a:spLocks/>
            </p:cNvSpPr>
            <p:nvPr/>
          </p:nvSpPr>
          <p:spPr bwMode="auto">
            <a:xfrm>
              <a:off x="1278" y="2485"/>
              <a:ext cx="445" cy="290"/>
            </a:xfrm>
            <a:custGeom>
              <a:avLst/>
              <a:gdLst>
                <a:gd name="G0" fmla="+- 19901 0 0"/>
                <a:gd name="G1" fmla="+- 12961 0 0"/>
                <a:gd name="G2" fmla="+- 21600 0 0"/>
                <a:gd name="T0" fmla="*/ 0 w 19901"/>
                <a:gd name="T1" fmla="*/ 4564 h 12961"/>
                <a:gd name="T2" fmla="*/ 2622 w 19901"/>
                <a:gd name="T3" fmla="*/ 0 h 12961"/>
                <a:gd name="T4" fmla="*/ 19901 w 19901"/>
                <a:gd name="T5" fmla="*/ 12961 h 129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901" h="12961" fill="none" extrusionOk="0">
                  <a:moveTo>
                    <a:pt x="-1" y="4563"/>
                  </a:moveTo>
                  <a:cubicBezTo>
                    <a:pt x="684" y="2941"/>
                    <a:pt x="1565" y="1408"/>
                    <a:pt x="2621" y="-1"/>
                  </a:cubicBezTo>
                </a:path>
                <a:path w="19901" h="12961" stroke="0" extrusionOk="0">
                  <a:moveTo>
                    <a:pt x="-1" y="4563"/>
                  </a:moveTo>
                  <a:cubicBezTo>
                    <a:pt x="684" y="2941"/>
                    <a:pt x="1565" y="1408"/>
                    <a:pt x="2621" y="-1"/>
                  </a:cubicBezTo>
                  <a:lnTo>
                    <a:pt x="19901" y="1296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Line 362"/>
            <p:cNvSpPr>
              <a:spLocks noChangeShapeType="1"/>
            </p:cNvSpPr>
            <p:nvPr/>
          </p:nvSpPr>
          <p:spPr bwMode="auto">
            <a:xfrm>
              <a:off x="1277" y="2587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Rectangle 363"/>
            <p:cNvSpPr>
              <a:spLocks noChangeArrowheads="1"/>
            </p:cNvSpPr>
            <p:nvPr/>
          </p:nvSpPr>
          <p:spPr bwMode="auto">
            <a:xfrm rot="2880000">
              <a:off x="548" y="1884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6351/2015</a:t>
              </a:r>
            </a:p>
          </p:txBody>
        </p:sp>
        <p:sp>
          <p:nvSpPr>
            <p:cNvPr id="164" name="Line 364"/>
            <p:cNvSpPr>
              <a:spLocks noChangeShapeType="1"/>
            </p:cNvSpPr>
            <p:nvPr/>
          </p:nvSpPr>
          <p:spPr bwMode="auto">
            <a:xfrm flipH="1" flipV="1">
              <a:off x="1245" y="2228"/>
              <a:ext cx="161" cy="1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Arc 365"/>
            <p:cNvSpPr>
              <a:spLocks/>
            </p:cNvSpPr>
            <p:nvPr/>
          </p:nvSpPr>
          <p:spPr bwMode="auto">
            <a:xfrm>
              <a:off x="1278" y="2491"/>
              <a:ext cx="445" cy="284"/>
            </a:xfrm>
            <a:custGeom>
              <a:avLst/>
              <a:gdLst>
                <a:gd name="G0" fmla="+- 19901 0 0"/>
                <a:gd name="G1" fmla="+- 12710 0 0"/>
                <a:gd name="G2" fmla="+- 21600 0 0"/>
                <a:gd name="T0" fmla="*/ 0 w 19901"/>
                <a:gd name="T1" fmla="*/ 4313 h 12710"/>
                <a:gd name="T2" fmla="*/ 2437 w 19901"/>
                <a:gd name="T3" fmla="*/ 0 h 12710"/>
                <a:gd name="T4" fmla="*/ 19901 w 19901"/>
                <a:gd name="T5" fmla="*/ 12710 h 127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901" h="12710" fill="none" extrusionOk="0">
                  <a:moveTo>
                    <a:pt x="-1" y="4312"/>
                  </a:moveTo>
                  <a:cubicBezTo>
                    <a:pt x="644" y="2786"/>
                    <a:pt x="1461" y="1339"/>
                    <a:pt x="2436" y="-1"/>
                  </a:cubicBezTo>
                </a:path>
                <a:path w="19901" h="12710" stroke="0" extrusionOk="0">
                  <a:moveTo>
                    <a:pt x="-1" y="4312"/>
                  </a:moveTo>
                  <a:cubicBezTo>
                    <a:pt x="644" y="2786"/>
                    <a:pt x="1461" y="1339"/>
                    <a:pt x="2436" y="-1"/>
                  </a:cubicBezTo>
                  <a:lnTo>
                    <a:pt x="19901" y="1271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Arc 366"/>
            <p:cNvSpPr>
              <a:spLocks/>
            </p:cNvSpPr>
            <p:nvPr/>
          </p:nvSpPr>
          <p:spPr bwMode="auto">
            <a:xfrm>
              <a:off x="1332" y="2411"/>
              <a:ext cx="391" cy="364"/>
            </a:xfrm>
            <a:custGeom>
              <a:avLst/>
              <a:gdLst>
                <a:gd name="G0" fmla="+- 17464 0 0"/>
                <a:gd name="G1" fmla="+- 16315 0 0"/>
                <a:gd name="G2" fmla="+- 21600 0 0"/>
                <a:gd name="T0" fmla="*/ 0 w 17464"/>
                <a:gd name="T1" fmla="*/ 3605 h 16315"/>
                <a:gd name="T2" fmla="*/ 3309 w 17464"/>
                <a:gd name="T3" fmla="*/ 0 h 16315"/>
                <a:gd name="T4" fmla="*/ 17464 w 17464"/>
                <a:gd name="T5" fmla="*/ 16315 h 163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464" h="16315" fill="none" extrusionOk="0">
                  <a:moveTo>
                    <a:pt x="-1" y="3604"/>
                  </a:moveTo>
                  <a:cubicBezTo>
                    <a:pt x="962" y="2281"/>
                    <a:pt x="2072" y="1072"/>
                    <a:pt x="3308" y="-1"/>
                  </a:cubicBezTo>
                </a:path>
                <a:path w="17464" h="16315" stroke="0" extrusionOk="0">
                  <a:moveTo>
                    <a:pt x="-1" y="3604"/>
                  </a:moveTo>
                  <a:cubicBezTo>
                    <a:pt x="962" y="2281"/>
                    <a:pt x="2072" y="1072"/>
                    <a:pt x="3308" y="-1"/>
                  </a:cubicBezTo>
                  <a:lnTo>
                    <a:pt x="17464" y="16315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Line 368"/>
            <p:cNvSpPr>
              <a:spLocks noChangeShapeType="1"/>
            </p:cNvSpPr>
            <p:nvPr/>
          </p:nvSpPr>
          <p:spPr bwMode="auto">
            <a:xfrm>
              <a:off x="1331" y="249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Rectangle 369"/>
            <p:cNvSpPr>
              <a:spLocks noChangeArrowheads="1"/>
            </p:cNvSpPr>
            <p:nvPr/>
          </p:nvSpPr>
          <p:spPr bwMode="auto">
            <a:xfrm rot="3240000">
              <a:off x="120" y="1101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16504/2015</a:t>
              </a:r>
            </a:p>
          </p:txBody>
        </p:sp>
        <p:sp>
          <p:nvSpPr>
            <p:cNvPr id="170" name="Line 370"/>
            <p:cNvSpPr>
              <a:spLocks noChangeShapeType="1"/>
            </p:cNvSpPr>
            <p:nvPr/>
          </p:nvSpPr>
          <p:spPr bwMode="auto">
            <a:xfrm flipH="1" flipV="1">
              <a:off x="778" y="1472"/>
              <a:ext cx="666" cy="91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Arc 371"/>
            <p:cNvSpPr>
              <a:spLocks/>
            </p:cNvSpPr>
            <p:nvPr/>
          </p:nvSpPr>
          <p:spPr bwMode="auto">
            <a:xfrm>
              <a:off x="1332" y="2434"/>
              <a:ext cx="391" cy="341"/>
            </a:xfrm>
            <a:custGeom>
              <a:avLst/>
              <a:gdLst>
                <a:gd name="G0" fmla="+- 17464 0 0"/>
                <a:gd name="G1" fmla="+- 15281 0 0"/>
                <a:gd name="G2" fmla="+- 21600 0 0"/>
                <a:gd name="T0" fmla="*/ 0 w 17464"/>
                <a:gd name="T1" fmla="*/ 2571 h 15281"/>
                <a:gd name="T2" fmla="*/ 2198 w 17464"/>
                <a:gd name="T3" fmla="*/ 0 h 15281"/>
                <a:gd name="T4" fmla="*/ 17464 w 17464"/>
                <a:gd name="T5" fmla="*/ 15281 h 152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464" h="15281" fill="none" extrusionOk="0">
                  <a:moveTo>
                    <a:pt x="-1" y="2570"/>
                  </a:moveTo>
                  <a:cubicBezTo>
                    <a:pt x="664" y="1657"/>
                    <a:pt x="1399" y="798"/>
                    <a:pt x="2197" y="-1"/>
                  </a:cubicBezTo>
                </a:path>
                <a:path w="17464" h="15281" stroke="0" extrusionOk="0">
                  <a:moveTo>
                    <a:pt x="-1" y="2570"/>
                  </a:moveTo>
                  <a:cubicBezTo>
                    <a:pt x="664" y="1657"/>
                    <a:pt x="1399" y="798"/>
                    <a:pt x="2197" y="-1"/>
                  </a:cubicBezTo>
                  <a:lnTo>
                    <a:pt x="17464" y="1528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Arc 372"/>
            <p:cNvSpPr>
              <a:spLocks/>
            </p:cNvSpPr>
            <p:nvPr/>
          </p:nvSpPr>
          <p:spPr bwMode="auto">
            <a:xfrm>
              <a:off x="1382" y="2385"/>
              <a:ext cx="341" cy="390"/>
            </a:xfrm>
            <a:custGeom>
              <a:avLst/>
              <a:gdLst>
                <a:gd name="G0" fmla="+- 15266 0 0"/>
                <a:gd name="G1" fmla="+- 17477 0 0"/>
                <a:gd name="G2" fmla="+- 21600 0 0"/>
                <a:gd name="T0" fmla="*/ 0 w 15266"/>
                <a:gd name="T1" fmla="*/ 2196 h 17477"/>
                <a:gd name="T2" fmla="*/ 2573 w 15266"/>
                <a:gd name="T3" fmla="*/ 0 h 17477"/>
                <a:gd name="T4" fmla="*/ 15266 w 15266"/>
                <a:gd name="T5" fmla="*/ 17477 h 174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266" h="17477" fill="none" extrusionOk="0">
                  <a:moveTo>
                    <a:pt x="-1" y="2195"/>
                  </a:moveTo>
                  <a:cubicBezTo>
                    <a:pt x="798" y="1397"/>
                    <a:pt x="1659" y="663"/>
                    <a:pt x="2572" y="-1"/>
                  </a:cubicBezTo>
                </a:path>
                <a:path w="15266" h="17477" stroke="0" extrusionOk="0">
                  <a:moveTo>
                    <a:pt x="-1" y="2195"/>
                  </a:moveTo>
                  <a:cubicBezTo>
                    <a:pt x="798" y="1397"/>
                    <a:pt x="1659" y="663"/>
                    <a:pt x="2572" y="-1"/>
                  </a:cubicBezTo>
                  <a:lnTo>
                    <a:pt x="15266" y="1747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Line 374"/>
            <p:cNvSpPr>
              <a:spLocks noChangeShapeType="1"/>
            </p:cNvSpPr>
            <p:nvPr/>
          </p:nvSpPr>
          <p:spPr bwMode="auto">
            <a:xfrm flipH="1" flipV="1">
              <a:off x="1379" y="2431"/>
              <a:ext cx="59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Rectangle 375"/>
            <p:cNvSpPr>
              <a:spLocks noChangeArrowheads="1"/>
            </p:cNvSpPr>
            <p:nvPr/>
          </p:nvSpPr>
          <p:spPr bwMode="auto">
            <a:xfrm rot="3540000">
              <a:off x="841" y="1978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31711/2015</a:t>
              </a:r>
            </a:p>
          </p:txBody>
        </p:sp>
        <p:sp>
          <p:nvSpPr>
            <p:cNvPr id="176" name="Line 376"/>
            <p:cNvSpPr>
              <a:spLocks noChangeShapeType="1"/>
            </p:cNvSpPr>
            <p:nvPr/>
          </p:nvSpPr>
          <p:spPr bwMode="auto">
            <a:xfrm flipH="1" flipV="1">
              <a:off x="1476" y="2362"/>
              <a:ext cx="43" cy="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Arc 377"/>
            <p:cNvSpPr>
              <a:spLocks/>
            </p:cNvSpPr>
            <p:nvPr/>
          </p:nvSpPr>
          <p:spPr bwMode="auto">
            <a:xfrm>
              <a:off x="1438" y="2457"/>
              <a:ext cx="285" cy="317"/>
            </a:xfrm>
            <a:custGeom>
              <a:avLst/>
              <a:gdLst>
                <a:gd name="G0" fmla="+- 15291 0 0"/>
                <a:gd name="G1" fmla="+- 17026 0 0"/>
                <a:gd name="G2" fmla="+- 21600 0 0"/>
                <a:gd name="T0" fmla="*/ 0 w 15291"/>
                <a:gd name="T1" fmla="*/ 1770 h 17026"/>
                <a:gd name="T2" fmla="*/ 1999 w 15291"/>
                <a:gd name="T3" fmla="*/ 0 h 17026"/>
                <a:gd name="T4" fmla="*/ 15291 w 15291"/>
                <a:gd name="T5" fmla="*/ 17026 h 170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291" h="17026" fill="none" extrusionOk="0">
                  <a:moveTo>
                    <a:pt x="0" y="1770"/>
                  </a:moveTo>
                  <a:cubicBezTo>
                    <a:pt x="629" y="1139"/>
                    <a:pt x="1296" y="548"/>
                    <a:pt x="1999" y="0"/>
                  </a:cubicBezTo>
                </a:path>
                <a:path w="15291" h="17026" stroke="0" extrusionOk="0">
                  <a:moveTo>
                    <a:pt x="0" y="1770"/>
                  </a:moveTo>
                  <a:cubicBezTo>
                    <a:pt x="629" y="1139"/>
                    <a:pt x="1296" y="548"/>
                    <a:pt x="1999" y="0"/>
                  </a:cubicBezTo>
                  <a:lnTo>
                    <a:pt x="15291" y="17026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Arc 378"/>
            <p:cNvSpPr>
              <a:spLocks/>
            </p:cNvSpPr>
            <p:nvPr/>
          </p:nvSpPr>
          <p:spPr bwMode="auto">
            <a:xfrm>
              <a:off x="1475" y="2427"/>
              <a:ext cx="248" cy="347"/>
            </a:xfrm>
            <a:custGeom>
              <a:avLst/>
              <a:gdLst>
                <a:gd name="G0" fmla="+- 13292 0 0"/>
                <a:gd name="G1" fmla="+- 18640 0 0"/>
                <a:gd name="G2" fmla="+- 21600 0 0"/>
                <a:gd name="T0" fmla="*/ 0 w 13292"/>
                <a:gd name="T1" fmla="*/ 1614 h 18640"/>
                <a:gd name="T2" fmla="*/ 2379 w 13292"/>
                <a:gd name="T3" fmla="*/ 0 h 18640"/>
                <a:gd name="T4" fmla="*/ 13292 w 13292"/>
                <a:gd name="T5" fmla="*/ 18640 h 186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292" h="18640" fill="none" extrusionOk="0">
                  <a:moveTo>
                    <a:pt x="0" y="1614"/>
                  </a:moveTo>
                  <a:cubicBezTo>
                    <a:pt x="756" y="1023"/>
                    <a:pt x="1550" y="484"/>
                    <a:pt x="2378" y="-1"/>
                  </a:cubicBezTo>
                </a:path>
                <a:path w="13292" h="18640" stroke="0" extrusionOk="0">
                  <a:moveTo>
                    <a:pt x="0" y="1614"/>
                  </a:moveTo>
                  <a:cubicBezTo>
                    <a:pt x="756" y="1023"/>
                    <a:pt x="1550" y="484"/>
                    <a:pt x="2378" y="-1"/>
                  </a:cubicBezTo>
                  <a:lnTo>
                    <a:pt x="13292" y="1864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Line 380"/>
            <p:cNvSpPr>
              <a:spLocks noChangeShapeType="1"/>
            </p:cNvSpPr>
            <p:nvPr/>
          </p:nvSpPr>
          <p:spPr bwMode="auto">
            <a:xfrm flipH="1" flipV="1">
              <a:off x="1476" y="2458"/>
              <a:ext cx="53" cy="6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Rectangle 381"/>
            <p:cNvSpPr>
              <a:spLocks noChangeArrowheads="1"/>
            </p:cNvSpPr>
            <p:nvPr/>
          </p:nvSpPr>
          <p:spPr bwMode="auto">
            <a:xfrm rot="3840000">
              <a:off x="922" y="1933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D2/Taiwan/24774/2015</a:t>
              </a:r>
            </a:p>
          </p:txBody>
        </p:sp>
        <p:sp>
          <p:nvSpPr>
            <p:cNvPr id="182" name="Line 382"/>
            <p:cNvSpPr>
              <a:spLocks noChangeShapeType="1"/>
            </p:cNvSpPr>
            <p:nvPr/>
          </p:nvSpPr>
          <p:spPr bwMode="auto">
            <a:xfrm flipH="1" flipV="1">
              <a:off x="1519" y="2340"/>
              <a:ext cx="64" cy="1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Arc 383"/>
            <p:cNvSpPr>
              <a:spLocks/>
            </p:cNvSpPr>
            <p:nvPr/>
          </p:nvSpPr>
          <p:spPr bwMode="auto">
            <a:xfrm>
              <a:off x="1524" y="2500"/>
              <a:ext cx="199" cy="275"/>
            </a:xfrm>
            <a:custGeom>
              <a:avLst/>
              <a:gdLst>
                <a:gd name="G0" fmla="+- 13374 0 0"/>
                <a:gd name="G1" fmla="+- 18452 0 0"/>
                <a:gd name="G2" fmla="+- 21600 0 0"/>
                <a:gd name="T0" fmla="*/ 0 w 13374"/>
                <a:gd name="T1" fmla="*/ 1490 h 18452"/>
                <a:gd name="T2" fmla="*/ 2145 w 13374"/>
                <a:gd name="T3" fmla="*/ 0 h 18452"/>
                <a:gd name="T4" fmla="*/ 13374 w 13374"/>
                <a:gd name="T5" fmla="*/ 18452 h 184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74" h="18452" fill="none" extrusionOk="0">
                  <a:moveTo>
                    <a:pt x="0" y="1490"/>
                  </a:moveTo>
                  <a:cubicBezTo>
                    <a:pt x="684" y="950"/>
                    <a:pt x="1400" y="453"/>
                    <a:pt x="2145" y="0"/>
                  </a:cubicBezTo>
                </a:path>
                <a:path w="13374" h="18452" stroke="0" extrusionOk="0">
                  <a:moveTo>
                    <a:pt x="0" y="1490"/>
                  </a:moveTo>
                  <a:cubicBezTo>
                    <a:pt x="684" y="950"/>
                    <a:pt x="1400" y="453"/>
                    <a:pt x="2145" y="0"/>
                  </a:cubicBezTo>
                  <a:lnTo>
                    <a:pt x="13374" y="18452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Arc 384"/>
            <p:cNvSpPr>
              <a:spLocks/>
            </p:cNvSpPr>
            <p:nvPr/>
          </p:nvSpPr>
          <p:spPr bwMode="auto">
            <a:xfrm>
              <a:off x="1556" y="2484"/>
              <a:ext cx="167" cy="291"/>
            </a:xfrm>
            <a:custGeom>
              <a:avLst/>
              <a:gdLst>
                <a:gd name="G0" fmla="+- 11229 0 0"/>
                <a:gd name="G1" fmla="+- 19526 0 0"/>
                <a:gd name="G2" fmla="+- 21600 0 0"/>
                <a:gd name="T0" fmla="*/ 0 w 11229"/>
                <a:gd name="T1" fmla="*/ 1074 h 19526"/>
                <a:gd name="T2" fmla="*/ 1994 w 11229"/>
                <a:gd name="T3" fmla="*/ 0 h 19526"/>
                <a:gd name="T4" fmla="*/ 11229 w 11229"/>
                <a:gd name="T5" fmla="*/ 19526 h 195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29" h="19526" fill="none" extrusionOk="0">
                  <a:moveTo>
                    <a:pt x="0" y="1074"/>
                  </a:moveTo>
                  <a:cubicBezTo>
                    <a:pt x="645" y="681"/>
                    <a:pt x="1310" y="322"/>
                    <a:pt x="1993" y="-1"/>
                  </a:cubicBezTo>
                </a:path>
                <a:path w="11229" h="19526" stroke="0" extrusionOk="0">
                  <a:moveTo>
                    <a:pt x="0" y="1074"/>
                  </a:moveTo>
                  <a:cubicBezTo>
                    <a:pt x="645" y="681"/>
                    <a:pt x="1310" y="322"/>
                    <a:pt x="1993" y="-1"/>
                  </a:cubicBezTo>
                  <a:lnTo>
                    <a:pt x="11229" y="19526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Line 385"/>
            <p:cNvSpPr>
              <a:spLocks noChangeShapeType="1"/>
            </p:cNvSpPr>
            <p:nvPr/>
          </p:nvSpPr>
          <p:spPr bwMode="auto">
            <a:xfrm flipH="1">
              <a:off x="1556" y="2501"/>
              <a:ext cx="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Rectangle 386"/>
            <p:cNvSpPr>
              <a:spLocks noChangeArrowheads="1"/>
            </p:cNvSpPr>
            <p:nvPr/>
          </p:nvSpPr>
          <p:spPr bwMode="auto">
            <a:xfrm rot="4200000">
              <a:off x="608" y="830"/>
              <a:ext cx="84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000" b="1" i="0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  <a:cs typeface="Arial" panose="020B0604020202020204" pitchFamily="34" charset="0"/>
                </a:rPr>
                <a:t>D2/Taiwan/19622/2015</a:t>
              </a:r>
            </a:p>
          </p:txBody>
        </p:sp>
        <p:sp>
          <p:nvSpPr>
            <p:cNvPr id="187" name="Line 387"/>
            <p:cNvSpPr>
              <a:spLocks noChangeShapeType="1"/>
            </p:cNvSpPr>
            <p:nvPr/>
          </p:nvSpPr>
          <p:spPr bwMode="auto">
            <a:xfrm flipH="1" flipV="1">
              <a:off x="1170" y="1263"/>
              <a:ext cx="440" cy="121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Arc 388"/>
            <p:cNvSpPr>
              <a:spLocks/>
            </p:cNvSpPr>
            <p:nvPr/>
          </p:nvSpPr>
          <p:spPr bwMode="auto">
            <a:xfrm>
              <a:off x="1556" y="2485"/>
              <a:ext cx="167" cy="290"/>
            </a:xfrm>
            <a:custGeom>
              <a:avLst/>
              <a:gdLst>
                <a:gd name="G0" fmla="+- 11229 0 0"/>
                <a:gd name="G1" fmla="+- 19458 0 0"/>
                <a:gd name="G2" fmla="+- 21600 0 0"/>
                <a:gd name="T0" fmla="*/ 0 w 11229"/>
                <a:gd name="T1" fmla="*/ 1006 h 19458"/>
                <a:gd name="T2" fmla="*/ 1850 w 11229"/>
                <a:gd name="T3" fmla="*/ 0 h 19458"/>
                <a:gd name="T4" fmla="*/ 11229 w 11229"/>
                <a:gd name="T5" fmla="*/ 19458 h 19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29" h="19458" fill="none" extrusionOk="0">
                  <a:moveTo>
                    <a:pt x="0" y="1006"/>
                  </a:moveTo>
                  <a:cubicBezTo>
                    <a:pt x="600" y="641"/>
                    <a:pt x="1217" y="305"/>
                    <a:pt x="1850" y="0"/>
                  </a:cubicBezTo>
                </a:path>
                <a:path w="11229" h="19458" stroke="0" extrusionOk="0">
                  <a:moveTo>
                    <a:pt x="0" y="1006"/>
                  </a:moveTo>
                  <a:cubicBezTo>
                    <a:pt x="600" y="641"/>
                    <a:pt x="1217" y="305"/>
                    <a:pt x="1850" y="0"/>
                  </a:cubicBezTo>
                  <a:lnTo>
                    <a:pt x="11229" y="19458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Arc 389"/>
            <p:cNvSpPr>
              <a:spLocks/>
            </p:cNvSpPr>
            <p:nvPr/>
          </p:nvSpPr>
          <p:spPr bwMode="auto">
            <a:xfrm>
              <a:off x="1583" y="2474"/>
              <a:ext cx="140" cy="301"/>
            </a:xfrm>
            <a:custGeom>
              <a:avLst/>
              <a:gdLst>
                <a:gd name="G0" fmla="+- 9379 0 0"/>
                <a:gd name="G1" fmla="+- 20226 0 0"/>
                <a:gd name="G2" fmla="+- 21600 0 0"/>
                <a:gd name="T0" fmla="*/ 0 w 9379"/>
                <a:gd name="T1" fmla="*/ 768 h 20226"/>
                <a:gd name="T2" fmla="*/ 1798 w 9379"/>
                <a:gd name="T3" fmla="*/ 0 h 20226"/>
                <a:gd name="T4" fmla="*/ 9379 w 9379"/>
                <a:gd name="T5" fmla="*/ 20226 h 202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79" h="20226" fill="none" extrusionOk="0">
                  <a:moveTo>
                    <a:pt x="0" y="768"/>
                  </a:moveTo>
                  <a:cubicBezTo>
                    <a:pt x="587" y="485"/>
                    <a:pt x="1187" y="228"/>
                    <a:pt x="1798" y="0"/>
                  </a:cubicBezTo>
                </a:path>
                <a:path w="9379" h="20226" stroke="0" extrusionOk="0">
                  <a:moveTo>
                    <a:pt x="0" y="768"/>
                  </a:moveTo>
                  <a:cubicBezTo>
                    <a:pt x="587" y="485"/>
                    <a:pt x="1187" y="228"/>
                    <a:pt x="1798" y="0"/>
                  </a:cubicBezTo>
                  <a:lnTo>
                    <a:pt x="9379" y="20226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Line 390"/>
            <p:cNvSpPr>
              <a:spLocks noChangeShapeType="1"/>
            </p:cNvSpPr>
            <p:nvPr/>
          </p:nvSpPr>
          <p:spPr bwMode="auto">
            <a:xfrm>
              <a:off x="1666" y="1901"/>
              <a:ext cx="0" cy="40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Line 391"/>
            <p:cNvSpPr>
              <a:spLocks noChangeShapeType="1"/>
            </p:cNvSpPr>
            <p:nvPr/>
          </p:nvSpPr>
          <p:spPr bwMode="auto">
            <a:xfrm>
              <a:off x="1607" y="1901"/>
              <a:ext cx="5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Line 392"/>
            <p:cNvSpPr>
              <a:spLocks noChangeShapeType="1"/>
            </p:cNvSpPr>
            <p:nvPr/>
          </p:nvSpPr>
          <p:spPr bwMode="auto">
            <a:xfrm flipH="1">
              <a:off x="1607" y="2308"/>
              <a:ext cx="5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Rectangle 393"/>
            <p:cNvSpPr>
              <a:spLocks noChangeArrowheads="1"/>
            </p:cNvSpPr>
            <p:nvPr/>
          </p:nvSpPr>
          <p:spPr bwMode="auto">
            <a:xfrm>
              <a:off x="1485" y="2051"/>
              <a:ext cx="20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005</a:t>
              </a:r>
              <a:endParaRPr kumimoji="0" lang="zh-TW" altLang="zh-TW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345" name="文字方塊 344"/>
          <p:cNvSpPr txBox="1"/>
          <p:nvPr/>
        </p:nvSpPr>
        <p:spPr>
          <a:xfrm>
            <a:off x="128478" y="8095127"/>
            <a:ext cx="65194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Phylogeny of DENV 2 sequences from the patients with different severity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nsus sequences of DENV 2 from sera of enrolled patients and those of DENV 2 prototypes were analyzed by maximum likelihood method with 1000 bootstrap replicates. The bootstrap values of each genotype were indicated on the root of branches.</a:t>
            </a:r>
            <a:r>
              <a:rPr lang="zh-TW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 from mild cases (orange) and severe cases (blue) were indicated by different colors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14436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96E546CA-4082-409C-A4AE-E5396968B86A}"/>
              </a:ext>
            </a:extLst>
          </p:cNvPr>
          <p:cNvSpPr txBox="1"/>
          <p:nvPr/>
        </p:nvSpPr>
        <p:spPr>
          <a:xfrm>
            <a:off x="257347" y="7113282"/>
            <a:ext cx="65194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etected frequency/times of the SNVs/DVGs for each sample from severe and mild cases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(A)(B)(C) frequency of SNVs and (D)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ion times of DVGs in the sera of dengue infected patients with different severity were compared. </a:t>
            </a:r>
            <a:r>
              <a:rPr lang="zh-TW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cated p &lt; 0.001 in Mann-Whitney </a:t>
            </a:r>
            <a:r>
              <a:rPr lang="en-US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.</a:t>
            </a:r>
            <a:r>
              <a:rPr lang="zh-TW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*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p &lt; 0.0001 in Mann-Whitney </a:t>
            </a:r>
            <a:r>
              <a:rPr lang="en-US" altLang="zh-TW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.</a:t>
            </a:r>
            <a:r>
              <a:rPr lang="zh-TW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graphicFrame>
        <p:nvGraphicFramePr>
          <p:cNvPr id="3" name="物件 2">
            <a:extLst>
              <a:ext uri="{FF2B5EF4-FFF2-40B4-BE49-F238E27FC236}">
                <a16:creationId xmlns:a16="http://schemas.microsoft.com/office/drawing/2014/main" id="{170A16B4-EFE7-4CB4-B56A-BEEC284AB2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4260305"/>
              </p:ext>
            </p:extLst>
          </p:nvPr>
        </p:nvGraphicFramePr>
        <p:xfrm>
          <a:off x="242584" y="355742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66" name="Prism 8" r:id="rId3" imgW="2303788" imgH="3430467" progId="Prism8.Document">
                  <p:embed/>
                </p:oleObj>
              </mc:Choice>
              <mc:Fallback>
                <p:oleObj name="Prism 8" r:id="rId3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2584" y="355742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物件 3">
            <a:extLst>
              <a:ext uri="{FF2B5EF4-FFF2-40B4-BE49-F238E27FC236}">
                <a16:creationId xmlns:a16="http://schemas.microsoft.com/office/drawing/2014/main" id="{2B2B301B-FDE1-403D-8AD5-BE5B88DC75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4529113"/>
              </p:ext>
            </p:extLst>
          </p:nvPr>
        </p:nvGraphicFramePr>
        <p:xfrm>
          <a:off x="1857811" y="355742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67" name="Prism 8" r:id="rId5" imgW="2303788" imgH="3430467" progId="Prism8.Document">
                  <p:embed/>
                </p:oleObj>
              </mc:Choice>
              <mc:Fallback>
                <p:oleObj name="Prism 8" r:id="rId5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57811" y="355742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物件 4">
            <a:extLst>
              <a:ext uri="{FF2B5EF4-FFF2-40B4-BE49-F238E27FC236}">
                <a16:creationId xmlns:a16="http://schemas.microsoft.com/office/drawing/2014/main" id="{86832D09-C33F-4682-8A47-C57DBD679B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1250943"/>
              </p:ext>
            </p:extLst>
          </p:nvPr>
        </p:nvGraphicFramePr>
        <p:xfrm>
          <a:off x="3473038" y="355742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68" name="Prism 8" r:id="rId7" imgW="2303788" imgH="3430467" progId="Prism8.Document">
                  <p:embed/>
                </p:oleObj>
              </mc:Choice>
              <mc:Fallback>
                <p:oleObj name="Prism 8" r:id="rId7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73038" y="355742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物件 5">
            <a:extLst>
              <a:ext uri="{FF2B5EF4-FFF2-40B4-BE49-F238E27FC236}">
                <a16:creationId xmlns:a16="http://schemas.microsoft.com/office/drawing/2014/main" id="{CA392F65-5C31-47C0-909C-838DF10738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0502867"/>
              </p:ext>
            </p:extLst>
          </p:nvPr>
        </p:nvGraphicFramePr>
        <p:xfrm>
          <a:off x="5088265" y="355742"/>
          <a:ext cx="1502971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69" name="Prism 8" r:id="rId9" imgW="2202950" imgH="3430467" progId="Prism8.Document">
                  <p:embed/>
                </p:oleObj>
              </mc:Choice>
              <mc:Fallback>
                <p:oleObj name="Prism 8" r:id="rId9" imgW="2202950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088265" y="355742"/>
                        <a:ext cx="1502971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物件 6">
            <a:extLst>
              <a:ext uri="{FF2B5EF4-FFF2-40B4-BE49-F238E27FC236}">
                <a16:creationId xmlns:a16="http://schemas.microsoft.com/office/drawing/2014/main" id="{F47C3612-5119-4638-B08D-448F9B74ED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702772"/>
              </p:ext>
            </p:extLst>
          </p:nvPr>
        </p:nvGraphicFramePr>
        <p:xfrm>
          <a:off x="242584" y="2564512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70" name="Prism 8" r:id="rId11" imgW="2303788" imgH="3430467" progId="Prism8.Document">
                  <p:embed/>
                </p:oleObj>
              </mc:Choice>
              <mc:Fallback>
                <p:oleObj name="Prism 8" r:id="rId11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42584" y="2564512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物件 7">
            <a:extLst>
              <a:ext uri="{FF2B5EF4-FFF2-40B4-BE49-F238E27FC236}">
                <a16:creationId xmlns:a16="http://schemas.microsoft.com/office/drawing/2014/main" id="{0AAD62CE-25B2-4DEF-BEC1-E0EC81E2C2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8294602"/>
              </p:ext>
            </p:extLst>
          </p:nvPr>
        </p:nvGraphicFramePr>
        <p:xfrm>
          <a:off x="1857810" y="2564512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71" name="Prism 8" r:id="rId13" imgW="2303788" imgH="3430467" progId="Prism8.Document">
                  <p:embed/>
                </p:oleObj>
              </mc:Choice>
              <mc:Fallback>
                <p:oleObj name="Prism 8" r:id="rId13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857810" y="2564512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物件 8">
            <a:extLst>
              <a:ext uri="{FF2B5EF4-FFF2-40B4-BE49-F238E27FC236}">
                <a16:creationId xmlns:a16="http://schemas.microsoft.com/office/drawing/2014/main" id="{8E05973C-C9CD-4BCD-B3A6-4F54AA9A06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9096990"/>
              </p:ext>
            </p:extLst>
          </p:nvPr>
        </p:nvGraphicFramePr>
        <p:xfrm>
          <a:off x="3473038" y="2564512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72" name="Prism 8" r:id="rId15" imgW="2303788" imgH="3430467" progId="Prism8.Document">
                  <p:embed/>
                </p:oleObj>
              </mc:Choice>
              <mc:Fallback>
                <p:oleObj name="Prism 8" r:id="rId15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473038" y="2564512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物件 9">
            <a:extLst>
              <a:ext uri="{FF2B5EF4-FFF2-40B4-BE49-F238E27FC236}">
                <a16:creationId xmlns:a16="http://schemas.microsoft.com/office/drawing/2014/main" id="{BC98E794-7E34-43CE-90BE-C805DE3949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1734432"/>
              </p:ext>
            </p:extLst>
          </p:nvPr>
        </p:nvGraphicFramePr>
        <p:xfrm>
          <a:off x="5088265" y="2564512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73" name="Prism 8" r:id="rId17" imgW="2303788" imgH="3430467" progId="Prism8.Document">
                  <p:embed/>
                </p:oleObj>
              </mc:Choice>
              <mc:Fallback>
                <p:oleObj name="Prism 8" r:id="rId17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088265" y="2564512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物件 10">
            <a:extLst>
              <a:ext uri="{FF2B5EF4-FFF2-40B4-BE49-F238E27FC236}">
                <a16:creationId xmlns:a16="http://schemas.microsoft.com/office/drawing/2014/main" id="{099944E3-192D-4F66-B1AD-855048B9C9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440794"/>
              </p:ext>
            </p:extLst>
          </p:nvPr>
        </p:nvGraphicFramePr>
        <p:xfrm>
          <a:off x="242583" y="4773282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74" name="Prism 8" r:id="rId19" imgW="2303788" imgH="3430467" progId="Prism8.Document">
                  <p:embed/>
                </p:oleObj>
              </mc:Choice>
              <mc:Fallback>
                <p:oleObj name="Prism 8" r:id="rId19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42583" y="4773282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物件 11">
            <a:extLst>
              <a:ext uri="{FF2B5EF4-FFF2-40B4-BE49-F238E27FC236}">
                <a16:creationId xmlns:a16="http://schemas.microsoft.com/office/drawing/2014/main" id="{4B601DDB-8B64-4DF5-B7F5-60B09A5A33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8702161"/>
              </p:ext>
            </p:extLst>
          </p:nvPr>
        </p:nvGraphicFramePr>
        <p:xfrm>
          <a:off x="1901847" y="4773282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75" name="Prism 8" r:id="rId21" imgW="2303788" imgH="3430467" progId="Prism8.Document">
                  <p:embed/>
                </p:oleObj>
              </mc:Choice>
              <mc:Fallback>
                <p:oleObj name="Prism 8" r:id="rId21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901847" y="4773282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物件 12">
            <a:extLst>
              <a:ext uri="{FF2B5EF4-FFF2-40B4-BE49-F238E27FC236}">
                <a16:creationId xmlns:a16="http://schemas.microsoft.com/office/drawing/2014/main" id="{3CFDB177-3B94-4E7E-9296-11B9636643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278941"/>
              </p:ext>
            </p:extLst>
          </p:nvPr>
        </p:nvGraphicFramePr>
        <p:xfrm>
          <a:off x="3517076" y="4773282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76" name="Prism 8" r:id="rId23" imgW="2303788" imgH="3430467" progId="Prism8.Document">
                  <p:embed/>
                </p:oleObj>
              </mc:Choice>
              <mc:Fallback>
                <p:oleObj name="Prism 8" r:id="rId23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517076" y="4773282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物件 13">
            <a:extLst>
              <a:ext uri="{FF2B5EF4-FFF2-40B4-BE49-F238E27FC236}">
                <a16:creationId xmlns:a16="http://schemas.microsoft.com/office/drawing/2014/main" id="{7D88D387-652E-4382-A7C3-704CBCF700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5465695"/>
              </p:ext>
            </p:extLst>
          </p:nvPr>
        </p:nvGraphicFramePr>
        <p:xfrm>
          <a:off x="5088265" y="4773282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77" name="Prism 8" r:id="rId25" imgW="2303788" imgH="3430467" progId="Prism8.Document">
                  <p:embed/>
                </p:oleObj>
              </mc:Choice>
              <mc:Fallback>
                <p:oleObj name="Prism 8" r:id="rId25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5088265" y="4773282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文字方塊 14">
            <a:extLst>
              <a:ext uri="{FF2B5EF4-FFF2-40B4-BE49-F238E27FC236}">
                <a16:creationId xmlns:a16="http://schemas.microsoft.com/office/drawing/2014/main" id="{6067B640-399D-42D7-B9B9-956D3B7DC517}"/>
              </a:ext>
            </a:extLst>
          </p:cNvPr>
          <p:cNvSpPr txBox="1"/>
          <p:nvPr/>
        </p:nvSpPr>
        <p:spPr>
          <a:xfrm>
            <a:off x="242583" y="7874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13725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FACDFF7F-56EE-4C52-BFDF-C6F5B3F8446C}"/>
              </a:ext>
            </a:extLst>
          </p:cNvPr>
          <p:cNvSpPr txBox="1"/>
          <p:nvPr/>
        </p:nvSpPr>
        <p:spPr>
          <a:xfrm>
            <a:off x="126399" y="9190263"/>
            <a:ext cx="2646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(continued)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物件 2">
            <a:extLst>
              <a:ext uri="{FF2B5EF4-FFF2-40B4-BE49-F238E27FC236}">
                <a16:creationId xmlns:a16="http://schemas.microsoft.com/office/drawing/2014/main" id="{82702747-A6D2-467A-91B8-7FFC5281E3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5750841"/>
              </p:ext>
            </p:extLst>
          </p:nvPr>
        </p:nvGraphicFramePr>
        <p:xfrm>
          <a:off x="126400" y="232224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2" name="Prism 8" r:id="rId3" imgW="2303788" imgH="3430467" progId="Prism8.Document">
                  <p:embed/>
                </p:oleObj>
              </mc:Choice>
              <mc:Fallback>
                <p:oleObj name="Prism 8" r:id="rId3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6400" y="232224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物件 3">
            <a:extLst>
              <a:ext uri="{FF2B5EF4-FFF2-40B4-BE49-F238E27FC236}">
                <a16:creationId xmlns:a16="http://schemas.microsoft.com/office/drawing/2014/main" id="{C0EF6A28-34CA-448E-AFAF-8FA02FCC75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0828198"/>
              </p:ext>
            </p:extLst>
          </p:nvPr>
        </p:nvGraphicFramePr>
        <p:xfrm>
          <a:off x="1777700" y="232224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3" name="Prism 8" r:id="rId5" imgW="2303788" imgH="3430467" progId="Prism8.Document">
                  <p:embed/>
                </p:oleObj>
              </mc:Choice>
              <mc:Fallback>
                <p:oleObj name="Prism 8" r:id="rId5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77700" y="232224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物件 4">
            <a:extLst>
              <a:ext uri="{FF2B5EF4-FFF2-40B4-BE49-F238E27FC236}">
                <a16:creationId xmlns:a16="http://schemas.microsoft.com/office/drawing/2014/main" id="{1BE944A0-6034-46AA-80DE-4CFDEFA783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4504908"/>
              </p:ext>
            </p:extLst>
          </p:nvPr>
        </p:nvGraphicFramePr>
        <p:xfrm>
          <a:off x="3429000" y="232224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4" name="Prism 8" r:id="rId7" imgW="2303788" imgH="3430467" progId="Prism8.Document">
                  <p:embed/>
                </p:oleObj>
              </mc:Choice>
              <mc:Fallback>
                <p:oleObj name="Prism 8" r:id="rId7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29000" y="232224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物件 5">
            <a:extLst>
              <a:ext uri="{FF2B5EF4-FFF2-40B4-BE49-F238E27FC236}">
                <a16:creationId xmlns:a16="http://schemas.microsoft.com/office/drawing/2014/main" id="{0607CA8F-0168-4720-8A20-0B51A8E60A3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6164248"/>
              </p:ext>
            </p:extLst>
          </p:nvPr>
        </p:nvGraphicFramePr>
        <p:xfrm>
          <a:off x="5080300" y="232224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5" name="Prism 8" r:id="rId9" imgW="2303788" imgH="3430467" progId="Prism8.Document">
                  <p:embed/>
                </p:oleObj>
              </mc:Choice>
              <mc:Fallback>
                <p:oleObj name="Prism 8" r:id="rId9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080300" y="232224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物件 6">
            <a:extLst>
              <a:ext uri="{FF2B5EF4-FFF2-40B4-BE49-F238E27FC236}">
                <a16:creationId xmlns:a16="http://schemas.microsoft.com/office/drawing/2014/main" id="{760B85F6-D46E-42C8-BBB8-6F3D67A19C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9058913"/>
              </p:ext>
            </p:extLst>
          </p:nvPr>
        </p:nvGraphicFramePr>
        <p:xfrm>
          <a:off x="126399" y="2406015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6" name="Prism 8" r:id="rId11" imgW="2303788" imgH="3430467" progId="Prism8.Document">
                  <p:embed/>
                </p:oleObj>
              </mc:Choice>
              <mc:Fallback>
                <p:oleObj name="Prism 8" r:id="rId11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26399" y="2406015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物件 7">
            <a:extLst>
              <a:ext uri="{FF2B5EF4-FFF2-40B4-BE49-F238E27FC236}">
                <a16:creationId xmlns:a16="http://schemas.microsoft.com/office/drawing/2014/main" id="{5C3C2124-B01E-4DE5-AEF0-852CDD603E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5397512"/>
              </p:ext>
            </p:extLst>
          </p:nvPr>
        </p:nvGraphicFramePr>
        <p:xfrm>
          <a:off x="1697588" y="2406015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7" name="Prism 8" r:id="rId13" imgW="2303788" imgH="3430467" progId="Prism8.Document">
                  <p:embed/>
                </p:oleObj>
              </mc:Choice>
              <mc:Fallback>
                <p:oleObj name="Prism 8" r:id="rId13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697588" y="2406015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物件 8">
            <a:extLst>
              <a:ext uri="{FF2B5EF4-FFF2-40B4-BE49-F238E27FC236}">
                <a16:creationId xmlns:a16="http://schemas.microsoft.com/office/drawing/2014/main" id="{7345863D-2E5B-4AFF-9E93-99744C915A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6624021"/>
              </p:ext>
            </p:extLst>
          </p:nvPr>
        </p:nvGraphicFramePr>
        <p:xfrm>
          <a:off x="3348888" y="2406015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8" name="Prism 8" r:id="rId15" imgW="2303788" imgH="3430467" progId="Prism8.Document">
                  <p:embed/>
                </p:oleObj>
              </mc:Choice>
              <mc:Fallback>
                <p:oleObj name="Prism 8" r:id="rId15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348888" y="2406015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物件 9">
            <a:extLst>
              <a:ext uri="{FF2B5EF4-FFF2-40B4-BE49-F238E27FC236}">
                <a16:creationId xmlns:a16="http://schemas.microsoft.com/office/drawing/2014/main" id="{3C96D84A-D2E1-4D8A-833F-B64FCD78DC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2853988"/>
              </p:ext>
            </p:extLst>
          </p:nvPr>
        </p:nvGraphicFramePr>
        <p:xfrm>
          <a:off x="5080300" y="2406015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9" name="Prism 8" r:id="rId17" imgW="2303788" imgH="3430467" progId="Prism8.Document">
                  <p:embed/>
                </p:oleObj>
              </mc:Choice>
              <mc:Fallback>
                <p:oleObj name="Prism 8" r:id="rId17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080300" y="2406015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物件 10">
            <a:extLst>
              <a:ext uri="{FF2B5EF4-FFF2-40B4-BE49-F238E27FC236}">
                <a16:creationId xmlns:a16="http://schemas.microsoft.com/office/drawing/2014/main" id="{B5CE6474-266F-48AE-91CB-72143B3FA0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4741615"/>
              </p:ext>
            </p:extLst>
          </p:nvPr>
        </p:nvGraphicFramePr>
        <p:xfrm>
          <a:off x="114505" y="4628139"/>
          <a:ext cx="1502971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30" name="Prism 8" r:id="rId19" imgW="2202950" imgH="3430467" progId="Prism8.Document">
                  <p:embed/>
                </p:oleObj>
              </mc:Choice>
              <mc:Fallback>
                <p:oleObj name="Prism 8" r:id="rId19" imgW="2202950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14505" y="4628139"/>
                        <a:ext cx="1502971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物件 11">
            <a:extLst>
              <a:ext uri="{FF2B5EF4-FFF2-40B4-BE49-F238E27FC236}">
                <a16:creationId xmlns:a16="http://schemas.microsoft.com/office/drawing/2014/main" id="{65450DF7-4952-4337-BFDD-B4E2BF2079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7167520"/>
              </p:ext>
            </p:extLst>
          </p:nvPr>
        </p:nvGraphicFramePr>
        <p:xfrm>
          <a:off x="1777699" y="4628139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31" name="Prism 8" r:id="rId21" imgW="2303788" imgH="3430467" progId="Prism8.Document">
                  <p:embed/>
                </p:oleObj>
              </mc:Choice>
              <mc:Fallback>
                <p:oleObj name="Prism 8" r:id="rId21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777699" y="4628139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物件 12">
            <a:extLst>
              <a:ext uri="{FF2B5EF4-FFF2-40B4-BE49-F238E27FC236}">
                <a16:creationId xmlns:a16="http://schemas.microsoft.com/office/drawing/2014/main" id="{D9B91255-260E-4792-8B21-763440DBE1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1748659"/>
              </p:ext>
            </p:extLst>
          </p:nvPr>
        </p:nvGraphicFramePr>
        <p:xfrm>
          <a:off x="3428999" y="4628139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32" name="Prism 8" r:id="rId23" imgW="2303788" imgH="3430467" progId="Prism8.Document">
                  <p:embed/>
                </p:oleObj>
              </mc:Choice>
              <mc:Fallback>
                <p:oleObj name="Prism 8" r:id="rId23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428999" y="4628139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物件 13">
            <a:extLst>
              <a:ext uri="{FF2B5EF4-FFF2-40B4-BE49-F238E27FC236}">
                <a16:creationId xmlns:a16="http://schemas.microsoft.com/office/drawing/2014/main" id="{135263A5-6EE4-4ABE-84C0-E7FFAA02AF3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3707717"/>
              </p:ext>
            </p:extLst>
          </p:nvPr>
        </p:nvGraphicFramePr>
        <p:xfrm>
          <a:off x="5080300" y="4628139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33" name="Prism 8" r:id="rId25" imgW="2303788" imgH="3430467" progId="Prism8.Document">
                  <p:embed/>
                </p:oleObj>
              </mc:Choice>
              <mc:Fallback>
                <p:oleObj name="Prism 8" r:id="rId25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5080300" y="4628139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物件 14">
            <a:extLst>
              <a:ext uri="{FF2B5EF4-FFF2-40B4-BE49-F238E27FC236}">
                <a16:creationId xmlns:a16="http://schemas.microsoft.com/office/drawing/2014/main" id="{69ED76F9-1CD2-4A21-8CCD-935C1D3AA93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1457417"/>
              </p:ext>
            </p:extLst>
          </p:nvPr>
        </p:nvGraphicFramePr>
        <p:xfrm>
          <a:off x="154560" y="6850263"/>
          <a:ext cx="1502971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34" name="Prism 8" r:id="rId27" imgW="2202950" imgH="3430467" progId="Prism8.Document">
                  <p:embed/>
                </p:oleObj>
              </mc:Choice>
              <mc:Fallback>
                <p:oleObj name="Prism 8" r:id="rId27" imgW="2202950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54560" y="6850263"/>
                        <a:ext cx="1502971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物件 15">
            <a:extLst>
              <a:ext uri="{FF2B5EF4-FFF2-40B4-BE49-F238E27FC236}">
                <a16:creationId xmlns:a16="http://schemas.microsoft.com/office/drawing/2014/main" id="{AE06DD22-CF78-42E7-A36F-F301284EFB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5382906"/>
              </p:ext>
            </p:extLst>
          </p:nvPr>
        </p:nvGraphicFramePr>
        <p:xfrm>
          <a:off x="1723561" y="6850263"/>
          <a:ext cx="1639407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35" name="Prism 8" r:id="rId29" imgW="2404266" imgH="3430467" progId="Prism8.Document">
                  <p:embed/>
                </p:oleObj>
              </mc:Choice>
              <mc:Fallback>
                <p:oleObj name="Prism 8" r:id="rId29" imgW="2404266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723561" y="6850263"/>
                        <a:ext cx="1639407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物件 16">
            <a:extLst>
              <a:ext uri="{FF2B5EF4-FFF2-40B4-BE49-F238E27FC236}">
                <a16:creationId xmlns:a16="http://schemas.microsoft.com/office/drawing/2014/main" id="{F853A625-EC2C-401D-8060-1078E43C1A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2000017"/>
              </p:ext>
            </p:extLst>
          </p:nvPr>
        </p:nvGraphicFramePr>
        <p:xfrm>
          <a:off x="3401930" y="6850263"/>
          <a:ext cx="1639407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36" name="Prism 8" r:id="rId31" imgW="2404266" imgH="3430467" progId="Prism8.Document">
                  <p:embed/>
                </p:oleObj>
              </mc:Choice>
              <mc:Fallback>
                <p:oleObj name="Prism 8" r:id="rId31" imgW="2404266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3401930" y="6850263"/>
                        <a:ext cx="1639407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物件 17">
            <a:extLst>
              <a:ext uri="{FF2B5EF4-FFF2-40B4-BE49-F238E27FC236}">
                <a16:creationId xmlns:a16="http://schemas.microsoft.com/office/drawing/2014/main" id="{EDC61156-09A7-4A08-AD2C-E4340DC4E0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674727"/>
              </p:ext>
            </p:extLst>
          </p:nvPr>
        </p:nvGraphicFramePr>
        <p:xfrm>
          <a:off x="5000188" y="6850263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37" name="Prism 8" r:id="rId33" imgW="2303788" imgH="3430467" progId="Prism8.Document">
                  <p:embed/>
                </p:oleObj>
              </mc:Choice>
              <mc:Fallback>
                <p:oleObj name="Prism 8" r:id="rId33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5000188" y="6850263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文字方塊 18">
            <a:extLst>
              <a:ext uri="{FF2B5EF4-FFF2-40B4-BE49-F238E27FC236}">
                <a16:creationId xmlns:a16="http://schemas.microsoft.com/office/drawing/2014/main" id="{DAFD2F53-B1A9-454F-A429-F7D4155D8900}"/>
              </a:ext>
            </a:extLst>
          </p:cNvPr>
          <p:cNvSpPr txBox="1"/>
          <p:nvPr/>
        </p:nvSpPr>
        <p:spPr>
          <a:xfrm>
            <a:off x="114505" y="6810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75322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FEB73063-7568-4742-9D92-28D4B4FFA273}"/>
              </a:ext>
            </a:extLst>
          </p:cNvPr>
          <p:cNvSpPr txBox="1"/>
          <p:nvPr/>
        </p:nvSpPr>
        <p:spPr>
          <a:xfrm>
            <a:off x="364699" y="9212985"/>
            <a:ext cx="2683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(continued)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物件 2">
            <a:extLst>
              <a:ext uri="{FF2B5EF4-FFF2-40B4-BE49-F238E27FC236}">
                <a16:creationId xmlns:a16="http://schemas.microsoft.com/office/drawing/2014/main" id="{CDC1C697-976F-4C91-B79C-B1A130C5F3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6882316"/>
              </p:ext>
            </p:extLst>
          </p:nvPr>
        </p:nvGraphicFramePr>
        <p:xfrm>
          <a:off x="166948" y="146383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30" name="Prism 8" r:id="rId3" imgW="2303788" imgH="3430467" progId="Prism8.Document">
                  <p:embed/>
                </p:oleObj>
              </mc:Choice>
              <mc:Fallback>
                <p:oleObj name="Prism 8" r:id="rId3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6948" y="146383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物件 3">
            <a:extLst>
              <a:ext uri="{FF2B5EF4-FFF2-40B4-BE49-F238E27FC236}">
                <a16:creationId xmlns:a16="http://schemas.microsoft.com/office/drawing/2014/main" id="{38AD6981-D769-492A-BB59-FF58C8F6F5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8660827"/>
              </p:ext>
            </p:extLst>
          </p:nvPr>
        </p:nvGraphicFramePr>
        <p:xfrm>
          <a:off x="1738137" y="146383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31" name="Prism 8" r:id="rId5" imgW="2303788" imgH="3430467" progId="Prism8.Document">
                  <p:embed/>
                </p:oleObj>
              </mc:Choice>
              <mc:Fallback>
                <p:oleObj name="Prism 8" r:id="rId5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38137" y="146383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物件 4">
            <a:extLst>
              <a:ext uri="{FF2B5EF4-FFF2-40B4-BE49-F238E27FC236}">
                <a16:creationId xmlns:a16="http://schemas.microsoft.com/office/drawing/2014/main" id="{143D3FD4-F50E-4428-B71C-453692CFC2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0904478"/>
              </p:ext>
            </p:extLst>
          </p:nvPr>
        </p:nvGraphicFramePr>
        <p:xfrm>
          <a:off x="3309326" y="146383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32" name="Prism 8" r:id="rId7" imgW="2303788" imgH="3430467" progId="Prism8.Document">
                  <p:embed/>
                </p:oleObj>
              </mc:Choice>
              <mc:Fallback>
                <p:oleObj name="Prism 8" r:id="rId7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09326" y="146383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物件 5">
            <a:extLst>
              <a:ext uri="{FF2B5EF4-FFF2-40B4-BE49-F238E27FC236}">
                <a16:creationId xmlns:a16="http://schemas.microsoft.com/office/drawing/2014/main" id="{69DB3592-A50A-4820-A110-8673327F2E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4264065"/>
              </p:ext>
            </p:extLst>
          </p:nvPr>
        </p:nvGraphicFramePr>
        <p:xfrm>
          <a:off x="4880515" y="146383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33" name="Prism 8" r:id="rId9" imgW="2303788" imgH="3430467" progId="Prism8.Document">
                  <p:embed/>
                </p:oleObj>
              </mc:Choice>
              <mc:Fallback>
                <p:oleObj name="Prism 8" r:id="rId9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880515" y="146383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物件 6">
            <a:extLst>
              <a:ext uri="{FF2B5EF4-FFF2-40B4-BE49-F238E27FC236}">
                <a16:creationId xmlns:a16="http://schemas.microsoft.com/office/drawing/2014/main" id="{D87BD472-3F24-4C84-A2DE-B5456AD617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0097034"/>
              </p:ext>
            </p:extLst>
          </p:nvPr>
        </p:nvGraphicFramePr>
        <p:xfrm>
          <a:off x="168130" y="2397569"/>
          <a:ext cx="1502971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34" name="Prism 8" r:id="rId11" imgW="2202950" imgH="3430467" progId="Prism8.Document">
                  <p:embed/>
                </p:oleObj>
              </mc:Choice>
              <mc:Fallback>
                <p:oleObj name="Prism 8" r:id="rId11" imgW="2202950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68130" y="2397569"/>
                        <a:ext cx="1502971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物件 7">
            <a:extLst>
              <a:ext uri="{FF2B5EF4-FFF2-40B4-BE49-F238E27FC236}">
                <a16:creationId xmlns:a16="http://schemas.microsoft.com/office/drawing/2014/main" id="{3B2AFEC1-9E35-4F9F-9A9E-54F6986BAA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1582109"/>
              </p:ext>
            </p:extLst>
          </p:nvPr>
        </p:nvGraphicFramePr>
        <p:xfrm>
          <a:off x="1739319" y="2397569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35" name="Prism 8" r:id="rId13" imgW="2303788" imgH="3430467" progId="Prism8.Document">
                  <p:embed/>
                </p:oleObj>
              </mc:Choice>
              <mc:Fallback>
                <p:oleObj name="Prism 8" r:id="rId13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739319" y="2397569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物件 8">
            <a:extLst>
              <a:ext uri="{FF2B5EF4-FFF2-40B4-BE49-F238E27FC236}">
                <a16:creationId xmlns:a16="http://schemas.microsoft.com/office/drawing/2014/main" id="{34934A10-C74E-41E2-BDBD-BBBFF452B1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9034373"/>
              </p:ext>
            </p:extLst>
          </p:nvPr>
        </p:nvGraphicFramePr>
        <p:xfrm>
          <a:off x="3430182" y="2397569"/>
          <a:ext cx="1502971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36" name="Prism 8" r:id="rId15" imgW="2202950" imgH="3430467" progId="Prism8.Document">
                  <p:embed/>
                </p:oleObj>
              </mc:Choice>
              <mc:Fallback>
                <p:oleObj name="Prism 8" r:id="rId15" imgW="2202950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430182" y="2397569"/>
                        <a:ext cx="1502971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物件 9">
            <a:extLst>
              <a:ext uri="{FF2B5EF4-FFF2-40B4-BE49-F238E27FC236}">
                <a16:creationId xmlns:a16="http://schemas.microsoft.com/office/drawing/2014/main" id="{B9B09159-1138-4F82-BD65-CFC827A2AF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5120831"/>
              </p:ext>
            </p:extLst>
          </p:nvPr>
        </p:nvGraphicFramePr>
        <p:xfrm>
          <a:off x="4933153" y="2397569"/>
          <a:ext cx="1639407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37" name="Prism 8" r:id="rId17" imgW="2404266" imgH="3430467" progId="Prism8.Document">
                  <p:embed/>
                </p:oleObj>
              </mc:Choice>
              <mc:Fallback>
                <p:oleObj name="Prism 8" r:id="rId17" imgW="2404266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933153" y="2397569"/>
                        <a:ext cx="1639407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物件 10">
            <a:extLst>
              <a:ext uri="{FF2B5EF4-FFF2-40B4-BE49-F238E27FC236}">
                <a16:creationId xmlns:a16="http://schemas.microsoft.com/office/drawing/2014/main" id="{75D4CD50-8E82-464E-9174-13C2963267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2685501"/>
              </p:ext>
            </p:extLst>
          </p:nvPr>
        </p:nvGraphicFramePr>
        <p:xfrm>
          <a:off x="166948" y="4621799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38" name="Prism 8" r:id="rId19" imgW="2303788" imgH="3430467" progId="Prism8.Document">
                  <p:embed/>
                </p:oleObj>
              </mc:Choice>
              <mc:Fallback>
                <p:oleObj name="Prism 8" r:id="rId19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66948" y="4621799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物件 11">
            <a:extLst>
              <a:ext uri="{FF2B5EF4-FFF2-40B4-BE49-F238E27FC236}">
                <a16:creationId xmlns:a16="http://schemas.microsoft.com/office/drawing/2014/main" id="{21973437-1588-4F68-8D33-F28B0B18F9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1843913"/>
              </p:ext>
            </p:extLst>
          </p:nvPr>
        </p:nvGraphicFramePr>
        <p:xfrm>
          <a:off x="1733203" y="4621799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39" name="Prism 8" r:id="rId21" imgW="2303788" imgH="3430467" progId="Prism8.Document">
                  <p:embed/>
                </p:oleObj>
              </mc:Choice>
              <mc:Fallback>
                <p:oleObj name="Prism 8" r:id="rId21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733203" y="4621799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物件 12">
            <a:extLst>
              <a:ext uri="{FF2B5EF4-FFF2-40B4-BE49-F238E27FC236}">
                <a16:creationId xmlns:a16="http://schemas.microsoft.com/office/drawing/2014/main" id="{EA37C6CF-87E6-456D-8A20-6975DE977F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1075405"/>
              </p:ext>
            </p:extLst>
          </p:nvPr>
        </p:nvGraphicFramePr>
        <p:xfrm>
          <a:off x="3424066" y="4604084"/>
          <a:ext cx="1502971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0" name="Prism 8" r:id="rId23" imgW="2202950" imgH="3430467" progId="Prism8.Document">
                  <p:embed/>
                </p:oleObj>
              </mc:Choice>
              <mc:Fallback>
                <p:oleObj name="Prism 8" r:id="rId23" imgW="2202950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424066" y="4604084"/>
                        <a:ext cx="1502971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物件 13">
            <a:extLst>
              <a:ext uri="{FF2B5EF4-FFF2-40B4-BE49-F238E27FC236}">
                <a16:creationId xmlns:a16="http://schemas.microsoft.com/office/drawing/2014/main" id="{0DDDC7CC-6ED4-4E8D-AAF6-CF7B4C4196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6741599"/>
              </p:ext>
            </p:extLst>
          </p:nvPr>
        </p:nvGraphicFramePr>
        <p:xfrm>
          <a:off x="4927037" y="4604084"/>
          <a:ext cx="15711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1" name="Prism 8" r:id="rId25" imgW="2303788" imgH="3430467" progId="Prism8.Document">
                  <p:embed/>
                </p:oleObj>
              </mc:Choice>
              <mc:Fallback>
                <p:oleObj name="Prism 8" r:id="rId25" imgW="230378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927037" y="4604084"/>
                        <a:ext cx="157118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物件 14">
            <a:extLst>
              <a:ext uri="{FF2B5EF4-FFF2-40B4-BE49-F238E27FC236}">
                <a16:creationId xmlns:a16="http://schemas.microsoft.com/office/drawing/2014/main" id="{2DD9AB95-D107-4900-95CC-47C3D9B4B6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7327010"/>
              </p:ext>
            </p:extLst>
          </p:nvPr>
        </p:nvGraphicFramePr>
        <p:xfrm>
          <a:off x="171352" y="6872985"/>
          <a:ext cx="159392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2" name="Prism 8" r:id="rId27" imgW="2337281" imgH="3430467" progId="Prism8.Document">
                  <p:embed/>
                </p:oleObj>
              </mc:Choice>
              <mc:Fallback>
                <p:oleObj name="Prism 8" r:id="rId27" imgW="2337281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71352" y="6872985"/>
                        <a:ext cx="159392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物件 15">
            <a:extLst>
              <a:ext uri="{FF2B5EF4-FFF2-40B4-BE49-F238E27FC236}">
                <a16:creationId xmlns:a16="http://schemas.microsoft.com/office/drawing/2014/main" id="{1FA1FC23-5030-4C49-97D0-9A744EE04C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4442458"/>
              </p:ext>
            </p:extLst>
          </p:nvPr>
        </p:nvGraphicFramePr>
        <p:xfrm>
          <a:off x="1741832" y="6872985"/>
          <a:ext cx="159392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3" name="Prism 8" r:id="rId29" imgW="2337281" imgH="3430467" progId="Prism8.Document">
                  <p:embed/>
                </p:oleObj>
              </mc:Choice>
              <mc:Fallback>
                <p:oleObj name="Prism 8" r:id="rId29" imgW="2337281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741832" y="6872985"/>
                        <a:ext cx="159392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物件 16">
            <a:extLst>
              <a:ext uri="{FF2B5EF4-FFF2-40B4-BE49-F238E27FC236}">
                <a16:creationId xmlns:a16="http://schemas.microsoft.com/office/drawing/2014/main" id="{CFDFA3D9-9645-4D70-8FAE-036D2D1A58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5042035"/>
              </p:ext>
            </p:extLst>
          </p:nvPr>
        </p:nvGraphicFramePr>
        <p:xfrm>
          <a:off x="3344390" y="6872985"/>
          <a:ext cx="159392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4" name="Prism 8" r:id="rId31" imgW="2337281" imgH="3430467" progId="Prism8.Document">
                  <p:embed/>
                </p:oleObj>
              </mc:Choice>
              <mc:Fallback>
                <p:oleObj name="Prism 8" r:id="rId31" imgW="2337281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3344390" y="6872985"/>
                        <a:ext cx="159392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物件 17">
            <a:extLst>
              <a:ext uri="{FF2B5EF4-FFF2-40B4-BE49-F238E27FC236}">
                <a16:creationId xmlns:a16="http://schemas.microsoft.com/office/drawing/2014/main" id="{2F67ED25-A674-4322-B451-F2A6E806DB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2679751"/>
              </p:ext>
            </p:extLst>
          </p:nvPr>
        </p:nvGraphicFramePr>
        <p:xfrm>
          <a:off x="4874872" y="6872985"/>
          <a:ext cx="159392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45" name="Prism 8" r:id="rId33" imgW="2337281" imgH="3430467" progId="Prism8.Document">
                  <p:embed/>
                </p:oleObj>
              </mc:Choice>
              <mc:Fallback>
                <p:oleObj name="Prism 8" r:id="rId33" imgW="2337281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4874872" y="6872985"/>
                        <a:ext cx="1593929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文字方塊 18">
            <a:extLst>
              <a:ext uri="{FF2B5EF4-FFF2-40B4-BE49-F238E27FC236}">
                <a16:creationId xmlns:a16="http://schemas.microsoft.com/office/drawing/2014/main" id="{82BE0E71-5735-4096-95F2-3ECECBDFCFC4}"/>
              </a:ext>
            </a:extLst>
          </p:cNvPr>
          <p:cNvSpPr txBox="1"/>
          <p:nvPr/>
        </p:nvSpPr>
        <p:spPr>
          <a:xfrm>
            <a:off x="165766" y="-481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10029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AAF5F164-D692-42C6-8FD3-1510CCF33297}"/>
              </a:ext>
            </a:extLst>
          </p:cNvPr>
          <p:cNvSpPr txBox="1"/>
          <p:nvPr/>
        </p:nvSpPr>
        <p:spPr>
          <a:xfrm>
            <a:off x="258502" y="4889796"/>
            <a:ext cx="2809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(continued)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物件 7">
            <a:extLst>
              <a:ext uri="{FF2B5EF4-FFF2-40B4-BE49-F238E27FC236}">
                <a16:creationId xmlns:a16="http://schemas.microsoft.com/office/drawing/2014/main" id="{9D8EF332-9A98-4D86-B7BF-D972ED43CB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9246440"/>
              </p:ext>
            </p:extLst>
          </p:nvPr>
        </p:nvGraphicFramePr>
        <p:xfrm>
          <a:off x="258502" y="370860"/>
          <a:ext cx="1479148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2" name="Prism 8" r:id="rId3" imgW="2168017" imgH="3430467" progId="Prism8.Document">
                  <p:embed/>
                </p:oleObj>
              </mc:Choice>
              <mc:Fallback>
                <p:oleObj name="Prism 8" r:id="rId3" imgW="2168017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8502" y="370860"/>
                        <a:ext cx="1479148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物件 8">
            <a:extLst>
              <a:ext uri="{FF2B5EF4-FFF2-40B4-BE49-F238E27FC236}">
                <a16:creationId xmlns:a16="http://schemas.microsoft.com/office/drawing/2014/main" id="{9F552D44-9936-450C-A397-17B380FA25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7648814"/>
              </p:ext>
            </p:extLst>
          </p:nvPr>
        </p:nvGraphicFramePr>
        <p:xfrm>
          <a:off x="1811983" y="370860"/>
          <a:ext cx="1447746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3" name="Prism 8" r:id="rId5" imgW="2122280" imgH="3430467" progId="Prism8.Document">
                  <p:embed/>
                </p:oleObj>
              </mc:Choice>
              <mc:Fallback>
                <p:oleObj name="Prism 8" r:id="rId5" imgW="2122280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11983" y="370860"/>
                        <a:ext cx="1447746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物件 9">
            <a:extLst>
              <a:ext uri="{FF2B5EF4-FFF2-40B4-BE49-F238E27FC236}">
                <a16:creationId xmlns:a16="http://schemas.microsoft.com/office/drawing/2014/main" id="{010D5475-735B-4F2E-9FC8-70681D990A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0746165"/>
              </p:ext>
            </p:extLst>
          </p:nvPr>
        </p:nvGraphicFramePr>
        <p:xfrm>
          <a:off x="3334062" y="370860"/>
          <a:ext cx="1553864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4" name="Prism 8" r:id="rId7" imgW="2277858" imgH="3430467" progId="Prism8.Document">
                  <p:embed/>
                </p:oleObj>
              </mc:Choice>
              <mc:Fallback>
                <p:oleObj name="Prism 8" r:id="rId7" imgW="227785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34062" y="370860"/>
                        <a:ext cx="1553864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物件 10">
            <a:extLst>
              <a:ext uri="{FF2B5EF4-FFF2-40B4-BE49-F238E27FC236}">
                <a16:creationId xmlns:a16="http://schemas.microsoft.com/office/drawing/2014/main" id="{01BC46C4-A5AE-4581-A316-4F4173F32A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5906741"/>
              </p:ext>
            </p:extLst>
          </p:nvPr>
        </p:nvGraphicFramePr>
        <p:xfrm>
          <a:off x="4962259" y="370860"/>
          <a:ext cx="1447746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5" name="Prism 8" r:id="rId9" imgW="2122280" imgH="3430467" progId="Prism8.Document">
                  <p:embed/>
                </p:oleObj>
              </mc:Choice>
              <mc:Fallback>
                <p:oleObj name="Prism 8" r:id="rId9" imgW="2122280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962259" y="370860"/>
                        <a:ext cx="1447746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物件 11">
            <a:extLst>
              <a:ext uri="{FF2B5EF4-FFF2-40B4-BE49-F238E27FC236}">
                <a16:creationId xmlns:a16="http://schemas.microsoft.com/office/drawing/2014/main" id="{522C1C11-943E-422F-9A90-52701A343D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5787870"/>
              </p:ext>
            </p:extLst>
          </p:nvPr>
        </p:nvGraphicFramePr>
        <p:xfrm>
          <a:off x="258851" y="2549796"/>
          <a:ext cx="1515965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6" name="Prism 8" r:id="rId11" imgW="2222758" imgH="3430467" progId="Prism8.Document">
                  <p:embed/>
                </p:oleObj>
              </mc:Choice>
              <mc:Fallback>
                <p:oleObj name="Prism 8" r:id="rId11" imgW="2222758" imgH="34304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58851" y="2549796"/>
                        <a:ext cx="1515965" cy="23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字方塊 12">
            <a:extLst>
              <a:ext uri="{FF2B5EF4-FFF2-40B4-BE49-F238E27FC236}">
                <a16:creationId xmlns:a16="http://schemas.microsoft.com/office/drawing/2014/main" id="{658AA7B0-FF10-4148-9D42-BEBBA12B08C8}"/>
              </a:ext>
            </a:extLst>
          </p:cNvPr>
          <p:cNvSpPr txBox="1"/>
          <p:nvPr/>
        </p:nvSpPr>
        <p:spPr>
          <a:xfrm>
            <a:off x="258502" y="13667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7755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53</TotalTime>
  <Words>1036</Words>
  <Application>Microsoft Office PowerPoint</Application>
  <PresentationFormat>A4 紙張 (210x297 公釐)</PresentationFormat>
  <Paragraphs>82</Paragraphs>
  <Slides>5</Slides>
  <Notes>0</Notes>
  <HiddenSlides>0</HiddenSlides>
  <MMClips>0</MMClips>
  <ScaleCrop>false</ScaleCrop>
  <HeadingPairs>
    <vt:vector size="8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佈景主題</vt:lpstr>
      <vt:lpstr>Prism 8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洪素珍</dc:creator>
  <cp:lastModifiedBy>素珍 洪</cp:lastModifiedBy>
  <cp:revision>166</cp:revision>
  <cp:lastPrinted>2021-11-01T06:26:32Z</cp:lastPrinted>
  <dcterms:created xsi:type="dcterms:W3CDTF">2021-09-29T08:57:15Z</dcterms:created>
  <dcterms:modified xsi:type="dcterms:W3CDTF">2022-01-04T06:00:14Z</dcterms:modified>
</cp:coreProperties>
</file>